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32" r:id="rId2"/>
    <p:sldId id="346" r:id="rId3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8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openxmlformats.org/officeDocument/2006/relationships/image" Target="../media/image7.jpeg"/><Relationship Id="rId5" Type="http://schemas.microsoft.com/office/2007/relationships/hdphoto" Target="../media/hdphoto2.wdp"/><Relationship Id="rId15" Type="http://schemas.openxmlformats.org/officeDocument/2006/relationships/image" Target="../media/image11.png"/><Relationship Id="rId10" Type="http://schemas.openxmlformats.org/officeDocument/2006/relationships/image" Target="../media/image6.jpeg"/><Relationship Id="rId4" Type="http://schemas.openxmlformats.org/officeDocument/2006/relationships/image" Target="../media/image2.png"/><Relationship Id="rId9" Type="http://schemas.openxmlformats.org/officeDocument/2006/relationships/image" Target="../media/image5.jpeg"/><Relationship Id="rId14" Type="http://schemas.openxmlformats.org/officeDocument/2006/relationships/image" Target="../media/image10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92">
            <a:extLst>
              <a:ext uri="{FF2B5EF4-FFF2-40B4-BE49-F238E27FC236}">
                <a16:creationId xmlns="" xmlns:a16="http://schemas.microsoft.com/office/drawing/2014/main" id="{30302FC7-C08E-504E-BDF8-0DF5BD53A23A}"/>
              </a:ext>
            </a:extLst>
          </p:cNvPr>
          <p:cNvSpPr txBox="1"/>
          <p:nvPr/>
        </p:nvSpPr>
        <p:spPr>
          <a:xfrm>
            <a:off x="152400" y="50845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2">
            <a:extLst>
              <a:ext uri="{FF2B5EF4-FFF2-40B4-BE49-F238E27FC236}">
                <a16:creationId xmlns="" xmlns:a16="http://schemas.microsoft.com/office/drawing/2014/main" id="{B22C72D2-A0A3-DD45-ABD3-8DD16FD5B3F7}"/>
              </a:ext>
            </a:extLst>
          </p:cNvPr>
          <p:cNvSpPr txBox="1"/>
          <p:nvPr/>
        </p:nvSpPr>
        <p:spPr>
          <a:xfrm>
            <a:off x="152399" y="254216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92">
            <a:extLst>
              <a:ext uri="{FF2B5EF4-FFF2-40B4-BE49-F238E27FC236}">
                <a16:creationId xmlns="" xmlns:a16="http://schemas.microsoft.com/office/drawing/2014/main" id="{4A27FBAE-45EE-2D45-A242-BB6B3EFD9003}"/>
              </a:ext>
            </a:extLst>
          </p:cNvPr>
          <p:cNvSpPr txBox="1"/>
          <p:nvPr/>
        </p:nvSpPr>
        <p:spPr>
          <a:xfrm>
            <a:off x="152400" y="45315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92">
            <a:extLst>
              <a:ext uri="{FF2B5EF4-FFF2-40B4-BE49-F238E27FC236}">
                <a16:creationId xmlns="" xmlns:a16="http://schemas.microsoft.com/office/drawing/2014/main" id="{67335296-AC46-6E41-8766-8E5A1A2BC0EE}"/>
              </a:ext>
            </a:extLst>
          </p:cNvPr>
          <p:cNvSpPr txBox="1"/>
          <p:nvPr/>
        </p:nvSpPr>
        <p:spPr>
          <a:xfrm>
            <a:off x="152399" y="655335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44" name="Group 43"/>
          <p:cNvGrpSpPr>
            <a:grpSpLocks noChangeAspect="1"/>
          </p:cNvGrpSpPr>
          <p:nvPr/>
        </p:nvGrpSpPr>
        <p:grpSpPr>
          <a:xfrm>
            <a:off x="3425952" y="530732"/>
            <a:ext cx="2880000" cy="1917972"/>
            <a:chOff x="3429000" y="646954"/>
            <a:chExt cx="2883048" cy="1919998"/>
          </a:xfrm>
        </p:grpSpPr>
        <p:pic>
          <p:nvPicPr>
            <p:cNvPr id="16" name="Grafik 15" descr="Ein Bild, das weiß, Foto, Essen, bedeckt enthält.&#10;&#10;Automatisch generierte Beschreibung">
              <a:extLst>
                <a:ext uri="{FF2B5EF4-FFF2-40B4-BE49-F238E27FC236}">
                  <a16:creationId xmlns="" xmlns:a16="http://schemas.microsoft.com/office/drawing/2014/main" id="{982F1132-66AD-2749-9DBE-18D73F5DAC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32048" y="646954"/>
              <a:ext cx="2880000" cy="19199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7" name="Gerade Verbindung 16">
              <a:extLst>
                <a:ext uri="{FF2B5EF4-FFF2-40B4-BE49-F238E27FC236}">
                  <a16:creationId xmlns="" xmlns:a16="http://schemas.microsoft.com/office/drawing/2014/main" id="{5524034E-2C03-BB40-BF6B-2F65A5711A11}"/>
                </a:ext>
              </a:extLst>
            </p:cNvPr>
            <p:cNvCxnSpPr/>
            <p:nvPr/>
          </p:nvCxnSpPr>
          <p:spPr>
            <a:xfrm>
              <a:off x="5819448" y="2446506"/>
              <a:ext cx="43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feld 17">
              <a:extLst>
                <a:ext uri="{FF2B5EF4-FFF2-40B4-BE49-F238E27FC236}">
                  <a16:creationId xmlns="" xmlns:a16="http://schemas.microsoft.com/office/drawing/2014/main" id="{0C02ED30-B4E1-4D47-B3A8-8796284EDF3A}"/>
                </a:ext>
              </a:extLst>
            </p:cNvPr>
            <p:cNvSpPr txBox="1"/>
            <p:nvPr/>
          </p:nvSpPr>
          <p:spPr>
            <a:xfrm>
              <a:off x="5854376" y="2291058"/>
              <a:ext cx="3626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19" name="Textfeld 18">
              <a:extLst>
                <a:ext uri="{FF2B5EF4-FFF2-40B4-BE49-F238E27FC236}">
                  <a16:creationId xmlns="" xmlns:a16="http://schemas.microsoft.com/office/drawing/2014/main" id="{4CCF8D54-822C-3748-BE1D-DC95369C16AA}"/>
                </a:ext>
              </a:extLst>
            </p:cNvPr>
            <p:cNvSpPr txBox="1"/>
            <p:nvPr/>
          </p:nvSpPr>
          <p:spPr>
            <a:xfrm>
              <a:off x="3429000" y="646954"/>
              <a:ext cx="504000" cy="179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60" name="Textfeld 59">
              <a:extLst>
                <a:ext uri="{FF2B5EF4-FFF2-40B4-BE49-F238E27FC236}">
                  <a16:creationId xmlns="" xmlns:a16="http://schemas.microsoft.com/office/drawing/2014/main" id="{7216ED5E-73A1-2148-BDBA-A4147B7D15C6}"/>
                </a:ext>
              </a:extLst>
            </p:cNvPr>
            <p:cNvSpPr txBox="1"/>
            <p:nvPr/>
          </p:nvSpPr>
          <p:spPr>
            <a:xfrm>
              <a:off x="4811129" y="1752600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61" name="Textfeld 60">
              <a:extLst>
                <a:ext uri="{FF2B5EF4-FFF2-40B4-BE49-F238E27FC236}">
                  <a16:creationId xmlns="" xmlns:a16="http://schemas.microsoft.com/office/drawing/2014/main" id="{45ABF277-695C-4440-B168-57CF594A0A41}"/>
                </a:ext>
              </a:extLst>
            </p:cNvPr>
            <p:cNvSpPr txBox="1"/>
            <p:nvPr/>
          </p:nvSpPr>
          <p:spPr>
            <a:xfrm>
              <a:off x="5257800" y="1312068"/>
              <a:ext cx="346937" cy="1848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61">
              <a:extLst>
                <a:ext uri="{FF2B5EF4-FFF2-40B4-BE49-F238E27FC236}">
                  <a16:creationId xmlns="" xmlns:a16="http://schemas.microsoft.com/office/drawing/2014/main" id="{3493EAD7-7184-5042-93E4-FD0ECA7726D4}"/>
                </a:ext>
              </a:extLst>
            </p:cNvPr>
            <p:cNvSpPr txBox="1"/>
            <p:nvPr/>
          </p:nvSpPr>
          <p:spPr>
            <a:xfrm>
              <a:off x="3881628" y="1511808"/>
              <a:ext cx="3209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feld 62">
              <a:extLst>
                <a:ext uri="{FF2B5EF4-FFF2-40B4-BE49-F238E27FC236}">
                  <a16:creationId xmlns="" xmlns:a16="http://schemas.microsoft.com/office/drawing/2014/main" id="{C29128D8-AE87-AE4B-A41C-932551274FF1}"/>
                </a:ext>
              </a:extLst>
            </p:cNvPr>
            <p:cNvSpPr txBox="1"/>
            <p:nvPr/>
          </p:nvSpPr>
          <p:spPr>
            <a:xfrm>
              <a:off x="4572533" y="1219735"/>
              <a:ext cx="346937" cy="1848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feld 63">
              <a:extLst>
                <a:ext uri="{FF2B5EF4-FFF2-40B4-BE49-F238E27FC236}">
                  <a16:creationId xmlns="" xmlns:a16="http://schemas.microsoft.com/office/drawing/2014/main" id="{932182B4-56C5-3F45-AF0F-8D2418F23318}"/>
                </a:ext>
              </a:extLst>
            </p:cNvPr>
            <p:cNvSpPr txBox="1"/>
            <p:nvPr/>
          </p:nvSpPr>
          <p:spPr>
            <a:xfrm>
              <a:off x="4991150" y="2159776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65" name="Textfeld 64">
              <a:extLst>
                <a:ext uri="{FF2B5EF4-FFF2-40B4-BE49-F238E27FC236}">
                  <a16:creationId xmlns="" xmlns:a16="http://schemas.microsoft.com/office/drawing/2014/main" id="{54CEA2E4-2578-EF47-ABCA-B2037DF66726}"/>
                </a:ext>
              </a:extLst>
            </p:cNvPr>
            <p:cNvSpPr txBox="1"/>
            <p:nvPr/>
          </p:nvSpPr>
          <p:spPr>
            <a:xfrm>
              <a:off x="4695072" y="2006764"/>
              <a:ext cx="346937" cy="1848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oup 48"/>
          <p:cNvGrpSpPr>
            <a:grpSpLocks noChangeAspect="1"/>
          </p:cNvGrpSpPr>
          <p:nvPr/>
        </p:nvGrpSpPr>
        <p:grpSpPr>
          <a:xfrm>
            <a:off x="439657" y="524164"/>
            <a:ext cx="2880000" cy="1925053"/>
            <a:chOff x="439657" y="641896"/>
            <a:chExt cx="2880001" cy="1925056"/>
          </a:xfrm>
        </p:grpSpPr>
        <p:pic>
          <p:nvPicPr>
            <p:cNvPr id="6" name="Grafik 5" descr="Ein Bild, das weiß, Essen, Foto, sitzend enthält.&#10;&#10;Automatisch generierte Beschreibung">
              <a:extLst>
                <a:ext uri="{FF2B5EF4-FFF2-40B4-BE49-F238E27FC236}">
                  <a16:creationId xmlns="" xmlns:a16="http://schemas.microsoft.com/office/drawing/2014/main" id="{4A25BA7A-0D15-024B-9EF6-A61DF71F97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9658" y="646955"/>
              <a:ext cx="2880000" cy="19199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8" name="Gerade Verbindung 7">
              <a:extLst>
                <a:ext uri="{FF2B5EF4-FFF2-40B4-BE49-F238E27FC236}">
                  <a16:creationId xmlns="" xmlns:a16="http://schemas.microsoft.com/office/drawing/2014/main" id="{B945760C-19BE-534F-ABB2-0C31F36ED620}"/>
                </a:ext>
              </a:extLst>
            </p:cNvPr>
            <p:cNvCxnSpPr/>
            <p:nvPr/>
          </p:nvCxnSpPr>
          <p:spPr>
            <a:xfrm>
              <a:off x="2819400" y="2438400"/>
              <a:ext cx="43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feld 12">
              <a:extLst>
                <a:ext uri="{FF2B5EF4-FFF2-40B4-BE49-F238E27FC236}">
                  <a16:creationId xmlns="" xmlns:a16="http://schemas.microsoft.com/office/drawing/2014/main" id="{A7066226-F5B9-3E4D-BDA5-0E6C77537E7C}"/>
                </a:ext>
              </a:extLst>
            </p:cNvPr>
            <p:cNvSpPr txBox="1"/>
            <p:nvPr/>
          </p:nvSpPr>
          <p:spPr>
            <a:xfrm>
              <a:off x="2854100" y="2286000"/>
              <a:ext cx="3626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14" name="Textfeld 13">
              <a:extLst>
                <a:ext uri="{FF2B5EF4-FFF2-40B4-BE49-F238E27FC236}">
                  <a16:creationId xmlns="" xmlns:a16="http://schemas.microsoft.com/office/drawing/2014/main" id="{F36D48AD-2785-DC4A-9544-E3D6B03F4FCF}"/>
                </a:ext>
              </a:extLst>
            </p:cNvPr>
            <p:cNvSpPr txBox="1"/>
            <p:nvPr/>
          </p:nvSpPr>
          <p:spPr>
            <a:xfrm>
              <a:off x="439657" y="641896"/>
              <a:ext cx="504000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66" name="Textfeld 65">
              <a:extLst>
                <a:ext uri="{FF2B5EF4-FFF2-40B4-BE49-F238E27FC236}">
                  <a16:creationId xmlns="" xmlns:a16="http://schemas.microsoft.com/office/drawing/2014/main" id="{91CE5B93-66FD-964B-8D96-94A4EC127B78}"/>
                </a:ext>
              </a:extLst>
            </p:cNvPr>
            <p:cNvSpPr txBox="1"/>
            <p:nvPr/>
          </p:nvSpPr>
          <p:spPr>
            <a:xfrm>
              <a:off x="1674812" y="1219735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feld 66">
              <a:extLst>
                <a:ext uri="{FF2B5EF4-FFF2-40B4-BE49-F238E27FC236}">
                  <a16:creationId xmlns="" xmlns:a16="http://schemas.microsoft.com/office/drawing/2014/main" id="{0337392B-009F-F44D-B2C2-64C17F92E6F1}"/>
                </a:ext>
              </a:extLst>
            </p:cNvPr>
            <p:cNvSpPr txBox="1"/>
            <p:nvPr/>
          </p:nvSpPr>
          <p:spPr>
            <a:xfrm>
              <a:off x="1087560" y="1327142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feld 67">
              <a:extLst>
                <a:ext uri="{FF2B5EF4-FFF2-40B4-BE49-F238E27FC236}">
                  <a16:creationId xmlns="" xmlns:a16="http://schemas.microsoft.com/office/drawing/2014/main" id="{3E8DC613-974F-B148-9840-5C9A17609463}"/>
                </a:ext>
              </a:extLst>
            </p:cNvPr>
            <p:cNvSpPr txBox="1"/>
            <p:nvPr/>
          </p:nvSpPr>
          <p:spPr>
            <a:xfrm>
              <a:off x="2209800" y="918895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feld 71">
              <a:extLst>
                <a:ext uri="{FF2B5EF4-FFF2-40B4-BE49-F238E27FC236}">
                  <a16:creationId xmlns="" xmlns:a16="http://schemas.microsoft.com/office/drawing/2014/main" id="{212FCC7C-CF17-844F-BB29-82DCE7552BCD}"/>
                </a:ext>
              </a:extLst>
            </p:cNvPr>
            <p:cNvSpPr txBox="1"/>
            <p:nvPr/>
          </p:nvSpPr>
          <p:spPr>
            <a:xfrm>
              <a:off x="1917732" y="1642434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73" name="Textfeld 72">
              <a:extLst>
                <a:ext uri="{FF2B5EF4-FFF2-40B4-BE49-F238E27FC236}">
                  <a16:creationId xmlns="" xmlns:a16="http://schemas.microsoft.com/office/drawing/2014/main" id="{16834363-54D8-964B-8217-8E1AE4E1730C}"/>
                </a:ext>
              </a:extLst>
            </p:cNvPr>
            <p:cNvSpPr txBox="1"/>
            <p:nvPr/>
          </p:nvSpPr>
          <p:spPr>
            <a:xfrm>
              <a:off x="2349446" y="1339282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76" name="Textfeld 75">
              <a:extLst>
                <a:ext uri="{FF2B5EF4-FFF2-40B4-BE49-F238E27FC236}">
                  <a16:creationId xmlns="" xmlns:a16="http://schemas.microsoft.com/office/drawing/2014/main" id="{4050FB65-C1B9-CE4B-BC4C-CC8DC77621BA}"/>
                </a:ext>
              </a:extLst>
            </p:cNvPr>
            <p:cNvSpPr txBox="1"/>
            <p:nvPr/>
          </p:nvSpPr>
          <p:spPr>
            <a:xfrm>
              <a:off x="2907946" y="2096094"/>
              <a:ext cx="3209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feld 76">
              <a:extLst>
                <a:ext uri="{FF2B5EF4-FFF2-40B4-BE49-F238E27FC236}">
                  <a16:creationId xmlns="" xmlns:a16="http://schemas.microsoft.com/office/drawing/2014/main" id="{E82D98A0-5EF5-5546-B27E-2925F4A6AC20}"/>
                </a:ext>
              </a:extLst>
            </p:cNvPr>
            <p:cNvSpPr txBox="1"/>
            <p:nvPr/>
          </p:nvSpPr>
          <p:spPr>
            <a:xfrm>
              <a:off x="2792004" y="1080998"/>
              <a:ext cx="3209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oup 34"/>
          <p:cNvGrpSpPr>
            <a:grpSpLocks noChangeAspect="1"/>
          </p:cNvGrpSpPr>
          <p:nvPr/>
        </p:nvGrpSpPr>
        <p:grpSpPr>
          <a:xfrm>
            <a:off x="416796" y="6548428"/>
            <a:ext cx="2880000" cy="1924749"/>
            <a:chOff x="416796" y="7224274"/>
            <a:chExt cx="2896764" cy="1935957"/>
          </a:xfrm>
        </p:grpSpPr>
        <p:pic>
          <p:nvPicPr>
            <p:cNvPr id="51" name="Grafik 50" descr="Ein Bild, das draußen, Berg, Foto, Seite enthält.&#10;&#10;Automatisch generierte Beschreibung">
              <a:extLst>
                <a:ext uri="{FF2B5EF4-FFF2-40B4-BE49-F238E27FC236}">
                  <a16:creationId xmlns="" xmlns:a16="http://schemas.microsoft.com/office/drawing/2014/main" id="{F2F0D41A-B7EF-2D4C-8A02-7DB1842D21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3560" y="7224274"/>
              <a:ext cx="2880000" cy="19359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52" name="Gerade Verbindung 51">
              <a:extLst>
                <a:ext uri="{FF2B5EF4-FFF2-40B4-BE49-F238E27FC236}">
                  <a16:creationId xmlns="" xmlns:a16="http://schemas.microsoft.com/office/drawing/2014/main" id="{4F1A9025-7AE5-8943-BB99-235E178F5DEC}"/>
                </a:ext>
              </a:extLst>
            </p:cNvPr>
            <p:cNvCxnSpPr/>
            <p:nvPr/>
          </p:nvCxnSpPr>
          <p:spPr>
            <a:xfrm>
              <a:off x="2792004" y="9053895"/>
              <a:ext cx="43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feld 52">
              <a:extLst>
                <a:ext uri="{FF2B5EF4-FFF2-40B4-BE49-F238E27FC236}">
                  <a16:creationId xmlns="" xmlns:a16="http://schemas.microsoft.com/office/drawing/2014/main" id="{E5EEEFBB-75E2-3741-A308-0829A064DCF4}"/>
                </a:ext>
              </a:extLst>
            </p:cNvPr>
            <p:cNvSpPr txBox="1"/>
            <p:nvPr/>
          </p:nvSpPr>
          <p:spPr>
            <a:xfrm>
              <a:off x="2826932" y="8898447"/>
              <a:ext cx="3626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54" name="Textfeld 53">
              <a:extLst>
                <a:ext uri="{FF2B5EF4-FFF2-40B4-BE49-F238E27FC236}">
                  <a16:creationId xmlns="" xmlns:a16="http://schemas.microsoft.com/office/drawing/2014/main" id="{78554C54-827B-424C-AAA8-A7A3FBD76BD9}"/>
                </a:ext>
              </a:extLst>
            </p:cNvPr>
            <p:cNvSpPr txBox="1"/>
            <p:nvPr/>
          </p:nvSpPr>
          <p:spPr>
            <a:xfrm>
              <a:off x="416796" y="7224274"/>
              <a:ext cx="504000" cy="1800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AUY-VE</a:t>
              </a:r>
            </a:p>
          </p:txBody>
        </p:sp>
        <p:sp>
          <p:nvSpPr>
            <p:cNvPr id="93" name="Textfeld 92">
              <a:extLst>
                <a:ext uri="{FF2B5EF4-FFF2-40B4-BE49-F238E27FC236}">
                  <a16:creationId xmlns="" xmlns:a16="http://schemas.microsoft.com/office/drawing/2014/main" id="{771FF4E8-992B-5C48-AA03-B947C2F8223D}"/>
                </a:ext>
              </a:extLst>
            </p:cNvPr>
            <p:cNvSpPr txBox="1"/>
            <p:nvPr/>
          </p:nvSpPr>
          <p:spPr>
            <a:xfrm>
              <a:off x="1674812" y="7444411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feld 94">
              <a:extLst>
                <a:ext uri="{FF2B5EF4-FFF2-40B4-BE49-F238E27FC236}">
                  <a16:creationId xmlns="" xmlns:a16="http://schemas.microsoft.com/office/drawing/2014/main" id="{BBF38739-0D86-B645-AE85-5AD7267F4981}"/>
                </a:ext>
              </a:extLst>
            </p:cNvPr>
            <p:cNvSpPr txBox="1"/>
            <p:nvPr/>
          </p:nvSpPr>
          <p:spPr>
            <a:xfrm>
              <a:off x="481317" y="7892362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96" name="Textfeld 95">
              <a:extLst>
                <a:ext uri="{FF2B5EF4-FFF2-40B4-BE49-F238E27FC236}">
                  <a16:creationId xmlns="" xmlns:a16="http://schemas.microsoft.com/office/drawing/2014/main" id="{32EB5C5E-24F8-D347-8694-21660F468886}"/>
                </a:ext>
              </a:extLst>
            </p:cNvPr>
            <p:cNvSpPr txBox="1"/>
            <p:nvPr/>
          </p:nvSpPr>
          <p:spPr>
            <a:xfrm>
              <a:off x="627351" y="8714514"/>
              <a:ext cx="348587" cy="1857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feld 96">
              <a:extLst>
                <a:ext uri="{FF2B5EF4-FFF2-40B4-BE49-F238E27FC236}">
                  <a16:creationId xmlns="" xmlns:a16="http://schemas.microsoft.com/office/drawing/2014/main" id="{ED0155BF-4D6E-0E47-9864-90BA659372C6}"/>
                </a:ext>
              </a:extLst>
            </p:cNvPr>
            <p:cNvSpPr txBox="1"/>
            <p:nvPr/>
          </p:nvSpPr>
          <p:spPr>
            <a:xfrm>
              <a:off x="511854" y="8357464"/>
              <a:ext cx="348587" cy="1857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feld 97">
              <a:extLst>
                <a:ext uri="{FF2B5EF4-FFF2-40B4-BE49-F238E27FC236}">
                  <a16:creationId xmlns="" xmlns:a16="http://schemas.microsoft.com/office/drawing/2014/main" id="{3F49CA99-5CC7-0B46-B24A-AB384729DA6F}"/>
                </a:ext>
              </a:extLst>
            </p:cNvPr>
            <p:cNvSpPr txBox="1"/>
            <p:nvPr/>
          </p:nvSpPr>
          <p:spPr>
            <a:xfrm>
              <a:off x="1993621" y="8718755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101" name="Textfeld 100">
              <a:extLst>
                <a:ext uri="{FF2B5EF4-FFF2-40B4-BE49-F238E27FC236}">
                  <a16:creationId xmlns="" xmlns:a16="http://schemas.microsoft.com/office/drawing/2014/main" id="{634740EE-04AB-F940-AB7D-F0DAAA64F505}"/>
                </a:ext>
              </a:extLst>
            </p:cNvPr>
            <p:cNvSpPr txBox="1"/>
            <p:nvPr/>
          </p:nvSpPr>
          <p:spPr>
            <a:xfrm>
              <a:off x="947664" y="8714514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102" name="Textfeld 101">
              <a:extLst>
                <a:ext uri="{FF2B5EF4-FFF2-40B4-BE49-F238E27FC236}">
                  <a16:creationId xmlns="" xmlns:a16="http://schemas.microsoft.com/office/drawing/2014/main" id="{989670FB-81EF-D543-84DC-2B05B6B78223}"/>
                </a:ext>
              </a:extLst>
            </p:cNvPr>
            <p:cNvSpPr txBox="1"/>
            <p:nvPr/>
          </p:nvSpPr>
          <p:spPr>
            <a:xfrm>
              <a:off x="2437116" y="7479678"/>
              <a:ext cx="348587" cy="1857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feld 113">
              <a:extLst>
                <a:ext uri="{FF2B5EF4-FFF2-40B4-BE49-F238E27FC236}">
                  <a16:creationId xmlns="" xmlns:a16="http://schemas.microsoft.com/office/drawing/2014/main" id="{365E5075-7254-D043-AD7D-5F7DB3678053}"/>
                </a:ext>
              </a:extLst>
            </p:cNvPr>
            <p:cNvSpPr txBox="1"/>
            <p:nvPr/>
          </p:nvSpPr>
          <p:spPr>
            <a:xfrm>
              <a:off x="2203780" y="7651044"/>
              <a:ext cx="4427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pid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sicle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feld 117">
              <a:extLst>
                <a:ext uri="{FF2B5EF4-FFF2-40B4-BE49-F238E27FC236}">
                  <a16:creationId xmlns="" xmlns:a16="http://schemas.microsoft.com/office/drawing/2014/main" id="{43D0CFD9-7617-5C43-AE13-AF9B14BEBEDA}"/>
                </a:ext>
              </a:extLst>
            </p:cNvPr>
            <p:cNvSpPr txBox="1"/>
            <p:nvPr/>
          </p:nvSpPr>
          <p:spPr>
            <a:xfrm>
              <a:off x="1929677" y="7945841"/>
              <a:ext cx="4427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pid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sicle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feld 118">
              <a:extLst>
                <a:ext uri="{FF2B5EF4-FFF2-40B4-BE49-F238E27FC236}">
                  <a16:creationId xmlns="" xmlns:a16="http://schemas.microsoft.com/office/drawing/2014/main" id="{C09142F4-7427-FA44-9229-28F6393E885B}"/>
                </a:ext>
              </a:extLst>
            </p:cNvPr>
            <p:cNvSpPr txBox="1"/>
            <p:nvPr/>
          </p:nvSpPr>
          <p:spPr>
            <a:xfrm>
              <a:off x="1549180" y="8581476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ut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feld 119">
              <a:extLst>
                <a:ext uri="{FF2B5EF4-FFF2-40B4-BE49-F238E27FC236}">
                  <a16:creationId xmlns="" xmlns:a16="http://schemas.microsoft.com/office/drawing/2014/main" id="{A503E37C-A66B-D949-B607-917B3FE4BA5D}"/>
                </a:ext>
              </a:extLst>
            </p:cNvPr>
            <p:cNvSpPr txBox="1"/>
            <p:nvPr/>
          </p:nvSpPr>
          <p:spPr>
            <a:xfrm>
              <a:off x="1791975" y="8350644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feld 121">
              <a:extLst>
                <a:ext uri="{FF2B5EF4-FFF2-40B4-BE49-F238E27FC236}">
                  <a16:creationId xmlns="" xmlns:a16="http://schemas.microsoft.com/office/drawing/2014/main" id="{1B3C42DE-FD46-3847-99D2-FF4392C49084}"/>
                </a:ext>
              </a:extLst>
            </p:cNvPr>
            <p:cNvSpPr txBox="1"/>
            <p:nvPr/>
          </p:nvSpPr>
          <p:spPr>
            <a:xfrm>
              <a:off x="2288817" y="8340713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ut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Freihandform 6">
              <a:extLst>
                <a:ext uri="{FF2B5EF4-FFF2-40B4-BE49-F238E27FC236}">
                  <a16:creationId xmlns="" xmlns:a16="http://schemas.microsoft.com/office/drawing/2014/main" id="{979F6691-31FB-EF44-AB27-A9B75749B5CE}"/>
                </a:ext>
              </a:extLst>
            </p:cNvPr>
            <p:cNvSpPr/>
            <p:nvPr/>
          </p:nvSpPr>
          <p:spPr>
            <a:xfrm>
              <a:off x="421419" y="7776376"/>
              <a:ext cx="381663" cy="429370"/>
            </a:xfrm>
            <a:custGeom>
              <a:avLst/>
              <a:gdLst>
                <a:gd name="connsiteX0" fmla="*/ 127221 w 381663"/>
                <a:gd name="connsiteY0" fmla="*/ 15902 h 429370"/>
                <a:gd name="connsiteX1" fmla="*/ 222637 w 381663"/>
                <a:gd name="connsiteY1" fmla="*/ 23854 h 429370"/>
                <a:gd name="connsiteX2" fmla="*/ 341906 w 381663"/>
                <a:gd name="connsiteY2" fmla="*/ 95415 h 429370"/>
                <a:gd name="connsiteX3" fmla="*/ 381663 w 381663"/>
                <a:gd name="connsiteY3" fmla="*/ 206734 h 429370"/>
                <a:gd name="connsiteX4" fmla="*/ 357809 w 381663"/>
                <a:gd name="connsiteY4" fmla="*/ 357808 h 429370"/>
                <a:gd name="connsiteX5" fmla="*/ 222637 w 381663"/>
                <a:gd name="connsiteY5" fmla="*/ 429370 h 429370"/>
                <a:gd name="connsiteX6" fmla="*/ 79513 w 381663"/>
                <a:gd name="connsiteY6" fmla="*/ 341906 h 429370"/>
                <a:gd name="connsiteX7" fmla="*/ 7951 w 381663"/>
                <a:gd name="connsiteY7" fmla="*/ 278295 h 429370"/>
                <a:gd name="connsiteX8" fmla="*/ 0 w 381663"/>
                <a:gd name="connsiteY8" fmla="*/ 95415 h 429370"/>
                <a:gd name="connsiteX9" fmla="*/ 39757 w 381663"/>
                <a:gd name="connsiteY9" fmla="*/ 0 h 429370"/>
                <a:gd name="connsiteX10" fmla="*/ 127221 w 381663"/>
                <a:gd name="connsiteY10" fmla="*/ 15902 h 4293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381663" h="429370" extrusionOk="0">
                  <a:moveTo>
                    <a:pt x="127221" y="15902"/>
                  </a:moveTo>
                  <a:cubicBezTo>
                    <a:pt x="165900" y="14051"/>
                    <a:pt x="180468" y="27955"/>
                    <a:pt x="222637" y="23854"/>
                  </a:cubicBezTo>
                  <a:cubicBezTo>
                    <a:pt x="275938" y="47964"/>
                    <a:pt x="298621" y="69948"/>
                    <a:pt x="341906" y="95415"/>
                  </a:cubicBezTo>
                  <a:cubicBezTo>
                    <a:pt x="357007" y="128470"/>
                    <a:pt x="355849" y="169712"/>
                    <a:pt x="381663" y="206734"/>
                  </a:cubicBezTo>
                  <a:cubicBezTo>
                    <a:pt x="393335" y="248723"/>
                    <a:pt x="354558" y="310528"/>
                    <a:pt x="357809" y="357808"/>
                  </a:cubicBezTo>
                  <a:cubicBezTo>
                    <a:pt x="318266" y="388158"/>
                    <a:pt x="258156" y="391979"/>
                    <a:pt x="222637" y="429370"/>
                  </a:cubicBezTo>
                  <a:cubicBezTo>
                    <a:pt x="157821" y="412718"/>
                    <a:pt x="137225" y="375847"/>
                    <a:pt x="79513" y="341906"/>
                  </a:cubicBezTo>
                  <a:cubicBezTo>
                    <a:pt x="49994" y="316440"/>
                    <a:pt x="46946" y="305882"/>
                    <a:pt x="7951" y="278295"/>
                  </a:cubicBezTo>
                  <a:cubicBezTo>
                    <a:pt x="-15034" y="187887"/>
                    <a:pt x="23139" y="151687"/>
                    <a:pt x="0" y="95415"/>
                  </a:cubicBezTo>
                  <a:cubicBezTo>
                    <a:pt x="6812" y="74756"/>
                    <a:pt x="30128" y="34431"/>
                    <a:pt x="39757" y="0"/>
                  </a:cubicBezTo>
                  <a:cubicBezTo>
                    <a:pt x="65288" y="-3035"/>
                    <a:pt x="98775" y="13949"/>
                    <a:pt x="127221" y="15902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127221 w 381663"/>
                        <a:gd name="connsiteY0" fmla="*/ 15902 h 429370"/>
                        <a:gd name="connsiteX1" fmla="*/ 222637 w 381663"/>
                        <a:gd name="connsiteY1" fmla="*/ 23854 h 429370"/>
                        <a:gd name="connsiteX2" fmla="*/ 341906 w 381663"/>
                        <a:gd name="connsiteY2" fmla="*/ 95415 h 429370"/>
                        <a:gd name="connsiteX3" fmla="*/ 381663 w 381663"/>
                        <a:gd name="connsiteY3" fmla="*/ 206734 h 429370"/>
                        <a:gd name="connsiteX4" fmla="*/ 357809 w 381663"/>
                        <a:gd name="connsiteY4" fmla="*/ 357808 h 429370"/>
                        <a:gd name="connsiteX5" fmla="*/ 222637 w 381663"/>
                        <a:gd name="connsiteY5" fmla="*/ 429370 h 429370"/>
                        <a:gd name="connsiteX6" fmla="*/ 79513 w 381663"/>
                        <a:gd name="connsiteY6" fmla="*/ 341906 h 429370"/>
                        <a:gd name="connsiteX7" fmla="*/ 7951 w 381663"/>
                        <a:gd name="connsiteY7" fmla="*/ 278295 h 429370"/>
                        <a:gd name="connsiteX8" fmla="*/ 0 w 381663"/>
                        <a:gd name="connsiteY8" fmla="*/ 95415 h 429370"/>
                        <a:gd name="connsiteX9" fmla="*/ 39757 w 381663"/>
                        <a:gd name="connsiteY9" fmla="*/ 0 h 429370"/>
                        <a:gd name="connsiteX10" fmla="*/ 127221 w 381663"/>
                        <a:gd name="connsiteY10" fmla="*/ 15902 h 42937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</a:cxnLst>
                      <a:rect l="l" t="t" r="r" b="b"/>
                      <a:pathLst>
                        <a:path w="381663" h="429370">
                          <a:moveTo>
                            <a:pt x="127221" y="15902"/>
                          </a:moveTo>
                          <a:lnTo>
                            <a:pt x="222637" y="23854"/>
                          </a:lnTo>
                          <a:lnTo>
                            <a:pt x="341906" y="95415"/>
                          </a:lnTo>
                          <a:lnTo>
                            <a:pt x="381663" y="206734"/>
                          </a:lnTo>
                          <a:lnTo>
                            <a:pt x="357809" y="357808"/>
                          </a:lnTo>
                          <a:lnTo>
                            <a:pt x="222637" y="429370"/>
                          </a:lnTo>
                          <a:lnTo>
                            <a:pt x="79513" y="341906"/>
                          </a:lnTo>
                          <a:lnTo>
                            <a:pt x="7951" y="278295"/>
                          </a:lnTo>
                          <a:lnTo>
                            <a:pt x="0" y="95415"/>
                          </a:lnTo>
                          <a:lnTo>
                            <a:pt x="39757" y="0"/>
                          </a:lnTo>
                          <a:lnTo>
                            <a:pt x="127221" y="15902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8" name="Textfeld 127">
              <a:extLst>
                <a:ext uri="{FF2B5EF4-FFF2-40B4-BE49-F238E27FC236}">
                  <a16:creationId xmlns="" xmlns:a16="http://schemas.microsoft.com/office/drawing/2014/main" id="{21E72CEB-6EF6-324E-A9A0-8C1D29B61457}"/>
                </a:ext>
              </a:extLst>
            </p:cNvPr>
            <p:cNvSpPr txBox="1"/>
            <p:nvPr/>
          </p:nvSpPr>
          <p:spPr>
            <a:xfrm>
              <a:off x="2931699" y="7560164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u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Freihandform 14">
              <a:extLst>
                <a:ext uri="{FF2B5EF4-FFF2-40B4-BE49-F238E27FC236}">
                  <a16:creationId xmlns="" xmlns:a16="http://schemas.microsoft.com/office/drawing/2014/main" id="{63D797CB-E6C0-2F48-98EE-14D305C8B2CC}"/>
                </a:ext>
              </a:extLst>
            </p:cNvPr>
            <p:cNvSpPr/>
            <p:nvPr/>
          </p:nvSpPr>
          <p:spPr>
            <a:xfrm>
              <a:off x="2727297" y="7267492"/>
              <a:ext cx="500933" cy="381663"/>
            </a:xfrm>
            <a:custGeom>
              <a:avLst/>
              <a:gdLst>
                <a:gd name="connsiteX0" fmla="*/ 31806 w 500933"/>
                <a:gd name="connsiteY0" fmla="*/ 63611 h 381663"/>
                <a:gd name="connsiteX1" fmla="*/ 0 w 500933"/>
                <a:gd name="connsiteY1" fmla="*/ 159026 h 381663"/>
                <a:gd name="connsiteX2" fmla="*/ 63611 w 500933"/>
                <a:gd name="connsiteY2" fmla="*/ 302150 h 381663"/>
                <a:gd name="connsiteX3" fmla="*/ 182880 w 500933"/>
                <a:gd name="connsiteY3" fmla="*/ 381663 h 381663"/>
                <a:gd name="connsiteX4" fmla="*/ 389614 w 500933"/>
                <a:gd name="connsiteY4" fmla="*/ 349858 h 381663"/>
                <a:gd name="connsiteX5" fmla="*/ 500933 w 500933"/>
                <a:gd name="connsiteY5" fmla="*/ 238539 h 381663"/>
                <a:gd name="connsiteX6" fmla="*/ 461176 w 500933"/>
                <a:gd name="connsiteY6" fmla="*/ 103367 h 381663"/>
                <a:gd name="connsiteX7" fmla="*/ 349858 w 500933"/>
                <a:gd name="connsiteY7" fmla="*/ 0 h 381663"/>
                <a:gd name="connsiteX8" fmla="*/ 151075 w 500933"/>
                <a:gd name="connsiteY8" fmla="*/ 0 h 381663"/>
                <a:gd name="connsiteX9" fmla="*/ 31806 w 500933"/>
                <a:gd name="connsiteY9" fmla="*/ 63611 h 3816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500933" h="381663" extrusionOk="0">
                  <a:moveTo>
                    <a:pt x="31806" y="63611"/>
                  </a:moveTo>
                  <a:cubicBezTo>
                    <a:pt x="21818" y="107762"/>
                    <a:pt x="2455" y="133853"/>
                    <a:pt x="0" y="159026"/>
                  </a:cubicBezTo>
                  <a:cubicBezTo>
                    <a:pt x="33771" y="225275"/>
                    <a:pt x="26469" y="246736"/>
                    <a:pt x="63611" y="302150"/>
                  </a:cubicBezTo>
                  <a:cubicBezTo>
                    <a:pt x="100417" y="324932"/>
                    <a:pt x="141358" y="359438"/>
                    <a:pt x="182880" y="381663"/>
                  </a:cubicBezTo>
                  <a:cubicBezTo>
                    <a:pt x="280054" y="345207"/>
                    <a:pt x="331018" y="382180"/>
                    <a:pt x="389614" y="349858"/>
                  </a:cubicBezTo>
                  <a:cubicBezTo>
                    <a:pt x="409066" y="308087"/>
                    <a:pt x="478627" y="280852"/>
                    <a:pt x="500933" y="238539"/>
                  </a:cubicBezTo>
                  <a:cubicBezTo>
                    <a:pt x="476166" y="183457"/>
                    <a:pt x="489798" y="146592"/>
                    <a:pt x="461176" y="103367"/>
                  </a:cubicBezTo>
                  <a:cubicBezTo>
                    <a:pt x="412589" y="82797"/>
                    <a:pt x="404201" y="36371"/>
                    <a:pt x="349858" y="0"/>
                  </a:cubicBezTo>
                  <a:cubicBezTo>
                    <a:pt x="280088" y="11975"/>
                    <a:pt x="195712" y="-13924"/>
                    <a:pt x="151075" y="0"/>
                  </a:cubicBezTo>
                  <a:cubicBezTo>
                    <a:pt x="105279" y="29597"/>
                    <a:pt x="68655" y="41148"/>
                    <a:pt x="31806" y="63611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31806 w 500933"/>
                        <a:gd name="connsiteY0" fmla="*/ 63611 h 381663"/>
                        <a:gd name="connsiteX1" fmla="*/ 0 w 500933"/>
                        <a:gd name="connsiteY1" fmla="*/ 159026 h 381663"/>
                        <a:gd name="connsiteX2" fmla="*/ 63611 w 500933"/>
                        <a:gd name="connsiteY2" fmla="*/ 302150 h 381663"/>
                        <a:gd name="connsiteX3" fmla="*/ 182880 w 500933"/>
                        <a:gd name="connsiteY3" fmla="*/ 381663 h 381663"/>
                        <a:gd name="connsiteX4" fmla="*/ 389614 w 500933"/>
                        <a:gd name="connsiteY4" fmla="*/ 349858 h 381663"/>
                        <a:gd name="connsiteX5" fmla="*/ 500933 w 500933"/>
                        <a:gd name="connsiteY5" fmla="*/ 238539 h 381663"/>
                        <a:gd name="connsiteX6" fmla="*/ 461176 w 500933"/>
                        <a:gd name="connsiteY6" fmla="*/ 103367 h 381663"/>
                        <a:gd name="connsiteX7" fmla="*/ 349858 w 500933"/>
                        <a:gd name="connsiteY7" fmla="*/ 0 h 381663"/>
                        <a:gd name="connsiteX8" fmla="*/ 151075 w 500933"/>
                        <a:gd name="connsiteY8" fmla="*/ 0 h 381663"/>
                        <a:gd name="connsiteX9" fmla="*/ 31806 w 500933"/>
                        <a:gd name="connsiteY9" fmla="*/ 63611 h 381663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</a:cxnLst>
                      <a:rect l="l" t="t" r="r" b="b"/>
                      <a:pathLst>
                        <a:path w="500933" h="381663">
                          <a:moveTo>
                            <a:pt x="31806" y="63611"/>
                          </a:moveTo>
                          <a:lnTo>
                            <a:pt x="0" y="159026"/>
                          </a:lnTo>
                          <a:lnTo>
                            <a:pt x="63611" y="302150"/>
                          </a:lnTo>
                          <a:lnTo>
                            <a:pt x="182880" y="381663"/>
                          </a:lnTo>
                          <a:lnTo>
                            <a:pt x="389614" y="349858"/>
                          </a:lnTo>
                          <a:lnTo>
                            <a:pt x="500933" y="238539"/>
                          </a:lnTo>
                          <a:lnTo>
                            <a:pt x="461176" y="103367"/>
                          </a:lnTo>
                          <a:lnTo>
                            <a:pt x="349858" y="0"/>
                          </a:lnTo>
                          <a:lnTo>
                            <a:pt x="151075" y="0"/>
                          </a:lnTo>
                          <a:lnTo>
                            <a:pt x="31806" y="63611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0" name="Freihandform 19">
              <a:extLst>
                <a:ext uri="{FF2B5EF4-FFF2-40B4-BE49-F238E27FC236}">
                  <a16:creationId xmlns="" xmlns:a16="http://schemas.microsoft.com/office/drawing/2014/main" id="{2DDDB8EB-2939-D146-9356-52F693D0BBC7}"/>
                </a:ext>
              </a:extLst>
            </p:cNvPr>
            <p:cNvSpPr/>
            <p:nvPr/>
          </p:nvSpPr>
          <p:spPr>
            <a:xfrm>
              <a:off x="1248355" y="7386762"/>
              <a:ext cx="763325" cy="389614"/>
            </a:xfrm>
            <a:custGeom>
              <a:avLst/>
              <a:gdLst>
                <a:gd name="connsiteX0" fmla="*/ 461175 w 763325"/>
                <a:gd name="connsiteY0" fmla="*/ 47708 h 389614"/>
                <a:gd name="connsiteX1" fmla="*/ 373711 w 763325"/>
                <a:gd name="connsiteY1" fmla="*/ 71561 h 389614"/>
                <a:gd name="connsiteX2" fmla="*/ 262393 w 763325"/>
                <a:gd name="connsiteY2" fmla="*/ 111318 h 389614"/>
                <a:gd name="connsiteX3" fmla="*/ 111318 w 763325"/>
                <a:gd name="connsiteY3" fmla="*/ 151075 h 389614"/>
                <a:gd name="connsiteX4" fmla="*/ 0 w 763325"/>
                <a:gd name="connsiteY4" fmla="*/ 262393 h 389614"/>
                <a:gd name="connsiteX5" fmla="*/ 87464 w 763325"/>
                <a:gd name="connsiteY5" fmla="*/ 373711 h 389614"/>
                <a:gd name="connsiteX6" fmla="*/ 206734 w 763325"/>
                <a:gd name="connsiteY6" fmla="*/ 389614 h 389614"/>
                <a:gd name="connsiteX7" fmla="*/ 405516 w 763325"/>
                <a:gd name="connsiteY7" fmla="*/ 373711 h 389614"/>
                <a:gd name="connsiteX8" fmla="*/ 508883 w 763325"/>
                <a:gd name="connsiteY8" fmla="*/ 365760 h 389614"/>
                <a:gd name="connsiteX9" fmla="*/ 612250 w 763325"/>
                <a:gd name="connsiteY9" fmla="*/ 286247 h 389614"/>
                <a:gd name="connsiteX10" fmla="*/ 763325 w 763325"/>
                <a:gd name="connsiteY10" fmla="*/ 151075 h 389614"/>
                <a:gd name="connsiteX11" fmla="*/ 715617 w 763325"/>
                <a:gd name="connsiteY11" fmla="*/ 63610 h 389614"/>
                <a:gd name="connsiteX12" fmla="*/ 636104 w 763325"/>
                <a:gd name="connsiteY12" fmla="*/ 7951 h 389614"/>
                <a:gd name="connsiteX13" fmla="*/ 524786 w 763325"/>
                <a:gd name="connsiteY13" fmla="*/ 0 h 389614"/>
                <a:gd name="connsiteX14" fmla="*/ 461175 w 763325"/>
                <a:gd name="connsiteY14" fmla="*/ 47708 h 3896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</a:cxnLst>
              <a:rect l="l" t="t" r="r" b="b"/>
              <a:pathLst>
                <a:path w="763325" h="389614" extrusionOk="0">
                  <a:moveTo>
                    <a:pt x="461175" y="47708"/>
                  </a:moveTo>
                  <a:cubicBezTo>
                    <a:pt x="428186" y="66769"/>
                    <a:pt x="405728" y="53498"/>
                    <a:pt x="373711" y="71561"/>
                  </a:cubicBezTo>
                  <a:cubicBezTo>
                    <a:pt x="325511" y="97326"/>
                    <a:pt x="292137" y="96157"/>
                    <a:pt x="262393" y="111318"/>
                  </a:cubicBezTo>
                  <a:cubicBezTo>
                    <a:pt x="191908" y="147052"/>
                    <a:pt x="180045" y="121930"/>
                    <a:pt x="111318" y="151075"/>
                  </a:cubicBezTo>
                  <a:cubicBezTo>
                    <a:pt x="58466" y="204049"/>
                    <a:pt x="31897" y="216918"/>
                    <a:pt x="0" y="262393"/>
                  </a:cubicBezTo>
                  <a:cubicBezTo>
                    <a:pt x="50705" y="311437"/>
                    <a:pt x="42961" y="332282"/>
                    <a:pt x="87464" y="373711"/>
                  </a:cubicBezTo>
                  <a:cubicBezTo>
                    <a:pt x="131852" y="367309"/>
                    <a:pt x="162841" y="384286"/>
                    <a:pt x="206734" y="389614"/>
                  </a:cubicBezTo>
                  <a:cubicBezTo>
                    <a:pt x="267397" y="372071"/>
                    <a:pt x="339628" y="402349"/>
                    <a:pt x="405516" y="373711"/>
                  </a:cubicBezTo>
                  <a:cubicBezTo>
                    <a:pt x="454320" y="363619"/>
                    <a:pt x="460809" y="370491"/>
                    <a:pt x="508883" y="365760"/>
                  </a:cubicBezTo>
                  <a:cubicBezTo>
                    <a:pt x="547790" y="326714"/>
                    <a:pt x="581399" y="318135"/>
                    <a:pt x="612250" y="286247"/>
                  </a:cubicBezTo>
                  <a:cubicBezTo>
                    <a:pt x="640037" y="248813"/>
                    <a:pt x="714556" y="201446"/>
                    <a:pt x="763325" y="151075"/>
                  </a:cubicBezTo>
                  <a:cubicBezTo>
                    <a:pt x="750572" y="128543"/>
                    <a:pt x="736798" y="85145"/>
                    <a:pt x="715617" y="63610"/>
                  </a:cubicBezTo>
                  <a:cubicBezTo>
                    <a:pt x="686346" y="50320"/>
                    <a:pt x="663907" y="27135"/>
                    <a:pt x="636104" y="7951"/>
                  </a:cubicBezTo>
                  <a:cubicBezTo>
                    <a:pt x="595941" y="12079"/>
                    <a:pt x="576879" y="-9486"/>
                    <a:pt x="524786" y="0"/>
                  </a:cubicBezTo>
                  <a:cubicBezTo>
                    <a:pt x="504769" y="25227"/>
                    <a:pt x="487792" y="22710"/>
                    <a:pt x="461175" y="47708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461175 w 763325"/>
                        <a:gd name="connsiteY0" fmla="*/ 47708 h 389614"/>
                        <a:gd name="connsiteX1" fmla="*/ 373711 w 763325"/>
                        <a:gd name="connsiteY1" fmla="*/ 71561 h 389614"/>
                        <a:gd name="connsiteX2" fmla="*/ 262393 w 763325"/>
                        <a:gd name="connsiteY2" fmla="*/ 111318 h 389614"/>
                        <a:gd name="connsiteX3" fmla="*/ 111318 w 763325"/>
                        <a:gd name="connsiteY3" fmla="*/ 151075 h 389614"/>
                        <a:gd name="connsiteX4" fmla="*/ 0 w 763325"/>
                        <a:gd name="connsiteY4" fmla="*/ 262393 h 389614"/>
                        <a:gd name="connsiteX5" fmla="*/ 87464 w 763325"/>
                        <a:gd name="connsiteY5" fmla="*/ 373711 h 389614"/>
                        <a:gd name="connsiteX6" fmla="*/ 206734 w 763325"/>
                        <a:gd name="connsiteY6" fmla="*/ 389614 h 389614"/>
                        <a:gd name="connsiteX7" fmla="*/ 405516 w 763325"/>
                        <a:gd name="connsiteY7" fmla="*/ 373711 h 389614"/>
                        <a:gd name="connsiteX8" fmla="*/ 508883 w 763325"/>
                        <a:gd name="connsiteY8" fmla="*/ 365760 h 389614"/>
                        <a:gd name="connsiteX9" fmla="*/ 612250 w 763325"/>
                        <a:gd name="connsiteY9" fmla="*/ 286247 h 389614"/>
                        <a:gd name="connsiteX10" fmla="*/ 763325 w 763325"/>
                        <a:gd name="connsiteY10" fmla="*/ 151075 h 389614"/>
                        <a:gd name="connsiteX11" fmla="*/ 715617 w 763325"/>
                        <a:gd name="connsiteY11" fmla="*/ 63610 h 389614"/>
                        <a:gd name="connsiteX12" fmla="*/ 636104 w 763325"/>
                        <a:gd name="connsiteY12" fmla="*/ 7951 h 389614"/>
                        <a:gd name="connsiteX13" fmla="*/ 524786 w 763325"/>
                        <a:gd name="connsiteY13" fmla="*/ 0 h 389614"/>
                        <a:gd name="connsiteX14" fmla="*/ 461175 w 763325"/>
                        <a:gd name="connsiteY14" fmla="*/ 47708 h 389614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</a:cxnLst>
                      <a:rect l="l" t="t" r="r" b="b"/>
                      <a:pathLst>
                        <a:path w="763325" h="389614">
                          <a:moveTo>
                            <a:pt x="461175" y="47708"/>
                          </a:moveTo>
                          <a:lnTo>
                            <a:pt x="373711" y="71561"/>
                          </a:lnTo>
                          <a:lnTo>
                            <a:pt x="262393" y="111318"/>
                          </a:lnTo>
                          <a:lnTo>
                            <a:pt x="111318" y="151075"/>
                          </a:lnTo>
                          <a:lnTo>
                            <a:pt x="0" y="262393"/>
                          </a:lnTo>
                          <a:lnTo>
                            <a:pt x="87464" y="373711"/>
                          </a:lnTo>
                          <a:lnTo>
                            <a:pt x="206734" y="389614"/>
                          </a:lnTo>
                          <a:lnTo>
                            <a:pt x="405516" y="373711"/>
                          </a:lnTo>
                          <a:lnTo>
                            <a:pt x="508883" y="365760"/>
                          </a:lnTo>
                          <a:lnTo>
                            <a:pt x="612250" y="286247"/>
                          </a:lnTo>
                          <a:lnTo>
                            <a:pt x="763325" y="151075"/>
                          </a:lnTo>
                          <a:lnTo>
                            <a:pt x="715617" y="63610"/>
                          </a:lnTo>
                          <a:lnTo>
                            <a:pt x="636104" y="7951"/>
                          </a:lnTo>
                          <a:lnTo>
                            <a:pt x="524786" y="0"/>
                          </a:lnTo>
                          <a:lnTo>
                            <a:pt x="461175" y="47708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36" name="Group 35"/>
          <p:cNvGrpSpPr>
            <a:grpSpLocks noChangeAspect="1"/>
          </p:cNvGrpSpPr>
          <p:nvPr/>
        </p:nvGrpSpPr>
        <p:grpSpPr>
          <a:xfrm>
            <a:off x="3422050" y="4536452"/>
            <a:ext cx="2880000" cy="1917970"/>
            <a:chOff x="3429000" y="5014626"/>
            <a:chExt cx="2883048" cy="1919996"/>
          </a:xfrm>
        </p:grpSpPr>
        <p:pic>
          <p:nvPicPr>
            <p:cNvPr id="45" name="Grafik 44" descr="Ein Bild, das draußen, Foto, weiß, schwarz enthält.&#10;&#10;Automatisch generierte Beschreibung">
              <a:extLst>
                <a:ext uri="{FF2B5EF4-FFF2-40B4-BE49-F238E27FC236}">
                  <a16:creationId xmlns="" xmlns:a16="http://schemas.microsoft.com/office/drawing/2014/main" id="{6241FBDE-6EAC-E049-9E6C-0A950D8943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32048" y="5014626"/>
              <a:ext cx="2880000" cy="19199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6" name="Gerade Verbindung 45">
              <a:extLst>
                <a:ext uri="{FF2B5EF4-FFF2-40B4-BE49-F238E27FC236}">
                  <a16:creationId xmlns="" xmlns:a16="http://schemas.microsoft.com/office/drawing/2014/main" id="{09B9388A-F3A0-8744-B7AA-BFF0EC1386F6}"/>
                </a:ext>
              </a:extLst>
            </p:cNvPr>
            <p:cNvCxnSpPr/>
            <p:nvPr/>
          </p:nvCxnSpPr>
          <p:spPr>
            <a:xfrm>
              <a:off x="5804208" y="6844247"/>
              <a:ext cx="43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feld 46">
              <a:extLst>
                <a:ext uri="{FF2B5EF4-FFF2-40B4-BE49-F238E27FC236}">
                  <a16:creationId xmlns="" xmlns:a16="http://schemas.microsoft.com/office/drawing/2014/main" id="{53CD7630-0E15-594E-BC70-2F57B4011FCE}"/>
                </a:ext>
              </a:extLst>
            </p:cNvPr>
            <p:cNvSpPr txBox="1"/>
            <p:nvPr/>
          </p:nvSpPr>
          <p:spPr>
            <a:xfrm>
              <a:off x="5839136" y="6688799"/>
              <a:ext cx="3626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48" name="Textfeld 47">
              <a:extLst>
                <a:ext uri="{FF2B5EF4-FFF2-40B4-BE49-F238E27FC236}">
                  <a16:creationId xmlns="" xmlns:a16="http://schemas.microsoft.com/office/drawing/2014/main" id="{46BEB2F0-7C40-4946-A648-253C82A29F74}"/>
                </a:ext>
              </a:extLst>
            </p:cNvPr>
            <p:cNvSpPr txBox="1"/>
            <p:nvPr/>
          </p:nvSpPr>
          <p:spPr>
            <a:xfrm>
              <a:off x="3429000" y="5014626"/>
              <a:ext cx="504000" cy="179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VE821</a:t>
              </a:r>
            </a:p>
          </p:txBody>
        </p:sp>
        <p:sp>
          <p:nvSpPr>
            <p:cNvPr id="83" name="Textfeld 82">
              <a:extLst>
                <a:ext uri="{FF2B5EF4-FFF2-40B4-BE49-F238E27FC236}">
                  <a16:creationId xmlns="" xmlns:a16="http://schemas.microsoft.com/office/drawing/2014/main" id="{D14F5FD9-CFB5-5A46-9ED3-33A1CE9E5E6D}"/>
                </a:ext>
              </a:extLst>
            </p:cNvPr>
            <p:cNvSpPr txBox="1"/>
            <p:nvPr/>
          </p:nvSpPr>
          <p:spPr>
            <a:xfrm>
              <a:off x="5053807" y="5559035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84" name="Textfeld 83">
              <a:extLst>
                <a:ext uri="{FF2B5EF4-FFF2-40B4-BE49-F238E27FC236}">
                  <a16:creationId xmlns="" xmlns:a16="http://schemas.microsoft.com/office/drawing/2014/main" id="{9C2FA0F4-F088-D24B-85B5-2804D8490C48}"/>
                </a:ext>
              </a:extLst>
            </p:cNvPr>
            <p:cNvSpPr txBox="1"/>
            <p:nvPr/>
          </p:nvSpPr>
          <p:spPr>
            <a:xfrm>
              <a:off x="4469369" y="6111736"/>
              <a:ext cx="346937" cy="1848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feld 84">
              <a:extLst>
                <a:ext uri="{FF2B5EF4-FFF2-40B4-BE49-F238E27FC236}">
                  <a16:creationId xmlns="" xmlns:a16="http://schemas.microsoft.com/office/drawing/2014/main" id="{D0BF2893-77C1-214A-BBD3-FCC0F3F9A1B6}"/>
                </a:ext>
              </a:extLst>
            </p:cNvPr>
            <p:cNvSpPr txBox="1"/>
            <p:nvPr/>
          </p:nvSpPr>
          <p:spPr>
            <a:xfrm>
              <a:off x="4820270" y="6210511"/>
              <a:ext cx="346937" cy="1848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feld 85">
              <a:extLst>
                <a:ext uri="{FF2B5EF4-FFF2-40B4-BE49-F238E27FC236}">
                  <a16:creationId xmlns="" xmlns:a16="http://schemas.microsoft.com/office/drawing/2014/main" id="{8C19E72F-03C6-B04C-9CAE-F57128282E1C}"/>
                </a:ext>
              </a:extLst>
            </p:cNvPr>
            <p:cNvSpPr txBox="1"/>
            <p:nvPr/>
          </p:nvSpPr>
          <p:spPr>
            <a:xfrm>
              <a:off x="4761286" y="5062487"/>
              <a:ext cx="346937" cy="1848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Freihandform 1">
              <a:extLst>
                <a:ext uri="{FF2B5EF4-FFF2-40B4-BE49-F238E27FC236}">
                  <a16:creationId xmlns="" xmlns:a16="http://schemas.microsoft.com/office/drawing/2014/main" id="{1481CD66-D5BA-BE4D-B683-637364FFC4BD}"/>
                </a:ext>
              </a:extLst>
            </p:cNvPr>
            <p:cNvSpPr/>
            <p:nvPr/>
          </p:nvSpPr>
          <p:spPr>
            <a:xfrm>
              <a:off x="4912242" y="5295014"/>
              <a:ext cx="588335" cy="673395"/>
            </a:xfrm>
            <a:custGeom>
              <a:avLst/>
              <a:gdLst>
                <a:gd name="connsiteX0" fmla="*/ 28353 w 588335"/>
                <a:gd name="connsiteY0" fmla="*/ 170121 h 673395"/>
                <a:gd name="connsiteX1" fmla="*/ 191386 w 588335"/>
                <a:gd name="connsiteY1" fmla="*/ 56707 h 673395"/>
                <a:gd name="connsiteX2" fmla="*/ 389860 w 588335"/>
                <a:gd name="connsiteY2" fmla="*/ 0 h 673395"/>
                <a:gd name="connsiteX3" fmla="*/ 552893 w 588335"/>
                <a:gd name="connsiteY3" fmla="*/ 63795 h 673395"/>
                <a:gd name="connsiteX4" fmla="*/ 588335 w 588335"/>
                <a:gd name="connsiteY4" fmla="*/ 191386 h 673395"/>
                <a:gd name="connsiteX5" fmla="*/ 559981 w 588335"/>
                <a:gd name="connsiteY5" fmla="*/ 326065 h 673395"/>
                <a:gd name="connsiteX6" fmla="*/ 489098 w 588335"/>
                <a:gd name="connsiteY6" fmla="*/ 439479 h 673395"/>
                <a:gd name="connsiteX7" fmla="*/ 482009 w 588335"/>
                <a:gd name="connsiteY7" fmla="*/ 588335 h 673395"/>
                <a:gd name="connsiteX8" fmla="*/ 460744 w 588335"/>
                <a:gd name="connsiteY8" fmla="*/ 666307 h 673395"/>
                <a:gd name="connsiteX9" fmla="*/ 347330 w 588335"/>
                <a:gd name="connsiteY9" fmla="*/ 673395 h 673395"/>
                <a:gd name="connsiteX10" fmla="*/ 184298 w 588335"/>
                <a:gd name="connsiteY10" fmla="*/ 559981 h 673395"/>
                <a:gd name="connsiteX11" fmla="*/ 21265 w 588335"/>
                <a:gd name="connsiteY11" fmla="*/ 453656 h 673395"/>
                <a:gd name="connsiteX12" fmla="*/ 0 w 588335"/>
                <a:gd name="connsiteY12" fmla="*/ 340242 h 673395"/>
                <a:gd name="connsiteX13" fmla="*/ 28353 w 588335"/>
                <a:gd name="connsiteY13" fmla="*/ 170121 h 6733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588335" h="673395" extrusionOk="0">
                  <a:moveTo>
                    <a:pt x="28353" y="170121"/>
                  </a:moveTo>
                  <a:cubicBezTo>
                    <a:pt x="98958" y="106677"/>
                    <a:pt x="159417" y="87441"/>
                    <a:pt x="191386" y="56707"/>
                  </a:cubicBezTo>
                  <a:cubicBezTo>
                    <a:pt x="265597" y="16894"/>
                    <a:pt x="300195" y="33732"/>
                    <a:pt x="389860" y="0"/>
                  </a:cubicBezTo>
                  <a:cubicBezTo>
                    <a:pt x="471930" y="19912"/>
                    <a:pt x="492924" y="53225"/>
                    <a:pt x="552893" y="63795"/>
                  </a:cubicBezTo>
                  <a:cubicBezTo>
                    <a:pt x="575921" y="113505"/>
                    <a:pt x="570575" y="148539"/>
                    <a:pt x="588335" y="191386"/>
                  </a:cubicBezTo>
                  <a:cubicBezTo>
                    <a:pt x="587368" y="235889"/>
                    <a:pt x="560811" y="288061"/>
                    <a:pt x="559981" y="326065"/>
                  </a:cubicBezTo>
                  <a:cubicBezTo>
                    <a:pt x="531720" y="375206"/>
                    <a:pt x="506805" y="391940"/>
                    <a:pt x="489098" y="439479"/>
                  </a:cubicBezTo>
                  <a:cubicBezTo>
                    <a:pt x="495260" y="500303"/>
                    <a:pt x="472178" y="516964"/>
                    <a:pt x="482009" y="588335"/>
                  </a:cubicBezTo>
                  <a:cubicBezTo>
                    <a:pt x="482999" y="614165"/>
                    <a:pt x="468289" y="638283"/>
                    <a:pt x="460744" y="666307"/>
                  </a:cubicBezTo>
                  <a:cubicBezTo>
                    <a:pt x="434061" y="679940"/>
                    <a:pt x="395022" y="660932"/>
                    <a:pt x="347330" y="673395"/>
                  </a:cubicBezTo>
                  <a:cubicBezTo>
                    <a:pt x="277733" y="627789"/>
                    <a:pt x="245707" y="586728"/>
                    <a:pt x="184298" y="559981"/>
                  </a:cubicBezTo>
                  <a:cubicBezTo>
                    <a:pt x="97976" y="528363"/>
                    <a:pt x="101332" y="497461"/>
                    <a:pt x="21265" y="453656"/>
                  </a:cubicBezTo>
                  <a:cubicBezTo>
                    <a:pt x="4131" y="429646"/>
                    <a:pt x="11566" y="387060"/>
                    <a:pt x="0" y="340242"/>
                  </a:cubicBezTo>
                  <a:cubicBezTo>
                    <a:pt x="3917" y="295507"/>
                    <a:pt x="25197" y="247912"/>
                    <a:pt x="28353" y="170121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28353 w 588335"/>
                        <a:gd name="connsiteY0" fmla="*/ 170121 h 673395"/>
                        <a:gd name="connsiteX1" fmla="*/ 191386 w 588335"/>
                        <a:gd name="connsiteY1" fmla="*/ 56707 h 673395"/>
                        <a:gd name="connsiteX2" fmla="*/ 389860 w 588335"/>
                        <a:gd name="connsiteY2" fmla="*/ 0 h 673395"/>
                        <a:gd name="connsiteX3" fmla="*/ 552893 w 588335"/>
                        <a:gd name="connsiteY3" fmla="*/ 63795 h 673395"/>
                        <a:gd name="connsiteX4" fmla="*/ 588335 w 588335"/>
                        <a:gd name="connsiteY4" fmla="*/ 191386 h 673395"/>
                        <a:gd name="connsiteX5" fmla="*/ 559981 w 588335"/>
                        <a:gd name="connsiteY5" fmla="*/ 326065 h 673395"/>
                        <a:gd name="connsiteX6" fmla="*/ 489098 w 588335"/>
                        <a:gd name="connsiteY6" fmla="*/ 439479 h 673395"/>
                        <a:gd name="connsiteX7" fmla="*/ 482009 w 588335"/>
                        <a:gd name="connsiteY7" fmla="*/ 588335 h 673395"/>
                        <a:gd name="connsiteX8" fmla="*/ 460744 w 588335"/>
                        <a:gd name="connsiteY8" fmla="*/ 666307 h 673395"/>
                        <a:gd name="connsiteX9" fmla="*/ 347330 w 588335"/>
                        <a:gd name="connsiteY9" fmla="*/ 673395 h 673395"/>
                        <a:gd name="connsiteX10" fmla="*/ 184298 w 588335"/>
                        <a:gd name="connsiteY10" fmla="*/ 559981 h 673395"/>
                        <a:gd name="connsiteX11" fmla="*/ 21265 w 588335"/>
                        <a:gd name="connsiteY11" fmla="*/ 453656 h 673395"/>
                        <a:gd name="connsiteX12" fmla="*/ 0 w 588335"/>
                        <a:gd name="connsiteY12" fmla="*/ 340242 h 673395"/>
                        <a:gd name="connsiteX13" fmla="*/ 28353 w 588335"/>
                        <a:gd name="connsiteY13" fmla="*/ 170121 h 67339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</a:cxnLst>
                      <a:rect l="l" t="t" r="r" b="b"/>
                      <a:pathLst>
                        <a:path w="588335" h="673395">
                          <a:moveTo>
                            <a:pt x="28353" y="170121"/>
                          </a:moveTo>
                          <a:lnTo>
                            <a:pt x="191386" y="56707"/>
                          </a:lnTo>
                          <a:lnTo>
                            <a:pt x="389860" y="0"/>
                          </a:lnTo>
                          <a:lnTo>
                            <a:pt x="552893" y="63795"/>
                          </a:lnTo>
                          <a:lnTo>
                            <a:pt x="588335" y="191386"/>
                          </a:lnTo>
                          <a:lnTo>
                            <a:pt x="559981" y="326065"/>
                          </a:lnTo>
                          <a:lnTo>
                            <a:pt x="489098" y="439479"/>
                          </a:lnTo>
                          <a:lnTo>
                            <a:pt x="482009" y="588335"/>
                          </a:lnTo>
                          <a:lnTo>
                            <a:pt x="460744" y="666307"/>
                          </a:lnTo>
                          <a:lnTo>
                            <a:pt x="347330" y="673395"/>
                          </a:lnTo>
                          <a:lnTo>
                            <a:pt x="184298" y="559981"/>
                          </a:lnTo>
                          <a:lnTo>
                            <a:pt x="21265" y="453656"/>
                          </a:lnTo>
                          <a:lnTo>
                            <a:pt x="0" y="340242"/>
                          </a:lnTo>
                          <a:lnTo>
                            <a:pt x="28353" y="170121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21" name="Textfeld 120">
              <a:extLst>
                <a:ext uri="{FF2B5EF4-FFF2-40B4-BE49-F238E27FC236}">
                  <a16:creationId xmlns="" xmlns:a16="http://schemas.microsoft.com/office/drawing/2014/main" id="{145F0B3D-D93F-9944-81A1-C23C036AE46C}"/>
                </a:ext>
              </a:extLst>
            </p:cNvPr>
            <p:cNvSpPr txBox="1"/>
            <p:nvPr/>
          </p:nvSpPr>
          <p:spPr>
            <a:xfrm>
              <a:off x="4005066" y="5986124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feld 122">
              <a:extLst>
                <a:ext uri="{FF2B5EF4-FFF2-40B4-BE49-F238E27FC236}">
                  <a16:creationId xmlns="" xmlns:a16="http://schemas.microsoft.com/office/drawing/2014/main" id="{91E6B773-C90D-2242-92F8-49BC2F9B259A}"/>
                </a:ext>
              </a:extLst>
            </p:cNvPr>
            <p:cNvSpPr txBox="1"/>
            <p:nvPr/>
          </p:nvSpPr>
          <p:spPr>
            <a:xfrm>
              <a:off x="4137526" y="5641887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feld 123">
              <a:extLst>
                <a:ext uri="{FF2B5EF4-FFF2-40B4-BE49-F238E27FC236}">
                  <a16:creationId xmlns="" xmlns:a16="http://schemas.microsoft.com/office/drawing/2014/main" id="{B4C28CFE-3FAE-4944-B2AA-C519E32AD82D}"/>
                </a:ext>
              </a:extLst>
            </p:cNvPr>
            <p:cNvSpPr txBox="1"/>
            <p:nvPr/>
          </p:nvSpPr>
          <p:spPr>
            <a:xfrm>
              <a:off x="3470664" y="6452744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Freihandform 24">
              <a:extLst>
                <a:ext uri="{FF2B5EF4-FFF2-40B4-BE49-F238E27FC236}">
                  <a16:creationId xmlns="" xmlns:a16="http://schemas.microsoft.com/office/drawing/2014/main" id="{A46C2748-F162-E94D-8080-1DAEB425B5EE}"/>
                </a:ext>
              </a:extLst>
            </p:cNvPr>
            <p:cNvSpPr/>
            <p:nvPr/>
          </p:nvSpPr>
          <p:spPr>
            <a:xfrm>
              <a:off x="4643562" y="6098650"/>
              <a:ext cx="532737" cy="739472"/>
            </a:xfrm>
            <a:custGeom>
              <a:avLst/>
              <a:gdLst>
                <a:gd name="connsiteX0" fmla="*/ 47708 w 532737"/>
                <a:gd name="connsiteY0" fmla="*/ 262393 h 739472"/>
                <a:gd name="connsiteX1" fmla="*/ 103367 w 532737"/>
                <a:gd name="connsiteY1" fmla="*/ 182880 h 739472"/>
                <a:gd name="connsiteX2" fmla="*/ 198782 w 532737"/>
                <a:gd name="connsiteY2" fmla="*/ 63611 h 739472"/>
                <a:gd name="connsiteX3" fmla="*/ 238539 w 532737"/>
                <a:gd name="connsiteY3" fmla="*/ 0 h 739472"/>
                <a:gd name="connsiteX4" fmla="*/ 349857 w 532737"/>
                <a:gd name="connsiteY4" fmla="*/ 55660 h 739472"/>
                <a:gd name="connsiteX5" fmla="*/ 421419 w 532737"/>
                <a:gd name="connsiteY5" fmla="*/ 135173 h 739472"/>
                <a:gd name="connsiteX6" fmla="*/ 492981 w 532737"/>
                <a:gd name="connsiteY6" fmla="*/ 214686 h 739472"/>
                <a:gd name="connsiteX7" fmla="*/ 516835 w 532737"/>
                <a:gd name="connsiteY7" fmla="*/ 286247 h 739472"/>
                <a:gd name="connsiteX8" fmla="*/ 532737 w 532737"/>
                <a:gd name="connsiteY8" fmla="*/ 333955 h 739472"/>
                <a:gd name="connsiteX9" fmla="*/ 532737 w 532737"/>
                <a:gd name="connsiteY9" fmla="*/ 492981 h 739472"/>
                <a:gd name="connsiteX10" fmla="*/ 492981 w 532737"/>
                <a:gd name="connsiteY10" fmla="*/ 548640 h 739472"/>
                <a:gd name="connsiteX11" fmla="*/ 429370 w 532737"/>
                <a:gd name="connsiteY11" fmla="*/ 612251 h 739472"/>
                <a:gd name="connsiteX12" fmla="*/ 381662 w 532737"/>
                <a:gd name="connsiteY12" fmla="*/ 667910 h 739472"/>
                <a:gd name="connsiteX13" fmla="*/ 357808 w 532737"/>
                <a:gd name="connsiteY13" fmla="*/ 675861 h 739472"/>
                <a:gd name="connsiteX14" fmla="*/ 238539 w 532737"/>
                <a:gd name="connsiteY14" fmla="*/ 723569 h 739472"/>
                <a:gd name="connsiteX15" fmla="*/ 127221 w 532737"/>
                <a:gd name="connsiteY15" fmla="*/ 739472 h 739472"/>
                <a:gd name="connsiteX16" fmla="*/ 159026 w 532737"/>
                <a:gd name="connsiteY16" fmla="*/ 628153 h 739472"/>
                <a:gd name="connsiteX17" fmla="*/ 246490 w 532737"/>
                <a:gd name="connsiteY17" fmla="*/ 485030 h 739472"/>
                <a:gd name="connsiteX18" fmla="*/ 262393 w 532737"/>
                <a:gd name="connsiteY18" fmla="*/ 477079 h 739472"/>
                <a:gd name="connsiteX19" fmla="*/ 294198 w 532737"/>
                <a:gd name="connsiteY19" fmla="*/ 389614 h 739472"/>
                <a:gd name="connsiteX20" fmla="*/ 302149 w 532737"/>
                <a:gd name="connsiteY20" fmla="*/ 349858 h 739472"/>
                <a:gd name="connsiteX21" fmla="*/ 270344 w 532737"/>
                <a:gd name="connsiteY21" fmla="*/ 294199 h 739472"/>
                <a:gd name="connsiteX22" fmla="*/ 174928 w 532737"/>
                <a:gd name="connsiteY22" fmla="*/ 326004 h 739472"/>
                <a:gd name="connsiteX23" fmla="*/ 87464 w 532737"/>
                <a:gd name="connsiteY23" fmla="*/ 429371 h 739472"/>
                <a:gd name="connsiteX24" fmla="*/ 0 w 532737"/>
                <a:gd name="connsiteY24" fmla="*/ 373712 h 739472"/>
                <a:gd name="connsiteX25" fmla="*/ 47708 w 532737"/>
                <a:gd name="connsiteY25" fmla="*/ 262393 h 7394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532737" h="739472" extrusionOk="0">
                  <a:moveTo>
                    <a:pt x="47708" y="262393"/>
                  </a:moveTo>
                  <a:cubicBezTo>
                    <a:pt x="71801" y="223672"/>
                    <a:pt x="79227" y="219394"/>
                    <a:pt x="103367" y="182880"/>
                  </a:cubicBezTo>
                  <a:cubicBezTo>
                    <a:pt x="120830" y="136795"/>
                    <a:pt x="189383" y="102292"/>
                    <a:pt x="198782" y="63611"/>
                  </a:cubicBezTo>
                  <a:cubicBezTo>
                    <a:pt x="208682" y="35684"/>
                    <a:pt x="236601" y="16528"/>
                    <a:pt x="238539" y="0"/>
                  </a:cubicBezTo>
                  <a:cubicBezTo>
                    <a:pt x="279227" y="12876"/>
                    <a:pt x="301617" y="42832"/>
                    <a:pt x="349857" y="55660"/>
                  </a:cubicBezTo>
                  <a:cubicBezTo>
                    <a:pt x="381953" y="81343"/>
                    <a:pt x="400923" y="120263"/>
                    <a:pt x="421419" y="135173"/>
                  </a:cubicBezTo>
                  <a:cubicBezTo>
                    <a:pt x="447969" y="159276"/>
                    <a:pt x="477741" y="198608"/>
                    <a:pt x="492981" y="214686"/>
                  </a:cubicBezTo>
                  <a:cubicBezTo>
                    <a:pt x="518297" y="280906"/>
                    <a:pt x="509807" y="254514"/>
                    <a:pt x="516835" y="286247"/>
                  </a:cubicBezTo>
                  <a:cubicBezTo>
                    <a:pt x="523850" y="294911"/>
                    <a:pt x="527983" y="320414"/>
                    <a:pt x="532737" y="333955"/>
                  </a:cubicBezTo>
                  <a:cubicBezTo>
                    <a:pt x="548731" y="387793"/>
                    <a:pt x="528442" y="449410"/>
                    <a:pt x="532737" y="492981"/>
                  </a:cubicBezTo>
                  <a:cubicBezTo>
                    <a:pt x="523083" y="520514"/>
                    <a:pt x="502944" y="526346"/>
                    <a:pt x="492981" y="548640"/>
                  </a:cubicBezTo>
                  <a:cubicBezTo>
                    <a:pt x="474080" y="570138"/>
                    <a:pt x="441457" y="593547"/>
                    <a:pt x="429370" y="612251"/>
                  </a:cubicBezTo>
                  <a:cubicBezTo>
                    <a:pt x="412605" y="629046"/>
                    <a:pt x="400298" y="646644"/>
                    <a:pt x="381662" y="667910"/>
                  </a:cubicBezTo>
                  <a:cubicBezTo>
                    <a:pt x="375397" y="673478"/>
                    <a:pt x="357808" y="675862"/>
                    <a:pt x="357808" y="675861"/>
                  </a:cubicBezTo>
                  <a:cubicBezTo>
                    <a:pt x="303046" y="698615"/>
                    <a:pt x="291602" y="699244"/>
                    <a:pt x="238539" y="723569"/>
                  </a:cubicBezTo>
                  <a:cubicBezTo>
                    <a:pt x="215674" y="730148"/>
                    <a:pt x="177587" y="723527"/>
                    <a:pt x="127221" y="739472"/>
                  </a:cubicBezTo>
                  <a:cubicBezTo>
                    <a:pt x="133011" y="709785"/>
                    <a:pt x="153323" y="665685"/>
                    <a:pt x="159026" y="628153"/>
                  </a:cubicBezTo>
                  <a:cubicBezTo>
                    <a:pt x="199884" y="559417"/>
                    <a:pt x="225049" y="520933"/>
                    <a:pt x="246490" y="485030"/>
                  </a:cubicBezTo>
                  <a:cubicBezTo>
                    <a:pt x="252642" y="480651"/>
                    <a:pt x="258535" y="479545"/>
                    <a:pt x="262393" y="477079"/>
                  </a:cubicBezTo>
                  <a:cubicBezTo>
                    <a:pt x="300465" y="407305"/>
                    <a:pt x="294528" y="438284"/>
                    <a:pt x="294198" y="389614"/>
                  </a:cubicBezTo>
                  <a:cubicBezTo>
                    <a:pt x="292993" y="372665"/>
                    <a:pt x="300425" y="363637"/>
                    <a:pt x="302149" y="349858"/>
                  </a:cubicBezTo>
                  <a:cubicBezTo>
                    <a:pt x="284385" y="330563"/>
                    <a:pt x="288659" y="319810"/>
                    <a:pt x="270344" y="294199"/>
                  </a:cubicBezTo>
                  <a:cubicBezTo>
                    <a:pt x="231979" y="309895"/>
                    <a:pt x="196486" y="312120"/>
                    <a:pt x="174928" y="326004"/>
                  </a:cubicBezTo>
                  <a:cubicBezTo>
                    <a:pt x="158291" y="365209"/>
                    <a:pt x="96182" y="399855"/>
                    <a:pt x="87464" y="429371"/>
                  </a:cubicBezTo>
                  <a:cubicBezTo>
                    <a:pt x="52184" y="418604"/>
                    <a:pt x="25755" y="375835"/>
                    <a:pt x="0" y="373712"/>
                  </a:cubicBezTo>
                  <a:cubicBezTo>
                    <a:pt x="6229" y="341585"/>
                    <a:pt x="47144" y="291551"/>
                    <a:pt x="47708" y="262393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47708 w 532737"/>
                        <a:gd name="connsiteY0" fmla="*/ 262393 h 739472"/>
                        <a:gd name="connsiteX1" fmla="*/ 103367 w 532737"/>
                        <a:gd name="connsiteY1" fmla="*/ 182880 h 739472"/>
                        <a:gd name="connsiteX2" fmla="*/ 198782 w 532737"/>
                        <a:gd name="connsiteY2" fmla="*/ 63611 h 739472"/>
                        <a:gd name="connsiteX3" fmla="*/ 238539 w 532737"/>
                        <a:gd name="connsiteY3" fmla="*/ 0 h 739472"/>
                        <a:gd name="connsiteX4" fmla="*/ 349857 w 532737"/>
                        <a:gd name="connsiteY4" fmla="*/ 55660 h 739472"/>
                        <a:gd name="connsiteX5" fmla="*/ 421419 w 532737"/>
                        <a:gd name="connsiteY5" fmla="*/ 135173 h 739472"/>
                        <a:gd name="connsiteX6" fmla="*/ 492981 w 532737"/>
                        <a:gd name="connsiteY6" fmla="*/ 214686 h 739472"/>
                        <a:gd name="connsiteX7" fmla="*/ 516835 w 532737"/>
                        <a:gd name="connsiteY7" fmla="*/ 286247 h 739472"/>
                        <a:gd name="connsiteX8" fmla="*/ 532737 w 532737"/>
                        <a:gd name="connsiteY8" fmla="*/ 333955 h 739472"/>
                        <a:gd name="connsiteX9" fmla="*/ 532737 w 532737"/>
                        <a:gd name="connsiteY9" fmla="*/ 492981 h 739472"/>
                        <a:gd name="connsiteX10" fmla="*/ 492981 w 532737"/>
                        <a:gd name="connsiteY10" fmla="*/ 548640 h 739472"/>
                        <a:gd name="connsiteX11" fmla="*/ 429370 w 532737"/>
                        <a:gd name="connsiteY11" fmla="*/ 612251 h 739472"/>
                        <a:gd name="connsiteX12" fmla="*/ 381662 w 532737"/>
                        <a:gd name="connsiteY12" fmla="*/ 667910 h 739472"/>
                        <a:gd name="connsiteX13" fmla="*/ 357808 w 532737"/>
                        <a:gd name="connsiteY13" fmla="*/ 675861 h 739472"/>
                        <a:gd name="connsiteX14" fmla="*/ 238539 w 532737"/>
                        <a:gd name="connsiteY14" fmla="*/ 723569 h 739472"/>
                        <a:gd name="connsiteX15" fmla="*/ 127221 w 532737"/>
                        <a:gd name="connsiteY15" fmla="*/ 739472 h 739472"/>
                        <a:gd name="connsiteX16" fmla="*/ 159026 w 532737"/>
                        <a:gd name="connsiteY16" fmla="*/ 628153 h 739472"/>
                        <a:gd name="connsiteX17" fmla="*/ 246490 w 532737"/>
                        <a:gd name="connsiteY17" fmla="*/ 485030 h 739472"/>
                        <a:gd name="connsiteX18" fmla="*/ 262393 w 532737"/>
                        <a:gd name="connsiteY18" fmla="*/ 477079 h 739472"/>
                        <a:gd name="connsiteX19" fmla="*/ 294198 w 532737"/>
                        <a:gd name="connsiteY19" fmla="*/ 389614 h 739472"/>
                        <a:gd name="connsiteX20" fmla="*/ 302149 w 532737"/>
                        <a:gd name="connsiteY20" fmla="*/ 349858 h 739472"/>
                        <a:gd name="connsiteX21" fmla="*/ 270344 w 532737"/>
                        <a:gd name="connsiteY21" fmla="*/ 294199 h 739472"/>
                        <a:gd name="connsiteX22" fmla="*/ 174928 w 532737"/>
                        <a:gd name="connsiteY22" fmla="*/ 326004 h 739472"/>
                        <a:gd name="connsiteX23" fmla="*/ 87464 w 532737"/>
                        <a:gd name="connsiteY23" fmla="*/ 429371 h 739472"/>
                        <a:gd name="connsiteX24" fmla="*/ 0 w 532737"/>
                        <a:gd name="connsiteY24" fmla="*/ 373712 h 739472"/>
                        <a:gd name="connsiteX25" fmla="*/ 47708 w 532737"/>
                        <a:gd name="connsiteY25" fmla="*/ 262393 h 739472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</a:cxnLst>
                      <a:rect l="l" t="t" r="r" b="b"/>
                      <a:pathLst>
                        <a:path w="532737" h="739472">
                          <a:moveTo>
                            <a:pt x="47708" y="262393"/>
                          </a:moveTo>
                          <a:lnTo>
                            <a:pt x="103367" y="182880"/>
                          </a:lnTo>
                          <a:lnTo>
                            <a:pt x="198782" y="63611"/>
                          </a:lnTo>
                          <a:lnTo>
                            <a:pt x="238539" y="0"/>
                          </a:lnTo>
                          <a:lnTo>
                            <a:pt x="349857" y="55660"/>
                          </a:lnTo>
                          <a:lnTo>
                            <a:pt x="421419" y="135173"/>
                          </a:lnTo>
                          <a:lnTo>
                            <a:pt x="492981" y="214686"/>
                          </a:lnTo>
                          <a:cubicBezTo>
                            <a:pt x="517766" y="280778"/>
                            <a:pt x="516835" y="255651"/>
                            <a:pt x="516835" y="286247"/>
                          </a:cubicBezTo>
                          <a:lnTo>
                            <a:pt x="532737" y="333955"/>
                          </a:lnTo>
                          <a:lnTo>
                            <a:pt x="532737" y="492981"/>
                          </a:lnTo>
                          <a:lnTo>
                            <a:pt x="492981" y="548640"/>
                          </a:lnTo>
                          <a:lnTo>
                            <a:pt x="429370" y="612251"/>
                          </a:lnTo>
                          <a:cubicBezTo>
                            <a:pt x="413467" y="630804"/>
                            <a:pt x="399926" y="651676"/>
                            <a:pt x="381662" y="667910"/>
                          </a:cubicBezTo>
                          <a:cubicBezTo>
                            <a:pt x="375398" y="673478"/>
                            <a:pt x="357808" y="675861"/>
                            <a:pt x="357808" y="675861"/>
                          </a:cubicBezTo>
                          <a:lnTo>
                            <a:pt x="238539" y="723569"/>
                          </a:lnTo>
                          <a:lnTo>
                            <a:pt x="127221" y="739472"/>
                          </a:lnTo>
                          <a:lnTo>
                            <a:pt x="159026" y="628153"/>
                          </a:lnTo>
                          <a:lnTo>
                            <a:pt x="246490" y="485030"/>
                          </a:lnTo>
                          <a:lnTo>
                            <a:pt x="262393" y="477079"/>
                          </a:lnTo>
                          <a:cubicBezTo>
                            <a:pt x="297754" y="406356"/>
                            <a:pt x="294198" y="437174"/>
                            <a:pt x="294198" y="389614"/>
                          </a:cubicBezTo>
                          <a:lnTo>
                            <a:pt x="302149" y="349858"/>
                          </a:lnTo>
                          <a:lnTo>
                            <a:pt x="270344" y="294199"/>
                          </a:lnTo>
                          <a:lnTo>
                            <a:pt x="174928" y="326004"/>
                          </a:lnTo>
                          <a:lnTo>
                            <a:pt x="87464" y="429371"/>
                          </a:lnTo>
                          <a:lnTo>
                            <a:pt x="0" y="373712"/>
                          </a:lnTo>
                          <a:lnTo>
                            <a:pt x="47708" y="262393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0" name="Freihandform 29">
              <a:extLst>
                <a:ext uri="{FF2B5EF4-FFF2-40B4-BE49-F238E27FC236}">
                  <a16:creationId xmlns="" xmlns:a16="http://schemas.microsoft.com/office/drawing/2014/main" id="{496F2764-AE40-AF45-89EB-90501E0B3F48}"/>
                </a:ext>
              </a:extLst>
            </p:cNvPr>
            <p:cNvSpPr/>
            <p:nvPr/>
          </p:nvSpPr>
          <p:spPr>
            <a:xfrm>
              <a:off x="4166483" y="5836257"/>
              <a:ext cx="691764" cy="1025719"/>
            </a:xfrm>
            <a:custGeom>
              <a:avLst/>
              <a:gdLst>
                <a:gd name="connsiteX0" fmla="*/ 326004 w 691764"/>
                <a:gd name="connsiteY0" fmla="*/ 628153 h 1025719"/>
                <a:gd name="connsiteX1" fmla="*/ 389614 w 691764"/>
                <a:gd name="connsiteY1" fmla="*/ 580446 h 1025719"/>
                <a:gd name="connsiteX2" fmla="*/ 540689 w 691764"/>
                <a:gd name="connsiteY2" fmla="*/ 453225 h 1025719"/>
                <a:gd name="connsiteX3" fmla="*/ 636105 w 691764"/>
                <a:gd name="connsiteY3" fmla="*/ 333955 h 1025719"/>
                <a:gd name="connsiteX4" fmla="*/ 683813 w 691764"/>
                <a:gd name="connsiteY4" fmla="*/ 262393 h 1025719"/>
                <a:gd name="connsiteX5" fmla="*/ 691764 w 691764"/>
                <a:gd name="connsiteY5" fmla="*/ 135173 h 1025719"/>
                <a:gd name="connsiteX6" fmla="*/ 636105 w 691764"/>
                <a:gd name="connsiteY6" fmla="*/ 0 h 1025719"/>
                <a:gd name="connsiteX7" fmla="*/ 564543 w 691764"/>
                <a:gd name="connsiteY7" fmla="*/ 39757 h 1025719"/>
                <a:gd name="connsiteX8" fmla="*/ 453225 w 691764"/>
                <a:gd name="connsiteY8" fmla="*/ 182880 h 1025719"/>
                <a:gd name="connsiteX9" fmla="*/ 333955 w 691764"/>
                <a:gd name="connsiteY9" fmla="*/ 373712 h 1025719"/>
                <a:gd name="connsiteX10" fmla="*/ 270345 w 691764"/>
                <a:gd name="connsiteY10" fmla="*/ 477079 h 1025719"/>
                <a:gd name="connsiteX11" fmla="*/ 246491 w 691764"/>
                <a:gd name="connsiteY11" fmla="*/ 485030 h 1025719"/>
                <a:gd name="connsiteX12" fmla="*/ 143124 w 691764"/>
                <a:gd name="connsiteY12" fmla="*/ 413468 h 1025719"/>
                <a:gd name="connsiteX13" fmla="*/ 0 w 691764"/>
                <a:gd name="connsiteY13" fmla="*/ 429371 h 1025719"/>
                <a:gd name="connsiteX14" fmla="*/ 55660 w 691764"/>
                <a:gd name="connsiteY14" fmla="*/ 508884 h 1025719"/>
                <a:gd name="connsiteX15" fmla="*/ 166978 w 691764"/>
                <a:gd name="connsiteY15" fmla="*/ 588397 h 1025719"/>
                <a:gd name="connsiteX16" fmla="*/ 79514 w 691764"/>
                <a:gd name="connsiteY16" fmla="*/ 620202 h 1025719"/>
                <a:gd name="connsiteX17" fmla="*/ 103367 w 691764"/>
                <a:gd name="connsiteY17" fmla="*/ 699715 h 1025719"/>
                <a:gd name="connsiteX18" fmla="*/ 166978 w 691764"/>
                <a:gd name="connsiteY18" fmla="*/ 826936 h 1025719"/>
                <a:gd name="connsiteX19" fmla="*/ 135173 w 691764"/>
                <a:gd name="connsiteY19" fmla="*/ 954157 h 1025719"/>
                <a:gd name="connsiteX20" fmla="*/ 222637 w 691764"/>
                <a:gd name="connsiteY20" fmla="*/ 1025719 h 1025719"/>
                <a:gd name="connsiteX21" fmla="*/ 310101 w 691764"/>
                <a:gd name="connsiteY21" fmla="*/ 962108 h 1025719"/>
                <a:gd name="connsiteX22" fmla="*/ 357809 w 691764"/>
                <a:gd name="connsiteY22" fmla="*/ 858741 h 1025719"/>
                <a:gd name="connsiteX23" fmla="*/ 310101 w 691764"/>
                <a:gd name="connsiteY23" fmla="*/ 739472 h 1025719"/>
                <a:gd name="connsiteX24" fmla="*/ 326004 w 691764"/>
                <a:gd name="connsiteY24" fmla="*/ 628153 h 10257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691764" h="1025719" extrusionOk="0">
                  <a:moveTo>
                    <a:pt x="326004" y="628153"/>
                  </a:moveTo>
                  <a:cubicBezTo>
                    <a:pt x="343875" y="614145"/>
                    <a:pt x="378844" y="595642"/>
                    <a:pt x="389614" y="580446"/>
                  </a:cubicBezTo>
                  <a:cubicBezTo>
                    <a:pt x="429421" y="537943"/>
                    <a:pt x="509248" y="479849"/>
                    <a:pt x="540689" y="453225"/>
                  </a:cubicBezTo>
                  <a:cubicBezTo>
                    <a:pt x="566134" y="400476"/>
                    <a:pt x="603647" y="389084"/>
                    <a:pt x="636105" y="333955"/>
                  </a:cubicBezTo>
                  <a:cubicBezTo>
                    <a:pt x="677361" y="267208"/>
                    <a:pt x="667219" y="292934"/>
                    <a:pt x="683813" y="262393"/>
                  </a:cubicBezTo>
                  <a:cubicBezTo>
                    <a:pt x="685208" y="227278"/>
                    <a:pt x="695894" y="177208"/>
                    <a:pt x="691764" y="135173"/>
                  </a:cubicBezTo>
                  <a:cubicBezTo>
                    <a:pt x="673542" y="110467"/>
                    <a:pt x="649578" y="32429"/>
                    <a:pt x="636105" y="0"/>
                  </a:cubicBezTo>
                  <a:cubicBezTo>
                    <a:pt x="622841" y="11084"/>
                    <a:pt x="583050" y="28003"/>
                    <a:pt x="564543" y="39757"/>
                  </a:cubicBezTo>
                  <a:cubicBezTo>
                    <a:pt x="532149" y="89367"/>
                    <a:pt x="486751" y="129904"/>
                    <a:pt x="453225" y="182880"/>
                  </a:cubicBezTo>
                  <a:cubicBezTo>
                    <a:pt x="439471" y="238393"/>
                    <a:pt x="375670" y="269057"/>
                    <a:pt x="333955" y="373712"/>
                  </a:cubicBezTo>
                  <a:cubicBezTo>
                    <a:pt x="308613" y="420989"/>
                    <a:pt x="276552" y="440775"/>
                    <a:pt x="270345" y="477079"/>
                  </a:cubicBezTo>
                  <a:cubicBezTo>
                    <a:pt x="265985" y="480318"/>
                    <a:pt x="254108" y="480219"/>
                    <a:pt x="246491" y="485030"/>
                  </a:cubicBezTo>
                  <a:cubicBezTo>
                    <a:pt x="215864" y="479226"/>
                    <a:pt x="174514" y="431009"/>
                    <a:pt x="143124" y="413468"/>
                  </a:cubicBezTo>
                  <a:cubicBezTo>
                    <a:pt x="94592" y="433498"/>
                    <a:pt x="67128" y="409260"/>
                    <a:pt x="0" y="429371"/>
                  </a:cubicBezTo>
                  <a:cubicBezTo>
                    <a:pt x="26672" y="449490"/>
                    <a:pt x="34756" y="482578"/>
                    <a:pt x="55660" y="508884"/>
                  </a:cubicBezTo>
                  <a:cubicBezTo>
                    <a:pt x="85042" y="523342"/>
                    <a:pt x="114515" y="551536"/>
                    <a:pt x="166978" y="588397"/>
                  </a:cubicBezTo>
                  <a:cubicBezTo>
                    <a:pt x="148578" y="601383"/>
                    <a:pt x="106412" y="609493"/>
                    <a:pt x="79514" y="620202"/>
                  </a:cubicBezTo>
                  <a:cubicBezTo>
                    <a:pt x="89526" y="638770"/>
                    <a:pt x="89265" y="678229"/>
                    <a:pt x="103367" y="699715"/>
                  </a:cubicBezTo>
                  <a:cubicBezTo>
                    <a:pt x="123837" y="738578"/>
                    <a:pt x="139737" y="808106"/>
                    <a:pt x="166978" y="826936"/>
                  </a:cubicBezTo>
                  <a:cubicBezTo>
                    <a:pt x="158086" y="864449"/>
                    <a:pt x="142627" y="908121"/>
                    <a:pt x="135173" y="954157"/>
                  </a:cubicBezTo>
                  <a:cubicBezTo>
                    <a:pt x="171393" y="971681"/>
                    <a:pt x="192144" y="1006548"/>
                    <a:pt x="222637" y="1025719"/>
                  </a:cubicBezTo>
                  <a:cubicBezTo>
                    <a:pt x="244091" y="997967"/>
                    <a:pt x="294430" y="980638"/>
                    <a:pt x="310101" y="962108"/>
                  </a:cubicBezTo>
                  <a:cubicBezTo>
                    <a:pt x="323937" y="912986"/>
                    <a:pt x="351611" y="892120"/>
                    <a:pt x="357809" y="858741"/>
                  </a:cubicBezTo>
                  <a:cubicBezTo>
                    <a:pt x="335618" y="822520"/>
                    <a:pt x="342907" y="793763"/>
                    <a:pt x="310101" y="739472"/>
                  </a:cubicBezTo>
                  <a:cubicBezTo>
                    <a:pt x="303375" y="695821"/>
                    <a:pt x="323544" y="666846"/>
                    <a:pt x="326004" y="628153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326004 w 691764"/>
                        <a:gd name="connsiteY0" fmla="*/ 628153 h 1025719"/>
                        <a:gd name="connsiteX1" fmla="*/ 389614 w 691764"/>
                        <a:gd name="connsiteY1" fmla="*/ 580446 h 1025719"/>
                        <a:gd name="connsiteX2" fmla="*/ 540689 w 691764"/>
                        <a:gd name="connsiteY2" fmla="*/ 453225 h 1025719"/>
                        <a:gd name="connsiteX3" fmla="*/ 636105 w 691764"/>
                        <a:gd name="connsiteY3" fmla="*/ 333955 h 1025719"/>
                        <a:gd name="connsiteX4" fmla="*/ 683813 w 691764"/>
                        <a:gd name="connsiteY4" fmla="*/ 262393 h 1025719"/>
                        <a:gd name="connsiteX5" fmla="*/ 691764 w 691764"/>
                        <a:gd name="connsiteY5" fmla="*/ 135173 h 1025719"/>
                        <a:gd name="connsiteX6" fmla="*/ 636105 w 691764"/>
                        <a:gd name="connsiteY6" fmla="*/ 0 h 1025719"/>
                        <a:gd name="connsiteX7" fmla="*/ 564543 w 691764"/>
                        <a:gd name="connsiteY7" fmla="*/ 39757 h 1025719"/>
                        <a:gd name="connsiteX8" fmla="*/ 453225 w 691764"/>
                        <a:gd name="connsiteY8" fmla="*/ 182880 h 1025719"/>
                        <a:gd name="connsiteX9" fmla="*/ 333955 w 691764"/>
                        <a:gd name="connsiteY9" fmla="*/ 373712 h 1025719"/>
                        <a:gd name="connsiteX10" fmla="*/ 270345 w 691764"/>
                        <a:gd name="connsiteY10" fmla="*/ 477079 h 1025719"/>
                        <a:gd name="connsiteX11" fmla="*/ 246491 w 691764"/>
                        <a:gd name="connsiteY11" fmla="*/ 485030 h 1025719"/>
                        <a:gd name="connsiteX12" fmla="*/ 143124 w 691764"/>
                        <a:gd name="connsiteY12" fmla="*/ 413468 h 1025719"/>
                        <a:gd name="connsiteX13" fmla="*/ 0 w 691764"/>
                        <a:gd name="connsiteY13" fmla="*/ 429371 h 1025719"/>
                        <a:gd name="connsiteX14" fmla="*/ 55660 w 691764"/>
                        <a:gd name="connsiteY14" fmla="*/ 508884 h 1025719"/>
                        <a:gd name="connsiteX15" fmla="*/ 166978 w 691764"/>
                        <a:gd name="connsiteY15" fmla="*/ 588397 h 1025719"/>
                        <a:gd name="connsiteX16" fmla="*/ 79514 w 691764"/>
                        <a:gd name="connsiteY16" fmla="*/ 620202 h 1025719"/>
                        <a:gd name="connsiteX17" fmla="*/ 103367 w 691764"/>
                        <a:gd name="connsiteY17" fmla="*/ 699715 h 1025719"/>
                        <a:gd name="connsiteX18" fmla="*/ 166978 w 691764"/>
                        <a:gd name="connsiteY18" fmla="*/ 826936 h 1025719"/>
                        <a:gd name="connsiteX19" fmla="*/ 135173 w 691764"/>
                        <a:gd name="connsiteY19" fmla="*/ 954157 h 1025719"/>
                        <a:gd name="connsiteX20" fmla="*/ 222637 w 691764"/>
                        <a:gd name="connsiteY20" fmla="*/ 1025719 h 1025719"/>
                        <a:gd name="connsiteX21" fmla="*/ 310101 w 691764"/>
                        <a:gd name="connsiteY21" fmla="*/ 962108 h 1025719"/>
                        <a:gd name="connsiteX22" fmla="*/ 357809 w 691764"/>
                        <a:gd name="connsiteY22" fmla="*/ 858741 h 1025719"/>
                        <a:gd name="connsiteX23" fmla="*/ 310101 w 691764"/>
                        <a:gd name="connsiteY23" fmla="*/ 739472 h 1025719"/>
                        <a:gd name="connsiteX24" fmla="*/ 326004 w 691764"/>
                        <a:gd name="connsiteY24" fmla="*/ 628153 h 1025719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</a:cxnLst>
                      <a:rect l="l" t="t" r="r" b="b"/>
                      <a:pathLst>
                        <a:path w="691764" h="1025719">
                          <a:moveTo>
                            <a:pt x="326004" y="628153"/>
                          </a:moveTo>
                          <a:lnTo>
                            <a:pt x="389614" y="580446"/>
                          </a:lnTo>
                          <a:lnTo>
                            <a:pt x="540689" y="453225"/>
                          </a:lnTo>
                          <a:lnTo>
                            <a:pt x="636105" y="333955"/>
                          </a:lnTo>
                          <a:cubicBezTo>
                            <a:pt x="679306" y="273473"/>
                            <a:pt x="665664" y="298688"/>
                            <a:pt x="683813" y="262393"/>
                          </a:cubicBezTo>
                          <a:lnTo>
                            <a:pt x="691764" y="135173"/>
                          </a:lnTo>
                          <a:lnTo>
                            <a:pt x="636105" y="0"/>
                          </a:lnTo>
                          <a:lnTo>
                            <a:pt x="564543" y="39757"/>
                          </a:lnTo>
                          <a:lnTo>
                            <a:pt x="453225" y="182880"/>
                          </a:lnTo>
                          <a:lnTo>
                            <a:pt x="333955" y="373712"/>
                          </a:lnTo>
                          <a:lnTo>
                            <a:pt x="270345" y="477079"/>
                          </a:lnTo>
                          <a:lnTo>
                            <a:pt x="246491" y="485030"/>
                          </a:lnTo>
                          <a:lnTo>
                            <a:pt x="143124" y="413468"/>
                          </a:lnTo>
                          <a:lnTo>
                            <a:pt x="0" y="429371"/>
                          </a:lnTo>
                          <a:lnTo>
                            <a:pt x="55660" y="508884"/>
                          </a:lnTo>
                          <a:lnTo>
                            <a:pt x="166978" y="588397"/>
                          </a:lnTo>
                          <a:lnTo>
                            <a:pt x="79514" y="620202"/>
                          </a:lnTo>
                          <a:lnTo>
                            <a:pt x="103367" y="699715"/>
                          </a:lnTo>
                          <a:lnTo>
                            <a:pt x="166978" y="826936"/>
                          </a:lnTo>
                          <a:lnTo>
                            <a:pt x="135173" y="954157"/>
                          </a:lnTo>
                          <a:lnTo>
                            <a:pt x="222637" y="1025719"/>
                          </a:lnTo>
                          <a:lnTo>
                            <a:pt x="310101" y="962108"/>
                          </a:lnTo>
                          <a:lnTo>
                            <a:pt x="357809" y="858741"/>
                          </a:lnTo>
                          <a:lnTo>
                            <a:pt x="310101" y="739472"/>
                          </a:lnTo>
                          <a:lnTo>
                            <a:pt x="326004" y="628153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40" name="Group 39"/>
          <p:cNvGrpSpPr>
            <a:grpSpLocks noChangeAspect="1"/>
          </p:cNvGrpSpPr>
          <p:nvPr/>
        </p:nvGrpSpPr>
        <p:grpSpPr>
          <a:xfrm>
            <a:off x="439656" y="2527805"/>
            <a:ext cx="2880000" cy="1927211"/>
            <a:chOff x="439656" y="2795457"/>
            <a:chExt cx="2880001" cy="1927214"/>
          </a:xfrm>
        </p:grpSpPr>
        <p:pic>
          <p:nvPicPr>
            <p:cNvPr id="21" name="Grafik 20" descr="Ein Bild, das draußen, Foto, Gras, schwarz enthält.&#10;&#10;Automatisch generierte Beschreibung">
              <a:extLst>
                <a:ext uri="{FF2B5EF4-FFF2-40B4-BE49-F238E27FC236}">
                  <a16:creationId xmlns="" xmlns:a16="http://schemas.microsoft.com/office/drawing/2014/main" id="{2B09E518-5E78-7D40-AF6B-6689620E51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9657" y="2802673"/>
              <a:ext cx="2880000" cy="191999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2" name="Gerade Verbindung 21">
              <a:extLst>
                <a:ext uri="{FF2B5EF4-FFF2-40B4-BE49-F238E27FC236}">
                  <a16:creationId xmlns="" xmlns:a16="http://schemas.microsoft.com/office/drawing/2014/main" id="{214955CB-2E49-2D4F-8D07-7C1C9A381F10}"/>
                </a:ext>
              </a:extLst>
            </p:cNvPr>
            <p:cNvCxnSpPr/>
            <p:nvPr/>
          </p:nvCxnSpPr>
          <p:spPr>
            <a:xfrm>
              <a:off x="2819172" y="4618982"/>
              <a:ext cx="43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feld 22">
              <a:extLst>
                <a:ext uri="{FF2B5EF4-FFF2-40B4-BE49-F238E27FC236}">
                  <a16:creationId xmlns="" xmlns:a16="http://schemas.microsoft.com/office/drawing/2014/main" id="{9BB8ED39-5A8A-AB40-932E-9A82B7BC0EF3}"/>
                </a:ext>
              </a:extLst>
            </p:cNvPr>
            <p:cNvSpPr txBox="1"/>
            <p:nvPr/>
          </p:nvSpPr>
          <p:spPr>
            <a:xfrm>
              <a:off x="2854100" y="4463534"/>
              <a:ext cx="3626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24" name="Textfeld 23">
              <a:extLst>
                <a:ext uri="{FF2B5EF4-FFF2-40B4-BE49-F238E27FC236}">
                  <a16:creationId xmlns="" xmlns:a16="http://schemas.microsoft.com/office/drawing/2014/main" id="{865A4C91-DFAB-C944-BDF9-2E7A4F754C40}"/>
                </a:ext>
              </a:extLst>
            </p:cNvPr>
            <p:cNvSpPr txBox="1"/>
            <p:nvPr/>
          </p:nvSpPr>
          <p:spPr>
            <a:xfrm>
              <a:off x="439656" y="2795457"/>
              <a:ext cx="504000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AUY922</a:t>
              </a:r>
            </a:p>
          </p:txBody>
        </p:sp>
        <p:sp>
          <p:nvSpPr>
            <p:cNvPr id="69" name="Textfeld 68">
              <a:extLst>
                <a:ext uri="{FF2B5EF4-FFF2-40B4-BE49-F238E27FC236}">
                  <a16:creationId xmlns="" xmlns:a16="http://schemas.microsoft.com/office/drawing/2014/main" id="{3D6495B0-E7EB-8A4B-BE6C-C31CDC6ABE7B}"/>
                </a:ext>
              </a:extLst>
            </p:cNvPr>
            <p:cNvSpPr txBox="1"/>
            <p:nvPr/>
          </p:nvSpPr>
          <p:spPr>
            <a:xfrm>
              <a:off x="2038920" y="4191000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feld 69">
              <a:extLst>
                <a:ext uri="{FF2B5EF4-FFF2-40B4-BE49-F238E27FC236}">
                  <a16:creationId xmlns="" xmlns:a16="http://schemas.microsoft.com/office/drawing/2014/main" id="{6741B595-C420-E448-8EEB-FDD07C3E19CB}"/>
                </a:ext>
              </a:extLst>
            </p:cNvPr>
            <p:cNvSpPr txBox="1"/>
            <p:nvPr/>
          </p:nvSpPr>
          <p:spPr>
            <a:xfrm>
              <a:off x="1092180" y="4481798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feld 70">
              <a:extLst>
                <a:ext uri="{FF2B5EF4-FFF2-40B4-BE49-F238E27FC236}">
                  <a16:creationId xmlns="" xmlns:a16="http://schemas.microsoft.com/office/drawing/2014/main" id="{21DDDC5B-9186-A945-8CEB-4B16EE433E70}"/>
                </a:ext>
              </a:extLst>
            </p:cNvPr>
            <p:cNvSpPr txBox="1"/>
            <p:nvPr/>
          </p:nvSpPr>
          <p:spPr>
            <a:xfrm>
              <a:off x="2436396" y="3397303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feld 73">
              <a:extLst>
                <a:ext uri="{FF2B5EF4-FFF2-40B4-BE49-F238E27FC236}">
                  <a16:creationId xmlns="" xmlns:a16="http://schemas.microsoft.com/office/drawing/2014/main" id="{9BD1E944-926A-6C43-9907-C057C733BA6D}"/>
                </a:ext>
              </a:extLst>
            </p:cNvPr>
            <p:cNvSpPr txBox="1"/>
            <p:nvPr/>
          </p:nvSpPr>
          <p:spPr>
            <a:xfrm>
              <a:off x="1159085" y="3539413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75" name="Textfeld 74">
              <a:extLst>
                <a:ext uri="{FF2B5EF4-FFF2-40B4-BE49-F238E27FC236}">
                  <a16:creationId xmlns="" xmlns:a16="http://schemas.microsoft.com/office/drawing/2014/main" id="{824180CD-5DBB-5848-A21B-D9AF92680B42}"/>
                </a:ext>
              </a:extLst>
            </p:cNvPr>
            <p:cNvSpPr txBox="1"/>
            <p:nvPr/>
          </p:nvSpPr>
          <p:spPr>
            <a:xfrm>
              <a:off x="1382744" y="3486920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130" name="Textfeld 129">
              <a:extLst>
                <a:ext uri="{FF2B5EF4-FFF2-40B4-BE49-F238E27FC236}">
                  <a16:creationId xmlns="" xmlns:a16="http://schemas.microsoft.com/office/drawing/2014/main" id="{B816FDF8-06F3-7544-B090-62F28D07FAC7}"/>
                </a:ext>
              </a:extLst>
            </p:cNvPr>
            <p:cNvSpPr txBox="1"/>
            <p:nvPr/>
          </p:nvSpPr>
          <p:spPr>
            <a:xfrm>
              <a:off x="616566" y="3285218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te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feld 130">
              <a:extLst>
                <a:ext uri="{FF2B5EF4-FFF2-40B4-BE49-F238E27FC236}">
                  <a16:creationId xmlns="" xmlns:a16="http://schemas.microsoft.com/office/drawing/2014/main" id="{29467C2F-94B6-8E44-9346-76DAAA002808}"/>
                </a:ext>
              </a:extLst>
            </p:cNvPr>
            <p:cNvSpPr txBox="1"/>
            <p:nvPr/>
          </p:nvSpPr>
          <p:spPr>
            <a:xfrm>
              <a:off x="1281876" y="2921906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 37"/>
          <p:cNvGrpSpPr>
            <a:grpSpLocks noChangeAspect="1"/>
          </p:cNvGrpSpPr>
          <p:nvPr/>
        </p:nvGrpSpPr>
        <p:grpSpPr>
          <a:xfrm>
            <a:off x="421660" y="4534884"/>
            <a:ext cx="2880000" cy="1923934"/>
            <a:chOff x="421660" y="4998664"/>
            <a:chExt cx="2897996" cy="1935958"/>
          </a:xfrm>
        </p:grpSpPr>
        <p:pic>
          <p:nvPicPr>
            <p:cNvPr id="37" name="Grafik 36" descr="Ein Bild, das Foto, weiß, schwarz, stehend enthält.&#10;&#10;Automatisch generierte Beschreibung">
              <a:extLst>
                <a:ext uri="{FF2B5EF4-FFF2-40B4-BE49-F238E27FC236}">
                  <a16:creationId xmlns="" xmlns:a16="http://schemas.microsoft.com/office/drawing/2014/main" id="{6E1C2C59-D04E-3E4A-B840-2BB9193FDB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9656" y="5014626"/>
              <a:ext cx="2880000" cy="19199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1" name="Gerade Verbindung 40">
              <a:extLst>
                <a:ext uri="{FF2B5EF4-FFF2-40B4-BE49-F238E27FC236}">
                  <a16:creationId xmlns="" xmlns:a16="http://schemas.microsoft.com/office/drawing/2014/main" id="{F19C5F7F-BCD0-7B49-89A2-FDC7E5CBF748}"/>
                </a:ext>
              </a:extLst>
            </p:cNvPr>
            <p:cNvCxnSpPr/>
            <p:nvPr/>
          </p:nvCxnSpPr>
          <p:spPr>
            <a:xfrm>
              <a:off x="2796868" y="6828285"/>
              <a:ext cx="43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feld 41">
              <a:extLst>
                <a:ext uri="{FF2B5EF4-FFF2-40B4-BE49-F238E27FC236}">
                  <a16:creationId xmlns="" xmlns:a16="http://schemas.microsoft.com/office/drawing/2014/main" id="{4F423E43-42D1-9444-9DEF-42E99DD5F142}"/>
                </a:ext>
              </a:extLst>
            </p:cNvPr>
            <p:cNvSpPr txBox="1"/>
            <p:nvPr/>
          </p:nvSpPr>
          <p:spPr>
            <a:xfrm>
              <a:off x="2831796" y="6672837"/>
              <a:ext cx="3626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43" name="Textfeld 42">
              <a:extLst>
                <a:ext uri="{FF2B5EF4-FFF2-40B4-BE49-F238E27FC236}">
                  <a16:creationId xmlns="" xmlns:a16="http://schemas.microsoft.com/office/drawing/2014/main" id="{E8B4710A-AF85-F14D-B93A-5BC57FEDC53B}"/>
                </a:ext>
              </a:extLst>
            </p:cNvPr>
            <p:cNvSpPr txBox="1"/>
            <p:nvPr/>
          </p:nvSpPr>
          <p:spPr>
            <a:xfrm>
              <a:off x="421660" y="4998664"/>
              <a:ext cx="503999" cy="1846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VE821</a:t>
              </a:r>
            </a:p>
          </p:txBody>
        </p:sp>
        <p:sp>
          <p:nvSpPr>
            <p:cNvPr id="87" name="Textfeld 86">
              <a:extLst>
                <a:ext uri="{FF2B5EF4-FFF2-40B4-BE49-F238E27FC236}">
                  <a16:creationId xmlns="" xmlns:a16="http://schemas.microsoft.com/office/drawing/2014/main" id="{B8014B02-7949-1142-BF8E-292CE2AA86FC}"/>
                </a:ext>
              </a:extLst>
            </p:cNvPr>
            <p:cNvSpPr txBox="1"/>
            <p:nvPr/>
          </p:nvSpPr>
          <p:spPr>
            <a:xfrm>
              <a:off x="2349446" y="5244482"/>
              <a:ext cx="348736" cy="185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feld 87">
              <a:extLst>
                <a:ext uri="{FF2B5EF4-FFF2-40B4-BE49-F238E27FC236}">
                  <a16:creationId xmlns="" xmlns:a16="http://schemas.microsoft.com/office/drawing/2014/main" id="{6519D892-A784-4745-94DD-70FA36E98A78}"/>
                </a:ext>
              </a:extLst>
            </p:cNvPr>
            <p:cNvSpPr txBox="1"/>
            <p:nvPr/>
          </p:nvSpPr>
          <p:spPr>
            <a:xfrm>
              <a:off x="2268503" y="5718800"/>
              <a:ext cx="348736" cy="185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feld 88">
              <a:extLst>
                <a:ext uri="{FF2B5EF4-FFF2-40B4-BE49-F238E27FC236}">
                  <a16:creationId xmlns="" xmlns:a16="http://schemas.microsoft.com/office/drawing/2014/main" id="{9038A503-DBCD-4B49-A768-9E1661F168E7}"/>
                </a:ext>
              </a:extLst>
            </p:cNvPr>
            <p:cNvSpPr txBox="1"/>
            <p:nvPr/>
          </p:nvSpPr>
          <p:spPr>
            <a:xfrm>
              <a:off x="1929677" y="5578733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90" name="Textfeld 89">
              <a:extLst>
                <a:ext uri="{FF2B5EF4-FFF2-40B4-BE49-F238E27FC236}">
                  <a16:creationId xmlns="" xmlns:a16="http://schemas.microsoft.com/office/drawing/2014/main" id="{3A1CD15F-AA4A-4E46-981F-2D89BD2002A7}"/>
                </a:ext>
              </a:extLst>
            </p:cNvPr>
            <p:cNvSpPr txBox="1"/>
            <p:nvPr/>
          </p:nvSpPr>
          <p:spPr>
            <a:xfrm>
              <a:off x="452844" y="6144066"/>
              <a:ext cx="524554" cy="1858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ycogen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feld 124">
              <a:extLst>
                <a:ext uri="{FF2B5EF4-FFF2-40B4-BE49-F238E27FC236}">
                  <a16:creationId xmlns="" xmlns:a16="http://schemas.microsoft.com/office/drawing/2014/main" id="{19A65D57-074B-F545-8366-48DD7CD139B1}"/>
                </a:ext>
              </a:extLst>
            </p:cNvPr>
            <p:cNvSpPr txBox="1"/>
            <p:nvPr/>
          </p:nvSpPr>
          <p:spPr>
            <a:xfrm>
              <a:off x="1468603" y="5847624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te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feld 125">
              <a:extLst>
                <a:ext uri="{FF2B5EF4-FFF2-40B4-BE49-F238E27FC236}">
                  <a16:creationId xmlns="" xmlns:a16="http://schemas.microsoft.com/office/drawing/2014/main" id="{0D449563-BF98-8E45-B4D6-94B390ABDB37}"/>
                </a:ext>
              </a:extLst>
            </p:cNvPr>
            <p:cNvSpPr txBox="1"/>
            <p:nvPr/>
          </p:nvSpPr>
          <p:spPr>
            <a:xfrm>
              <a:off x="1359501" y="6459319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feld 126">
              <a:extLst>
                <a:ext uri="{FF2B5EF4-FFF2-40B4-BE49-F238E27FC236}">
                  <a16:creationId xmlns="" xmlns:a16="http://schemas.microsoft.com/office/drawing/2014/main" id="{B3888D06-2D46-9441-8271-65ECD75AB5CB}"/>
                </a:ext>
              </a:extLst>
            </p:cNvPr>
            <p:cNvSpPr txBox="1"/>
            <p:nvPr/>
          </p:nvSpPr>
          <p:spPr>
            <a:xfrm>
              <a:off x="1363662" y="6710034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so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Freihandform 30">
              <a:extLst>
                <a:ext uri="{FF2B5EF4-FFF2-40B4-BE49-F238E27FC236}">
                  <a16:creationId xmlns="" xmlns:a16="http://schemas.microsoft.com/office/drawing/2014/main" id="{AA6C0C19-46D2-0C4C-96F5-58CBA70DC657}"/>
                </a:ext>
              </a:extLst>
            </p:cNvPr>
            <p:cNvSpPr/>
            <p:nvPr/>
          </p:nvSpPr>
          <p:spPr>
            <a:xfrm>
              <a:off x="484632" y="6272784"/>
              <a:ext cx="557784" cy="612648"/>
            </a:xfrm>
            <a:custGeom>
              <a:avLst/>
              <a:gdLst>
                <a:gd name="connsiteX0" fmla="*/ 173736 w 557784"/>
                <a:gd name="connsiteY0" fmla="*/ 109728 h 612648"/>
                <a:gd name="connsiteX1" fmla="*/ 0 w 557784"/>
                <a:gd name="connsiteY1" fmla="*/ 210312 h 612648"/>
                <a:gd name="connsiteX2" fmla="*/ 27432 w 557784"/>
                <a:gd name="connsiteY2" fmla="*/ 438912 h 612648"/>
                <a:gd name="connsiteX3" fmla="*/ 182880 w 557784"/>
                <a:gd name="connsiteY3" fmla="*/ 566928 h 612648"/>
                <a:gd name="connsiteX4" fmla="*/ 320040 w 557784"/>
                <a:gd name="connsiteY4" fmla="*/ 612648 h 612648"/>
                <a:gd name="connsiteX5" fmla="*/ 420624 w 557784"/>
                <a:gd name="connsiteY5" fmla="*/ 548640 h 612648"/>
                <a:gd name="connsiteX6" fmla="*/ 466344 w 557784"/>
                <a:gd name="connsiteY6" fmla="*/ 457200 h 612648"/>
                <a:gd name="connsiteX7" fmla="*/ 557784 w 557784"/>
                <a:gd name="connsiteY7" fmla="*/ 301752 h 612648"/>
                <a:gd name="connsiteX8" fmla="*/ 557784 w 557784"/>
                <a:gd name="connsiteY8" fmla="*/ 182880 h 612648"/>
                <a:gd name="connsiteX9" fmla="*/ 493776 w 557784"/>
                <a:gd name="connsiteY9" fmla="*/ 54864 h 612648"/>
                <a:gd name="connsiteX10" fmla="*/ 338328 w 557784"/>
                <a:gd name="connsiteY10" fmla="*/ 0 h 612648"/>
                <a:gd name="connsiteX11" fmla="*/ 173736 w 557784"/>
                <a:gd name="connsiteY11" fmla="*/ 109728 h 6126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557784" h="612648" extrusionOk="0">
                  <a:moveTo>
                    <a:pt x="173736" y="109728"/>
                  </a:moveTo>
                  <a:cubicBezTo>
                    <a:pt x="112095" y="152423"/>
                    <a:pt x="30551" y="178119"/>
                    <a:pt x="0" y="210312"/>
                  </a:cubicBezTo>
                  <a:cubicBezTo>
                    <a:pt x="23272" y="274252"/>
                    <a:pt x="-7095" y="355784"/>
                    <a:pt x="27432" y="438912"/>
                  </a:cubicBezTo>
                  <a:cubicBezTo>
                    <a:pt x="66993" y="454589"/>
                    <a:pt x="138569" y="552010"/>
                    <a:pt x="182880" y="566928"/>
                  </a:cubicBezTo>
                  <a:cubicBezTo>
                    <a:pt x="228676" y="573757"/>
                    <a:pt x="286313" y="616700"/>
                    <a:pt x="320040" y="612648"/>
                  </a:cubicBezTo>
                  <a:cubicBezTo>
                    <a:pt x="340674" y="599329"/>
                    <a:pt x="399799" y="564253"/>
                    <a:pt x="420624" y="548640"/>
                  </a:cubicBezTo>
                  <a:cubicBezTo>
                    <a:pt x="433619" y="501397"/>
                    <a:pt x="461560" y="490694"/>
                    <a:pt x="466344" y="457200"/>
                  </a:cubicBezTo>
                  <a:cubicBezTo>
                    <a:pt x="500968" y="374614"/>
                    <a:pt x="546921" y="353088"/>
                    <a:pt x="557784" y="301752"/>
                  </a:cubicBezTo>
                  <a:cubicBezTo>
                    <a:pt x="557224" y="272359"/>
                    <a:pt x="566205" y="219905"/>
                    <a:pt x="557784" y="182880"/>
                  </a:cubicBezTo>
                  <a:cubicBezTo>
                    <a:pt x="531872" y="153190"/>
                    <a:pt x="514823" y="78253"/>
                    <a:pt x="493776" y="54864"/>
                  </a:cubicBezTo>
                  <a:cubicBezTo>
                    <a:pt x="424745" y="42740"/>
                    <a:pt x="416400" y="23712"/>
                    <a:pt x="338328" y="0"/>
                  </a:cubicBezTo>
                  <a:cubicBezTo>
                    <a:pt x="307233" y="43264"/>
                    <a:pt x="226179" y="68292"/>
                    <a:pt x="173736" y="109728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173736 w 557784"/>
                        <a:gd name="connsiteY0" fmla="*/ 109728 h 612648"/>
                        <a:gd name="connsiteX1" fmla="*/ 0 w 557784"/>
                        <a:gd name="connsiteY1" fmla="*/ 210312 h 612648"/>
                        <a:gd name="connsiteX2" fmla="*/ 27432 w 557784"/>
                        <a:gd name="connsiteY2" fmla="*/ 438912 h 612648"/>
                        <a:gd name="connsiteX3" fmla="*/ 182880 w 557784"/>
                        <a:gd name="connsiteY3" fmla="*/ 566928 h 612648"/>
                        <a:gd name="connsiteX4" fmla="*/ 320040 w 557784"/>
                        <a:gd name="connsiteY4" fmla="*/ 612648 h 612648"/>
                        <a:gd name="connsiteX5" fmla="*/ 420624 w 557784"/>
                        <a:gd name="connsiteY5" fmla="*/ 548640 h 612648"/>
                        <a:gd name="connsiteX6" fmla="*/ 466344 w 557784"/>
                        <a:gd name="connsiteY6" fmla="*/ 457200 h 612648"/>
                        <a:gd name="connsiteX7" fmla="*/ 557784 w 557784"/>
                        <a:gd name="connsiteY7" fmla="*/ 301752 h 612648"/>
                        <a:gd name="connsiteX8" fmla="*/ 557784 w 557784"/>
                        <a:gd name="connsiteY8" fmla="*/ 182880 h 612648"/>
                        <a:gd name="connsiteX9" fmla="*/ 493776 w 557784"/>
                        <a:gd name="connsiteY9" fmla="*/ 54864 h 612648"/>
                        <a:gd name="connsiteX10" fmla="*/ 338328 w 557784"/>
                        <a:gd name="connsiteY10" fmla="*/ 0 h 612648"/>
                        <a:gd name="connsiteX11" fmla="*/ 173736 w 557784"/>
                        <a:gd name="connsiteY11" fmla="*/ 109728 h 612648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</a:cxnLst>
                      <a:rect l="l" t="t" r="r" b="b"/>
                      <a:pathLst>
                        <a:path w="557784" h="612648">
                          <a:moveTo>
                            <a:pt x="173736" y="109728"/>
                          </a:moveTo>
                          <a:lnTo>
                            <a:pt x="0" y="210312"/>
                          </a:lnTo>
                          <a:lnTo>
                            <a:pt x="27432" y="438912"/>
                          </a:lnTo>
                          <a:lnTo>
                            <a:pt x="182880" y="566928"/>
                          </a:lnTo>
                          <a:lnTo>
                            <a:pt x="320040" y="612648"/>
                          </a:lnTo>
                          <a:lnTo>
                            <a:pt x="420624" y="548640"/>
                          </a:lnTo>
                          <a:lnTo>
                            <a:pt x="466344" y="457200"/>
                          </a:lnTo>
                          <a:lnTo>
                            <a:pt x="557784" y="301752"/>
                          </a:lnTo>
                          <a:lnTo>
                            <a:pt x="557784" y="182880"/>
                          </a:lnTo>
                          <a:lnTo>
                            <a:pt x="493776" y="54864"/>
                          </a:lnTo>
                          <a:lnTo>
                            <a:pt x="338328" y="0"/>
                          </a:lnTo>
                          <a:lnTo>
                            <a:pt x="173736" y="109728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3" name="Freihandform 32">
              <a:extLst>
                <a:ext uri="{FF2B5EF4-FFF2-40B4-BE49-F238E27FC236}">
                  <a16:creationId xmlns="" xmlns:a16="http://schemas.microsoft.com/office/drawing/2014/main" id="{B575CD62-B3DE-D845-B2F1-ED8F214188AE}"/>
                </a:ext>
              </a:extLst>
            </p:cNvPr>
            <p:cNvSpPr/>
            <p:nvPr/>
          </p:nvSpPr>
          <p:spPr>
            <a:xfrm>
              <a:off x="1298448" y="5660136"/>
              <a:ext cx="594360" cy="694944"/>
            </a:xfrm>
            <a:custGeom>
              <a:avLst/>
              <a:gdLst>
                <a:gd name="connsiteX0" fmla="*/ 246888 w 594360"/>
                <a:gd name="connsiteY0" fmla="*/ 27432 h 694944"/>
                <a:gd name="connsiteX1" fmla="*/ 128016 w 594360"/>
                <a:gd name="connsiteY1" fmla="*/ 155448 h 694944"/>
                <a:gd name="connsiteX2" fmla="*/ 0 w 594360"/>
                <a:gd name="connsiteY2" fmla="*/ 265176 h 694944"/>
                <a:gd name="connsiteX3" fmla="*/ 54864 w 594360"/>
                <a:gd name="connsiteY3" fmla="*/ 466344 h 694944"/>
                <a:gd name="connsiteX4" fmla="*/ 100584 w 594360"/>
                <a:gd name="connsiteY4" fmla="*/ 594360 h 694944"/>
                <a:gd name="connsiteX5" fmla="*/ 164592 w 594360"/>
                <a:gd name="connsiteY5" fmla="*/ 649224 h 694944"/>
                <a:gd name="connsiteX6" fmla="*/ 265176 w 594360"/>
                <a:gd name="connsiteY6" fmla="*/ 694944 h 694944"/>
                <a:gd name="connsiteX7" fmla="*/ 402336 w 594360"/>
                <a:gd name="connsiteY7" fmla="*/ 658368 h 694944"/>
                <a:gd name="connsiteX8" fmla="*/ 530352 w 594360"/>
                <a:gd name="connsiteY8" fmla="*/ 512064 h 694944"/>
                <a:gd name="connsiteX9" fmla="*/ 594360 w 594360"/>
                <a:gd name="connsiteY9" fmla="*/ 329184 h 694944"/>
                <a:gd name="connsiteX10" fmla="*/ 576072 w 594360"/>
                <a:gd name="connsiteY10" fmla="*/ 182880 h 694944"/>
                <a:gd name="connsiteX11" fmla="*/ 438912 w 594360"/>
                <a:gd name="connsiteY11" fmla="*/ 27432 h 694944"/>
                <a:gd name="connsiteX12" fmla="*/ 365760 w 594360"/>
                <a:gd name="connsiteY12" fmla="*/ 0 h 694944"/>
                <a:gd name="connsiteX13" fmla="*/ 246888 w 594360"/>
                <a:gd name="connsiteY13" fmla="*/ 27432 h 6949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</a:cxnLst>
              <a:rect l="l" t="t" r="r" b="b"/>
              <a:pathLst>
                <a:path w="594360" h="694944" extrusionOk="0">
                  <a:moveTo>
                    <a:pt x="246888" y="27432"/>
                  </a:moveTo>
                  <a:cubicBezTo>
                    <a:pt x="204018" y="75467"/>
                    <a:pt x="161129" y="117991"/>
                    <a:pt x="128016" y="155448"/>
                  </a:cubicBezTo>
                  <a:cubicBezTo>
                    <a:pt x="103206" y="201378"/>
                    <a:pt x="25916" y="216806"/>
                    <a:pt x="0" y="265176"/>
                  </a:cubicBezTo>
                  <a:cubicBezTo>
                    <a:pt x="35073" y="318604"/>
                    <a:pt x="41567" y="419291"/>
                    <a:pt x="54864" y="466344"/>
                  </a:cubicBezTo>
                  <a:cubicBezTo>
                    <a:pt x="74667" y="514401"/>
                    <a:pt x="73700" y="560131"/>
                    <a:pt x="100584" y="594360"/>
                  </a:cubicBezTo>
                  <a:cubicBezTo>
                    <a:pt x="129864" y="610887"/>
                    <a:pt x="138771" y="636452"/>
                    <a:pt x="164592" y="649224"/>
                  </a:cubicBezTo>
                  <a:cubicBezTo>
                    <a:pt x="194828" y="661780"/>
                    <a:pt x="220302" y="678937"/>
                    <a:pt x="265176" y="694944"/>
                  </a:cubicBezTo>
                  <a:cubicBezTo>
                    <a:pt x="307260" y="673371"/>
                    <a:pt x="371435" y="677958"/>
                    <a:pt x="402336" y="658368"/>
                  </a:cubicBezTo>
                  <a:cubicBezTo>
                    <a:pt x="427997" y="620814"/>
                    <a:pt x="499163" y="548591"/>
                    <a:pt x="530352" y="512064"/>
                  </a:cubicBezTo>
                  <a:cubicBezTo>
                    <a:pt x="537746" y="451900"/>
                    <a:pt x="581950" y="380296"/>
                    <a:pt x="594360" y="329184"/>
                  </a:cubicBezTo>
                  <a:cubicBezTo>
                    <a:pt x="585436" y="268649"/>
                    <a:pt x="599220" y="231153"/>
                    <a:pt x="576072" y="182880"/>
                  </a:cubicBezTo>
                  <a:cubicBezTo>
                    <a:pt x="518171" y="139560"/>
                    <a:pt x="487883" y="51296"/>
                    <a:pt x="438912" y="27432"/>
                  </a:cubicBezTo>
                  <a:cubicBezTo>
                    <a:pt x="420900" y="27762"/>
                    <a:pt x="391735" y="3549"/>
                    <a:pt x="365760" y="0"/>
                  </a:cubicBezTo>
                  <a:cubicBezTo>
                    <a:pt x="310574" y="22579"/>
                    <a:pt x="276974" y="6552"/>
                    <a:pt x="246888" y="27432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246888 w 594360"/>
                        <a:gd name="connsiteY0" fmla="*/ 27432 h 694944"/>
                        <a:gd name="connsiteX1" fmla="*/ 128016 w 594360"/>
                        <a:gd name="connsiteY1" fmla="*/ 155448 h 694944"/>
                        <a:gd name="connsiteX2" fmla="*/ 0 w 594360"/>
                        <a:gd name="connsiteY2" fmla="*/ 265176 h 694944"/>
                        <a:gd name="connsiteX3" fmla="*/ 54864 w 594360"/>
                        <a:gd name="connsiteY3" fmla="*/ 466344 h 694944"/>
                        <a:gd name="connsiteX4" fmla="*/ 100584 w 594360"/>
                        <a:gd name="connsiteY4" fmla="*/ 594360 h 694944"/>
                        <a:gd name="connsiteX5" fmla="*/ 164592 w 594360"/>
                        <a:gd name="connsiteY5" fmla="*/ 649224 h 694944"/>
                        <a:gd name="connsiteX6" fmla="*/ 265176 w 594360"/>
                        <a:gd name="connsiteY6" fmla="*/ 694944 h 694944"/>
                        <a:gd name="connsiteX7" fmla="*/ 402336 w 594360"/>
                        <a:gd name="connsiteY7" fmla="*/ 658368 h 694944"/>
                        <a:gd name="connsiteX8" fmla="*/ 530352 w 594360"/>
                        <a:gd name="connsiteY8" fmla="*/ 512064 h 694944"/>
                        <a:gd name="connsiteX9" fmla="*/ 594360 w 594360"/>
                        <a:gd name="connsiteY9" fmla="*/ 329184 h 694944"/>
                        <a:gd name="connsiteX10" fmla="*/ 576072 w 594360"/>
                        <a:gd name="connsiteY10" fmla="*/ 182880 h 694944"/>
                        <a:gd name="connsiteX11" fmla="*/ 438912 w 594360"/>
                        <a:gd name="connsiteY11" fmla="*/ 27432 h 694944"/>
                        <a:gd name="connsiteX12" fmla="*/ 365760 w 594360"/>
                        <a:gd name="connsiteY12" fmla="*/ 0 h 694944"/>
                        <a:gd name="connsiteX13" fmla="*/ 246888 w 594360"/>
                        <a:gd name="connsiteY13" fmla="*/ 27432 h 694944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</a:cxnLst>
                      <a:rect l="l" t="t" r="r" b="b"/>
                      <a:pathLst>
                        <a:path w="594360" h="694944">
                          <a:moveTo>
                            <a:pt x="246888" y="27432"/>
                          </a:moveTo>
                          <a:lnTo>
                            <a:pt x="128016" y="155448"/>
                          </a:lnTo>
                          <a:lnTo>
                            <a:pt x="0" y="265176"/>
                          </a:lnTo>
                          <a:lnTo>
                            <a:pt x="54864" y="466344"/>
                          </a:lnTo>
                          <a:lnTo>
                            <a:pt x="100584" y="594360"/>
                          </a:lnTo>
                          <a:lnTo>
                            <a:pt x="164592" y="649224"/>
                          </a:lnTo>
                          <a:lnTo>
                            <a:pt x="265176" y="694944"/>
                          </a:lnTo>
                          <a:lnTo>
                            <a:pt x="402336" y="658368"/>
                          </a:lnTo>
                          <a:lnTo>
                            <a:pt x="530352" y="512064"/>
                          </a:lnTo>
                          <a:lnTo>
                            <a:pt x="594360" y="329184"/>
                          </a:lnTo>
                          <a:lnTo>
                            <a:pt x="576072" y="182880"/>
                          </a:lnTo>
                          <a:lnTo>
                            <a:pt x="438912" y="27432"/>
                          </a:lnTo>
                          <a:lnTo>
                            <a:pt x="365760" y="0"/>
                          </a:lnTo>
                          <a:lnTo>
                            <a:pt x="246888" y="27432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2" name="Textfeld 131">
              <a:extLst>
                <a:ext uri="{FF2B5EF4-FFF2-40B4-BE49-F238E27FC236}">
                  <a16:creationId xmlns="" xmlns:a16="http://schemas.microsoft.com/office/drawing/2014/main" id="{E02FD731-B91B-6E42-9E97-97E3C25F99D6}"/>
                </a:ext>
              </a:extLst>
            </p:cNvPr>
            <p:cNvSpPr txBox="1"/>
            <p:nvPr/>
          </p:nvSpPr>
          <p:spPr>
            <a:xfrm>
              <a:off x="2676056" y="6180451"/>
              <a:ext cx="3209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oup 31"/>
          <p:cNvGrpSpPr>
            <a:grpSpLocks noChangeAspect="1"/>
          </p:cNvGrpSpPr>
          <p:nvPr/>
        </p:nvGrpSpPr>
        <p:grpSpPr>
          <a:xfrm>
            <a:off x="3418955" y="6526526"/>
            <a:ext cx="2880000" cy="1946651"/>
            <a:chOff x="3425952" y="7213579"/>
            <a:chExt cx="2880000" cy="1946652"/>
          </a:xfrm>
        </p:grpSpPr>
        <p:pic>
          <p:nvPicPr>
            <p:cNvPr id="56" name="Grafik 55" descr="Ein Bild, das Essen, Foto, sitzend, Pizza enthält.&#10;&#10;Automatisch generierte Beschreibung">
              <a:extLst>
                <a:ext uri="{FF2B5EF4-FFF2-40B4-BE49-F238E27FC236}">
                  <a16:creationId xmlns="" xmlns:a16="http://schemas.microsoft.com/office/drawing/2014/main" id="{262C4BA9-D979-3643-8DE9-3D8C929670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25952" y="7224273"/>
              <a:ext cx="2880000" cy="193595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57" name="Gerade Verbindung 56">
              <a:extLst>
                <a:ext uri="{FF2B5EF4-FFF2-40B4-BE49-F238E27FC236}">
                  <a16:creationId xmlns="" xmlns:a16="http://schemas.microsoft.com/office/drawing/2014/main" id="{A7644B97-628C-BE4D-A44E-56A60AB7B6BF}"/>
                </a:ext>
              </a:extLst>
            </p:cNvPr>
            <p:cNvCxnSpPr/>
            <p:nvPr/>
          </p:nvCxnSpPr>
          <p:spPr>
            <a:xfrm>
              <a:off x="5801160" y="9043200"/>
              <a:ext cx="43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feld 57">
              <a:extLst>
                <a:ext uri="{FF2B5EF4-FFF2-40B4-BE49-F238E27FC236}">
                  <a16:creationId xmlns="" xmlns:a16="http://schemas.microsoft.com/office/drawing/2014/main" id="{A7916AD7-D4DC-9C4D-89E7-AA384EEBDB38}"/>
                </a:ext>
              </a:extLst>
            </p:cNvPr>
            <p:cNvSpPr txBox="1"/>
            <p:nvPr/>
          </p:nvSpPr>
          <p:spPr>
            <a:xfrm>
              <a:off x="5836088" y="8887752"/>
              <a:ext cx="3626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59" name="Textfeld 58">
              <a:extLst>
                <a:ext uri="{FF2B5EF4-FFF2-40B4-BE49-F238E27FC236}">
                  <a16:creationId xmlns="" xmlns:a16="http://schemas.microsoft.com/office/drawing/2014/main" id="{BA4725B5-8E30-A743-9469-3BB84A83293B}"/>
                </a:ext>
              </a:extLst>
            </p:cNvPr>
            <p:cNvSpPr txBox="1"/>
            <p:nvPr/>
          </p:nvSpPr>
          <p:spPr>
            <a:xfrm>
              <a:off x="3425952" y="7213579"/>
              <a:ext cx="504000" cy="1846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AUY-VE</a:t>
              </a:r>
            </a:p>
          </p:txBody>
        </p:sp>
        <p:sp>
          <p:nvSpPr>
            <p:cNvPr id="99" name="Textfeld 98">
              <a:extLst>
                <a:ext uri="{FF2B5EF4-FFF2-40B4-BE49-F238E27FC236}">
                  <a16:creationId xmlns="" xmlns:a16="http://schemas.microsoft.com/office/drawing/2014/main" id="{BA4D8643-5DE6-234D-922B-79085339308D}"/>
                </a:ext>
              </a:extLst>
            </p:cNvPr>
            <p:cNvSpPr txBox="1"/>
            <p:nvPr/>
          </p:nvSpPr>
          <p:spPr>
            <a:xfrm>
              <a:off x="5428680" y="7732105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100" name="Textfeld 99">
              <a:extLst>
                <a:ext uri="{FF2B5EF4-FFF2-40B4-BE49-F238E27FC236}">
                  <a16:creationId xmlns="" xmlns:a16="http://schemas.microsoft.com/office/drawing/2014/main" id="{A68F4914-B408-714E-94C1-6E0A8C727271}"/>
                </a:ext>
              </a:extLst>
            </p:cNvPr>
            <p:cNvSpPr txBox="1"/>
            <p:nvPr/>
          </p:nvSpPr>
          <p:spPr>
            <a:xfrm>
              <a:off x="3470664" y="8713781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103" name="Textfeld 102">
              <a:extLst>
                <a:ext uri="{FF2B5EF4-FFF2-40B4-BE49-F238E27FC236}">
                  <a16:creationId xmlns="" xmlns:a16="http://schemas.microsoft.com/office/drawing/2014/main" id="{B449B8F6-4CA8-BF44-9239-93924F909A64}"/>
                </a:ext>
              </a:extLst>
            </p:cNvPr>
            <p:cNvSpPr txBox="1"/>
            <p:nvPr/>
          </p:nvSpPr>
          <p:spPr>
            <a:xfrm>
              <a:off x="4353312" y="7632684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feld 103">
              <a:extLst>
                <a:ext uri="{FF2B5EF4-FFF2-40B4-BE49-F238E27FC236}">
                  <a16:creationId xmlns="" xmlns:a16="http://schemas.microsoft.com/office/drawing/2014/main" id="{8CFA70D3-DA42-394E-8A40-1082E81F66D1}"/>
                </a:ext>
              </a:extLst>
            </p:cNvPr>
            <p:cNvSpPr txBox="1"/>
            <p:nvPr/>
          </p:nvSpPr>
          <p:spPr>
            <a:xfrm>
              <a:off x="3446966" y="8130507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feld 104">
              <a:extLst>
                <a:ext uri="{FF2B5EF4-FFF2-40B4-BE49-F238E27FC236}">
                  <a16:creationId xmlns="" xmlns:a16="http://schemas.microsoft.com/office/drawing/2014/main" id="{20ABE96A-0765-EC4B-AFEF-4EE2DF77BFF6}"/>
                </a:ext>
              </a:extLst>
            </p:cNvPr>
            <p:cNvSpPr txBox="1"/>
            <p:nvPr/>
          </p:nvSpPr>
          <p:spPr>
            <a:xfrm>
              <a:off x="5648568" y="7916771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feld 110">
              <a:extLst>
                <a:ext uri="{FF2B5EF4-FFF2-40B4-BE49-F238E27FC236}">
                  <a16:creationId xmlns="" xmlns:a16="http://schemas.microsoft.com/office/drawing/2014/main" id="{598725EF-8700-3E42-8B62-AF5270F9C142}"/>
                </a:ext>
              </a:extLst>
            </p:cNvPr>
            <p:cNvSpPr txBox="1"/>
            <p:nvPr/>
          </p:nvSpPr>
          <p:spPr>
            <a:xfrm>
              <a:off x="3751663" y="7928043"/>
              <a:ext cx="3465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u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feld 112">
              <a:extLst>
                <a:ext uri="{FF2B5EF4-FFF2-40B4-BE49-F238E27FC236}">
                  <a16:creationId xmlns="" xmlns:a16="http://schemas.microsoft.com/office/drawing/2014/main" id="{57E4F94B-7A13-114D-8A71-33BC96CF119C}"/>
                </a:ext>
              </a:extLst>
            </p:cNvPr>
            <p:cNvSpPr txBox="1"/>
            <p:nvPr/>
          </p:nvSpPr>
          <p:spPr>
            <a:xfrm>
              <a:off x="4707896" y="8265131"/>
              <a:ext cx="6190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pid</a:t>
              </a:r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sicle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Freihandform 3">
              <a:extLst>
                <a:ext uri="{FF2B5EF4-FFF2-40B4-BE49-F238E27FC236}">
                  <a16:creationId xmlns="" xmlns:a16="http://schemas.microsoft.com/office/drawing/2014/main" id="{D22D265D-C2B1-6E41-BC37-6EA4E9E5F903}"/>
                </a:ext>
              </a:extLst>
            </p:cNvPr>
            <p:cNvSpPr/>
            <p:nvPr/>
          </p:nvSpPr>
          <p:spPr>
            <a:xfrm>
              <a:off x="4317558" y="7927450"/>
              <a:ext cx="1367625" cy="1200647"/>
            </a:xfrm>
            <a:custGeom>
              <a:avLst/>
              <a:gdLst>
                <a:gd name="connsiteX0" fmla="*/ 294199 w 1367625"/>
                <a:gd name="connsiteY0" fmla="*/ 190832 h 1200647"/>
                <a:gd name="connsiteX1" fmla="*/ 548640 w 1367625"/>
                <a:gd name="connsiteY1" fmla="*/ 79513 h 1200647"/>
                <a:gd name="connsiteX2" fmla="*/ 826936 w 1367625"/>
                <a:gd name="connsiteY2" fmla="*/ 0 h 1200647"/>
                <a:gd name="connsiteX3" fmla="*/ 985962 w 1367625"/>
                <a:gd name="connsiteY3" fmla="*/ 7952 h 1200647"/>
                <a:gd name="connsiteX4" fmla="*/ 1184745 w 1367625"/>
                <a:gd name="connsiteY4" fmla="*/ 23854 h 1200647"/>
                <a:gd name="connsiteX5" fmla="*/ 1319917 w 1367625"/>
                <a:gd name="connsiteY5" fmla="*/ 143124 h 1200647"/>
                <a:gd name="connsiteX6" fmla="*/ 1367625 w 1367625"/>
                <a:gd name="connsiteY6" fmla="*/ 262393 h 1200647"/>
                <a:gd name="connsiteX7" fmla="*/ 1327868 w 1367625"/>
                <a:gd name="connsiteY7" fmla="*/ 333955 h 1200647"/>
                <a:gd name="connsiteX8" fmla="*/ 1343771 w 1367625"/>
                <a:gd name="connsiteY8" fmla="*/ 453225 h 1200647"/>
                <a:gd name="connsiteX9" fmla="*/ 1280160 w 1367625"/>
                <a:gd name="connsiteY9" fmla="*/ 564543 h 1200647"/>
                <a:gd name="connsiteX10" fmla="*/ 1192696 w 1367625"/>
                <a:gd name="connsiteY10" fmla="*/ 667910 h 1200647"/>
                <a:gd name="connsiteX11" fmla="*/ 1017767 w 1367625"/>
                <a:gd name="connsiteY11" fmla="*/ 707667 h 1200647"/>
                <a:gd name="connsiteX12" fmla="*/ 946205 w 1367625"/>
                <a:gd name="connsiteY12" fmla="*/ 795131 h 1200647"/>
                <a:gd name="connsiteX13" fmla="*/ 938254 w 1367625"/>
                <a:gd name="connsiteY13" fmla="*/ 898498 h 1200647"/>
                <a:gd name="connsiteX14" fmla="*/ 842839 w 1367625"/>
                <a:gd name="connsiteY14" fmla="*/ 978011 h 1200647"/>
                <a:gd name="connsiteX15" fmla="*/ 699715 w 1367625"/>
                <a:gd name="connsiteY15" fmla="*/ 1049573 h 1200647"/>
                <a:gd name="connsiteX16" fmla="*/ 540689 w 1367625"/>
                <a:gd name="connsiteY16" fmla="*/ 1113183 h 1200647"/>
                <a:gd name="connsiteX17" fmla="*/ 365760 w 1367625"/>
                <a:gd name="connsiteY17" fmla="*/ 1200647 h 1200647"/>
                <a:gd name="connsiteX18" fmla="*/ 111319 w 1367625"/>
                <a:gd name="connsiteY18" fmla="*/ 1184745 h 1200647"/>
                <a:gd name="connsiteX19" fmla="*/ 31805 w 1367625"/>
                <a:gd name="connsiteY19" fmla="*/ 1041621 h 1200647"/>
                <a:gd name="connsiteX20" fmla="*/ 0 w 1367625"/>
                <a:gd name="connsiteY20" fmla="*/ 898498 h 1200647"/>
                <a:gd name="connsiteX21" fmla="*/ 39757 w 1367625"/>
                <a:gd name="connsiteY21" fmla="*/ 691764 h 1200647"/>
                <a:gd name="connsiteX22" fmla="*/ 127221 w 1367625"/>
                <a:gd name="connsiteY22" fmla="*/ 477079 h 1200647"/>
                <a:gd name="connsiteX23" fmla="*/ 230588 w 1367625"/>
                <a:gd name="connsiteY23" fmla="*/ 310101 h 1200647"/>
                <a:gd name="connsiteX24" fmla="*/ 294199 w 1367625"/>
                <a:gd name="connsiteY24" fmla="*/ 190832 h 12006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1367625" h="1200647" extrusionOk="0">
                  <a:moveTo>
                    <a:pt x="294199" y="190832"/>
                  </a:moveTo>
                  <a:cubicBezTo>
                    <a:pt x="377193" y="126465"/>
                    <a:pt x="470785" y="146600"/>
                    <a:pt x="548640" y="79513"/>
                  </a:cubicBezTo>
                  <a:cubicBezTo>
                    <a:pt x="623321" y="38238"/>
                    <a:pt x="738244" y="38705"/>
                    <a:pt x="826936" y="0"/>
                  </a:cubicBezTo>
                  <a:cubicBezTo>
                    <a:pt x="895441" y="-10806"/>
                    <a:pt x="943374" y="15562"/>
                    <a:pt x="985962" y="7952"/>
                  </a:cubicBezTo>
                  <a:cubicBezTo>
                    <a:pt x="1052488" y="9998"/>
                    <a:pt x="1130806" y="30192"/>
                    <a:pt x="1184745" y="23854"/>
                  </a:cubicBezTo>
                  <a:cubicBezTo>
                    <a:pt x="1220279" y="38395"/>
                    <a:pt x="1280727" y="123046"/>
                    <a:pt x="1319917" y="143124"/>
                  </a:cubicBezTo>
                  <a:cubicBezTo>
                    <a:pt x="1330666" y="167240"/>
                    <a:pt x="1352943" y="231519"/>
                    <a:pt x="1367625" y="262393"/>
                  </a:cubicBezTo>
                  <a:cubicBezTo>
                    <a:pt x="1356292" y="292750"/>
                    <a:pt x="1338339" y="298408"/>
                    <a:pt x="1327868" y="333955"/>
                  </a:cubicBezTo>
                  <a:cubicBezTo>
                    <a:pt x="1338077" y="367012"/>
                    <a:pt x="1335116" y="420654"/>
                    <a:pt x="1343771" y="453225"/>
                  </a:cubicBezTo>
                  <a:cubicBezTo>
                    <a:pt x="1319213" y="507375"/>
                    <a:pt x="1298546" y="517255"/>
                    <a:pt x="1280160" y="564543"/>
                  </a:cubicBezTo>
                  <a:cubicBezTo>
                    <a:pt x="1257341" y="593330"/>
                    <a:pt x="1220377" y="613253"/>
                    <a:pt x="1192696" y="667910"/>
                  </a:cubicBezTo>
                  <a:cubicBezTo>
                    <a:pt x="1160310" y="696351"/>
                    <a:pt x="1075093" y="693933"/>
                    <a:pt x="1017767" y="707667"/>
                  </a:cubicBezTo>
                  <a:cubicBezTo>
                    <a:pt x="1000756" y="733156"/>
                    <a:pt x="964451" y="762783"/>
                    <a:pt x="946205" y="795131"/>
                  </a:cubicBezTo>
                  <a:cubicBezTo>
                    <a:pt x="944799" y="828365"/>
                    <a:pt x="933329" y="849635"/>
                    <a:pt x="938254" y="898498"/>
                  </a:cubicBezTo>
                  <a:cubicBezTo>
                    <a:pt x="904143" y="943449"/>
                    <a:pt x="874287" y="944928"/>
                    <a:pt x="842839" y="978011"/>
                  </a:cubicBezTo>
                  <a:cubicBezTo>
                    <a:pt x="777909" y="1018787"/>
                    <a:pt x="725048" y="1025692"/>
                    <a:pt x="699715" y="1049573"/>
                  </a:cubicBezTo>
                  <a:cubicBezTo>
                    <a:pt x="647457" y="1085151"/>
                    <a:pt x="589576" y="1086774"/>
                    <a:pt x="540689" y="1113183"/>
                  </a:cubicBezTo>
                  <a:cubicBezTo>
                    <a:pt x="486933" y="1151813"/>
                    <a:pt x="450714" y="1157414"/>
                    <a:pt x="365760" y="1200647"/>
                  </a:cubicBezTo>
                  <a:cubicBezTo>
                    <a:pt x="278308" y="1204868"/>
                    <a:pt x="206750" y="1167705"/>
                    <a:pt x="111319" y="1184745"/>
                  </a:cubicBezTo>
                  <a:cubicBezTo>
                    <a:pt x="85043" y="1145178"/>
                    <a:pt x="64255" y="1072453"/>
                    <a:pt x="31805" y="1041621"/>
                  </a:cubicBezTo>
                  <a:cubicBezTo>
                    <a:pt x="16401" y="995126"/>
                    <a:pt x="28319" y="951798"/>
                    <a:pt x="0" y="898498"/>
                  </a:cubicBezTo>
                  <a:cubicBezTo>
                    <a:pt x="7234" y="823210"/>
                    <a:pt x="47136" y="751176"/>
                    <a:pt x="39757" y="691764"/>
                  </a:cubicBezTo>
                  <a:cubicBezTo>
                    <a:pt x="69240" y="595354"/>
                    <a:pt x="112637" y="558505"/>
                    <a:pt x="127221" y="477079"/>
                  </a:cubicBezTo>
                  <a:cubicBezTo>
                    <a:pt x="157838" y="415820"/>
                    <a:pt x="217320" y="357359"/>
                    <a:pt x="230588" y="310101"/>
                  </a:cubicBezTo>
                  <a:cubicBezTo>
                    <a:pt x="243331" y="276557"/>
                    <a:pt x="269396" y="241941"/>
                    <a:pt x="294199" y="190832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294199 w 1367625"/>
                        <a:gd name="connsiteY0" fmla="*/ 190832 h 1200647"/>
                        <a:gd name="connsiteX1" fmla="*/ 548640 w 1367625"/>
                        <a:gd name="connsiteY1" fmla="*/ 79513 h 1200647"/>
                        <a:gd name="connsiteX2" fmla="*/ 826936 w 1367625"/>
                        <a:gd name="connsiteY2" fmla="*/ 0 h 1200647"/>
                        <a:gd name="connsiteX3" fmla="*/ 985962 w 1367625"/>
                        <a:gd name="connsiteY3" fmla="*/ 7952 h 1200647"/>
                        <a:gd name="connsiteX4" fmla="*/ 1184745 w 1367625"/>
                        <a:gd name="connsiteY4" fmla="*/ 23854 h 1200647"/>
                        <a:gd name="connsiteX5" fmla="*/ 1319917 w 1367625"/>
                        <a:gd name="connsiteY5" fmla="*/ 143124 h 1200647"/>
                        <a:gd name="connsiteX6" fmla="*/ 1367625 w 1367625"/>
                        <a:gd name="connsiteY6" fmla="*/ 262393 h 1200647"/>
                        <a:gd name="connsiteX7" fmla="*/ 1327868 w 1367625"/>
                        <a:gd name="connsiteY7" fmla="*/ 333955 h 1200647"/>
                        <a:gd name="connsiteX8" fmla="*/ 1343771 w 1367625"/>
                        <a:gd name="connsiteY8" fmla="*/ 453225 h 1200647"/>
                        <a:gd name="connsiteX9" fmla="*/ 1280160 w 1367625"/>
                        <a:gd name="connsiteY9" fmla="*/ 564543 h 1200647"/>
                        <a:gd name="connsiteX10" fmla="*/ 1192696 w 1367625"/>
                        <a:gd name="connsiteY10" fmla="*/ 667910 h 1200647"/>
                        <a:gd name="connsiteX11" fmla="*/ 1017767 w 1367625"/>
                        <a:gd name="connsiteY11" fmla="*/ 707667 h 1200647"/>
                        <a:gd name="connsiteX12" fmla="*/ 946205 w 1367625"/>
                        <a:gd name="connsiteY12" fmla="*/ 795131 h 1200647"/>
                        <a:gd name="connsiteX13" fmla="*/ 938254 w 1367625"/>
                        <a:gd name="connsiteY13" fmla="*/ 898498 h 1200647"/>
                        <a:gd name="connsiteX14" fmla="*/ 842839 w 1367625"/>
                        <a:gd name="connsiteY14" fmla="*/ 978011 h 1200647"/>
                        <a:gd name="connsiteX15" fmla="*/ 699715 w 1367625"/>
                        <a:gd name="connsiteY15" fmla="*/ 1049573 h 1200647"/>
                        <a:gd name="connsiteX16" fmla="*/ 540689 w 1367625"/>
                        <a:gd name="connsiteY16" fmla="*/ 1113183 h 1200647"/>
                        <a:gd name="connsiteX17" fmla="*/ 365760 w 1367625"/>
                        <a:gd name="connsiteY17" fmla="*/ 1200647 h 1200647"/>
                        <a:gd name="connsiteX18" fmla="*/ 111319 w 1367625"/>
                        <a:gd name="connsiteY18" fmla="*/ 1184745 h 1200647"/>
                        <a:gd name="connsiteX19" fmla="*/ 31805 w 1367625"/>
                        <a:gd name="connsiteY19" fmla="*/ 1041621 h 1200647"/>
                        <a:gd name="connsiteX20" fmla="*/ 0 w 1367625"/>
                        <a:gd name="connsiteY20" fmla="*/ 898498 h 1200647"/>
                        <a:gd name="connsiteX21" fmla="*/ 39757 w 1367625"/>
                        <a:gd name="connsiteY21" fmla="*/ 691764 h 1200647"/>
                        <a:gd name="connsiteX22" fmla="*/ 127221 w 1367625"/>
                        <a:gd name="connsiteY22" fmla="*/ 477079 h 1200647"/>
                        <a:gd name="connsiteX23" fmla="*/ 230588 w 1367625"/>
                        <a:gd name="connsiteY23" fmla="*/ 310101 h 1200647"/>
                        <a:gd name="connsiteX24" fmla="*/ 294199 w 1367625"/>
                        <a:gd name="connsiteY24" fmla="*/ 190832 h 1200647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</a:cxnLst>
                      <a:rect l="l" t="t" r="r" b="b"/>
                      <a:pathLst>
                        <a:path w="1367625" h="1200647">
                          <a:moveTo>
                            <a:pt x="294199" y="190832"/>
                          </a:moveTo>
                          <a:lnTo>
                            <a:pt x="548640" y="79513"/>
                          </a:lnTo>
                          <a:lnTo>
                            <a:pt x="826936" y="0"/>
                          </a:lnTo>
                          <a:lnTo>
                            <a:pt x="985962" y="7952"/>
                          </a:lnTo>
                          <a:lnTo>
                            <a:pt x="1184745" y="23854"/>
                          </a:lnTo>
                          <a:lnTo>
                            <a:pt x="1319917" y="143124"/>
                          </a:lnTo>
                          <a:lnTo>
                            <a:pt x="1367625" y="262393"/>
                          </a:lnTo>
                          <a:lnTo>
                            <a:pt x="1327868" y="333955"/>
                          </a:lnTo>
                          <a:lnTo>
                            <a:pt x="1343771" y="453225"/>
                          </a:lnTo>
                          <a:lnTo>
                            <a:pt x="1280160" y="564543"/>
                          </a:lnTo>
                          <a:lnTo>
                            <a:pt x="1192696" y="667910"/>
                          </a:lnTo>
                          <a:lnTo>
                            <a:pt x="1017767" y="707667"/>
                          </a:lnTo>
                          <a:lnTo>
                            <a:pt x="946205" y="795131"/>
                          </a:lnTo>
                          <a:lnTo>
                            <a:pt x="938254" y="898498"/>
                          </a:lnTo>
                          <a:lnTo>
                            <a:pt x="842839" y="978011"/>
                          </a:lnTo>
                          <a:lnTo>
                            <a:pt x="699715" y="1049573"/>
                          </a:lnTo>
                          <a:lnTo>
                            <a:pt x="540689" y="1113183"/>
                          </a:lnTo>
                          <a:lnTo>
                            <a:pt x="365760" y="1200647"/>
                          </a:lnTo>
                          <a:lnTo>
                            <a:pt x="111319" y="1184745"/>
                          </a:lnTo>
                          <a:lnTo>
                            <a:pt x="31805" y="1041621"/>
                          </a:lnTo>
                          <a:lnTo>
                            <a:pt x="0" y="898498"/>
                          </a:lnTo>
                          <a:lnTo>
                            <a:pt x="39757" y="691764"/>
                          </a:lnTo>
                          <a:lnTo>
                            <a:pt x="127221" y="477079"/>
                          </a:lnTo>
                          <a:lnTo>
                            <a:pt x="230588" y="310101"/>
                          </a:lnTo>
                          <a:lnTo>
                            <a:pt x="294199" y="190832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" name="Freihandform 4">
              <a:extLst>
                <a:ext uri="{FF2B5EF4-FFF2-40B4-BE49-F238E27FC236}">
                  <a16:creationId xmlns="" xmlns:a16="http://schemas.microsoft.com/office/drawing/2014/main" id="{08770525-A852-C14C-8B25-CEDE36C04F46}"/>
                </a:ext>
              </a:extLst>
            </p:cNvPr>
            <p:cNvSpPr/>
            <p:nvPr/>
          </p:nvSpPr>
          <p:spPr>
            <a:xfrm>
              <a:off x="3681454" y="7768424"/>
              <a:ext cx="397565" cy="397566"/>
            </a:xfrm>
            <a:custGeom>
              <a:avLst/>
              <a:gdLst>
                <a:gd name="connsiteX0" fmla="*/ 0 w 397565"/>
                <a:gd name="connsiteY0" fmla="*/ 143124 h 397566"/>
                <a:gd name="connsiteX1" fmla="*/ 0 w 397565"/>
                <a:gd name="connsiteY1" fmla="*/ 246491 h 397566"/>
                <a:gd name="connsiteX2" fmla="*/ 71562 w 397565"/>
                <a:gd name="connsiteY2" fmla="*/ 357809 h 397566"/>
                <a:gd name="connsiteX3" fmla="*/ 278296 w 397565"/>
                <a:gd name="connsiteY3" fmla="*/ 397566 h 397566"/>
                <a:gd name="connsiteX4" fmla="*/ 397565 w 397565"/>
                <a:gd name="connsiteY4" fmla="*/ 310101 h 397566"/>
                <a:gd name="connsiteX5" fmla="*/ 389614 w 397565"/>
                <a:gd name="connsiteY5" fmla="*/ 135173 h 397566"/>
                <a:gd name="connsiteX6" fmla="*/ 262393 w 397565"/>
                <a:gd name="connsiteY6" fmla="*/ 7952 h 397566"/>
                <a:gd name="connsiteX7" fmla="*/ 166977 w 397565"/>
                <a:gd name="connsiteY7" fmla="*/ 0 h 397566"/>
                <a:gd name="connsiteX8" fmla="*/ 103367 w 397565"/>
                <a:gd name="connsiteY8" fmla="*/ 87465 h 397566"/>
                <a:gd name="connsiteX9" fmla="*/ 0 w 397565"/>
                <a:gd name="connsiteY9" fmla="*/ 143124 h 3975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397565" h="397566" extrusionOk="0">
                  <a:moveTo>
                    <a:pt x="0" y="143124"/>
                  </a:moveTo>
                  <a:cubicBezTo>
                    <a:pt x="2482" y="180834"/>
                    <a:pt x="-4907" y="195555"/>
                    <a:pt x="0" y="246491"/>
                  </a:cubicBezTo>
                  <a:cubicBezTo>
                    <a:pt x="29318" y="288848"/>
                    <a:pt x="32008" y="317274"/>
                    <a:pt x="71562" y="357809"/>
                  </a:cubicBezTo>
                  <a:cubicBezTo>
                    <a:pt x="133714" y="350458"/>
                    <a:pt x="189082" y="389729"/>
                    <a:pt x="278296" y="397566"/>
                  </a:cubicBezTo>
                  <a:cubicBezTo>
                    <a:pt x="311375" y="356846"/>
                    <a:pt x="369706" y="335301"/>
                    <a:pt x="397565" y="310101"/>
                  </a:cubicBezTo>
                  <a:cubicBezTo>
                    <a:pt x="389818" y="226359"/>
                    <a:pt x="404458" y="205135"/>
                    <a:pt x="389614" y="135173"/>
                  </a:cubicBezTo>
                  <a:cubicBezTo>
                    <a:pt x="343793" y="96726"/>
                    <a:pt x="316716" y="55786"/>
                    <a:pt x="262393" y="7952"/>
                  </a:cubicBezTo>
                  <a:cubicBezTo>
                    <a:pt x="216815" y="14554"/>
                    <a:pt x="210412" y="-3214"/>
                    <a:pt x="166977" y="0"/>
                  </a:cubicBezTo>
                  <a:cubicBezTo>
                    <a:pt x="148151" y="32605"/>
                    <a:pt x="123783" y="42967"/>
                    <a:pt x="103367" y="87465"/>
                  </a:cubicBezTo>
                  <a:cubicBezTo>
                    <a:pt x="78048" y="103349"/>
                    <a:pt x="24301" y="119593"/>
                    <a:pt x="0" y="143124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0 w 397565"/>
                        <a:gd name="connsiteY0" fmla="*/ 143124 h 397566"/>
                        <a:gd name="connsiteX1" fmla="*/ 0 w 397565"/>
                        <a:gd name="connsiteY1" fmla="*/ 246491 h 397566"/>
                        <a:gd name="connsiteX2" fmla="*/ 71562 w 397565"/>
                        <a:gd name="connsiteY2" fmla="*/ 357809 h 397566"/>
                        <a:gd name="connsiteX3" fmla="*/ 278296 w 397565"/>
                        <a:gd name="connsiteY3" fmla="*/ 397566 h 397566"/>
                        <a:gd name="connsiteX4" fmla="*/ 397565 w 397565"/>
                        <a:gd name="connsiteY4" fmla="*/ 310101 h 397566"/>
                        <a:gd name="connsiteX5" fmla="*/ 389614 w 397565"/>
                        <a:gd name="connsiteY5" fmla="*/ 135173 h 397566"/>
                        <a:gd name="connsiteX6" fmla="*/ 262393 w 397565"/>
                        <a:gd name="connsiteY6" fmla="*/ 7952 h 397566"/>
                        <a:gd name="connsiteX7" fmla="*/ 166977 w 397565"/>
                        <a:gd name="connsiteY7" fmla="*/ 0 h 397566"/>
                        <a:gd name="connsiteX8" fmla="*/ 103367 w 397565"/>
                        <a:gd name="connsiteY8" fmla="*/ 87465 h 397566"/>
                        <a:gd name="connsiteX9" fmla="*/ 0 w 397565"/>
                        <a:gd name="connsiteY9" fmla="*/ 143124 h 397566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</a:cxnLst>
                      <a:rect l="l" t="t" r="r" b="b"/>
                      <a:pathLst>
                        <a:path w="397565" h="397566">
                          <a:moveTo>
                            <a:pt x="0" y="143124"/>
                          </a:moveTo>
                          <a:lnTo>
                            <a:pt x="0" y="246491"/>
                          </a:lnTo>
                          <a:lnTo>
                            <a:pt x="71562" y="357809"/>
                          </a:lnTo>
                          <a:lnTo>
                            <a:pt x="278296" y="397566"/>
                          </a:lnTo>
                          <a:lnTo>
                            <a:pt x="397565" y="310101"/>
                          </a:lnTo>
                          <a:lnTo>
                            <a:pt x="389614" y="135173"/>
                          </a:lnTo>
                          <a:lnTo>
                            <a:pt x="262393" y="7952"/>
                          </a:lnTo>
                          <a:lnTo>
                            <a:pt x="166977" y="0"/>
                          </a:lnTo>
                          <a:lnTo>
                            <a:pt x="103367" y="87465"/>
                          </a:lnTo>
                          <a:lnTo>
                            <a:pt x="0" y="143124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33" name="Textfeld 132">
              <a:extLst>
                <a:ext uri="{FF2B5EF4-FFF2-40B4-BE49-F238E27FC236}">
                  <a16:creationId xmlns="" xmlns:a16="http://schemas.microsoft.com/office/drawing/2014/main" id="{DE5FF885-B0B9-124B-A789-D009C94A25DD}"/>
                </a:ext>
              </a:extLst>
            </p:cNvPr>
            <p:cNvSpPr txBox="1"/>
            <p:nvPr/>
          </p:nvSpPr>
          <p:spPr>
            <a:xfrm>
              <a:off x="4911729" y="7269920"/>
              <a:ext cx="3209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9" name="Group 38"/>
          <p:cNvGrpSpPr>
            <a:grpSpLocks noChangeAspect="1"/>
          </p:cNvGrpSpPr>
          <p:nvPr/>
        </p:nvGrpSpPr>
        <p:grpSpPr>
          <a:xfrm>
            <a:off x="3375315" y="2532483"/>
            <a:ext cx="2880000" cy="1886816"/>
            <a:chOff x="3372096" y="2789361"/>
            <a:chExt cx="2939952" cy="1926095"/>
          </a:xfrm>
        </p:grpSpPr>
        <p:pic>
          <p:nvPicPr>
            <p:cNvPr id="26" name="Grafik 25" descr="Ein Bild, das draußen, Gras, weiß, Foto enthält.&#10;&#10;Automatisch generierte Beschreibung">
              <a:extLst>
                <a:ext uri="{FF2B5EF4-FFF2-40B4-BE49-F238E27FC236}">
                  <a16:creationId xmlns="" xmlns:a16="http://schemas.microsoft.com/office/drawing/2014/main" id="{204F2190-56D6-514F-8323-AB79E25990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32048" y="2795457"/>
              <a:ext cx="2880000" cy="19199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7" name="Gerade Verbindung 26">
              <a:extLst>
                <a:ext uri="{FF2B5EF4-FFF2-40B4-BE49-F238E27FC236}">
                  <a16:creationId xmlns="" xmlns:a16="http://schemas.microsoft.com/office/drawing/2014/main" id="{78E05931-13A5-464F-B7A9-6131CE55DCA9}"/>
                </a:ext>
              </a:extLst>
            </p:cNvPr>
            <p:cNvCxnSpPr/>
            <p:nvPr/>
          </p:nvCxnSpPr>
          <p:spPr>
            <a:xfrm>
              <a:off x="5804208" y="4618982"/>
              <a:ext cx="43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feld 27">
              <a:extLst>
                <a:ext uri="{FF2B5EF4-FFF2-40B4-BE49-F238E27FC236}">
                  <a16:creationId xmlns="" xmlns:a16="http://schemas.microsoft.com/office/drawing/2014/main" id="{DD10C07E-EAE8-C346-AAD1-6EFB6273954A}"/>
                </a:ext>
              </a:extLst>
            </p:cNvPr>
            <p:cNvSpPr txBox="1"/>
            <p:nvPr/>
          </p:nvSpPr>
          <p:spPr>
            <a:xfrm>
              <a:off x="5839136" y="4463534"/>
              <a:ext cx="3626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latin typeface="Arial" panose="020B0604020202020204" pitchFamily="34" charset="0"/>
                  <a:cs typeface="Arial" panose="020B0604020202020204" pitchFamily="34" charset="0"/>
                </a:rPr>
                <a:t>1 µm</a:t>
              </a:r>
            </a:p>
          </p:txBody>
        </p:sp>
        <p:sp>
          <p:nvSpPr>
            <p:cNvPr id="29" name="Textfeld 28">
              <a:extLst>
                <a:ext uri="{FF2B5EF4-FFF2-40B4-BE49-F238E27FC236}">
                  <a16:creationId xmlns="" xmlns:a16="http://schemas.microsoft.com/office/drawing/2014/main" id="{FC96E7F2-CBE9-E542-97EA-7075F9507515}"/>
                </a:ext>
              </a:extLst>
            </p:cNvPr>
            <p:cNvSpPr txBox="1"/>
            <p:nvPr/>
          </p:nvSpPr>
          <p:spPr>
            <a:xfrm>
              <a:off x="3429000" y="2789361"/>
              <a:ext cx="504000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AUY922</a:t>
              </a:r>
            </a:p>
          </p:txBody>
        </p:sp>
        <p:sp>
          <p:nvSpPr>
            <p:cNvPr id="80" name="Textfeld 79">
              <a:extLst>
                <a:ext uri="{FF2B5EF4-FFF2-40B4-BE49-F238E27FC236}">
                  <a16:creationId xmlns="" xmlns:a16="http://schemas.microsoft.com/office/drawing/2014/main" id="{688530BE-CD92-934D-A68E-0167A75F4F6F}"/>
                </a:ext>
              </a:extLst>
            </p:cNvPr>
            <p:cNvSpPr txBox="1"/>
            <p:nvPr/>
          </p:nvSpPr>
          <p:spPr>
            <a:xfrm>
              <a:off x="4003463" y="3059491"/>
              <a:ext cx="353784" cy="1885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</a:t>
              </a:r>
              <a:endPara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feld 80">
              <a:extLst>
                <a:ext uri="{FF2B5EF4-FFF2-40B4-BE49-F238E27FC236}">
                  <a16:creationId xmlns="" xmlns:a16="http://schemas.microsoft.com/office/drawing/2014/main" id="{59916F5E-B71C-7844-9855-4459EB98647B}"/>
                </a:ext>
              </a:extLst>
            </p:cNvPr>
            <p:cNvSpPr txBox="1"/>
            <p:nvPr/>
          </p:nvSpPr>
          <p:spPr>
            <a:xfrm>
              <a:off x="3425952" y="3716520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</a:p>
          </p:txBody>
        </p:sp>
        <p:sp>
          <p:nvSpPr>
            <p:cNvPr id="82" name="Textfeld 81">
              <a:extLst>
                <a:ext uri="{FF2B5EF4-FFF2-40B4-BE49-F238E27FC236}">
                  <a16:creationId xmlns="" xmlns:a16="http://schemas.microsoft.com/office/drawing/2014/main" id="{996933CF-B274-4644-81D8-F3942A9958D1}"/>
                </a:ext>
              </a:extLst>
            </p:cNvPr>
            <p:cNvSpPr txBox="1"/>
            <p:nvPr/>
          </p:nvSpPr>
          <p:spPr>
            <a:xfrm>
              <a:off x="3372096" y="4459013"/>
              <a:ext cx="3209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feld 116">
              <a:extLst>
                <a:ext uri="{FF2B5EF4-FFF2-40B4-BE49-F238E27FC236}">
                  <a16:creationId xmlns="" xmlns:a16="http://schemas.microsoft.com/office/drawing/2014/main" id="{59B72CF7-2485-FD40-A728-14AAAE8764D2}"/>
                </a:ext>
              </a:extLst>
            </p:cNvPr>
            <p:cNvSpPr txBox="1"/>
            <p:nvPr/>
          </p:nvSpPr>
          <p:spPr>
            <a:xfrm>
              <a:off x="5031397" y="4359819"/>
              <a:ext cx="3401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pid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feld 128">
              <a:extLst>
                <a:ext uri="{FF2B5EF4-FFF2-40B4-BE49-F238E27FC236}">
                  <a16:creationId xmlns="" xmlns:a16="http://schemas.microsoft.com/office/drawing/2014/main" id="{CDBA78C1-26DB-924B-94E9-967639C947A0}"/>
                </a:ext>
              </a:extLst>
            </p:cNvPr>
            <p:cNvSpPr txBox="1"/>
            <p:nvPr/>
          </p:nvSpPr>
          <p:spPr>
            <a:xfrm>
              <a:off x="4820270" y="3316962"/>
              <a:ext cx="6190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pid</a:t>
              </a:r>
              <a:r>
                <a:rPr lang="de-DE" sz="6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600" b="1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sicle</a:t>
              </a:r>
              <a:endParaRPr lang="de-DE" sz="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Freihandform 33">
              <a:extLst>
                <a:ext uri="{FF2B5EF4-FFF2-40B4-BE49-F238E27FC236}">
                  <a16:creationId xmlns="" xmlns:a16="http://schemas.microsoft.com/office/drawing/2014/main" id="{EE67226F-24C3-814F-9395-1A76E86BF311}"/>
                </a:ext>
              </a:extLst>
            </p:cNvPr>
            <p:cNvSpPr/>
            <p:nvPr/>
          </p:nvSpPr>
          <p:spPr>
            <a:xfrm>
              <a:off x="4444584" y="3117861"/>
              <a:ext cx="1349114" cy="824552"/>
            </a:xfrm>
            <a:custGeom>
              <a:avLst/>
              <a:gdLst>
                <a:gd name="connsiteX0" fmla="*/ 367259 w 1349114"/>
                <a:gd name="connsiteY0" fmla="*/ 22578 h 824552"/>
                <a:gd name="connsiteX1" fmla="*/ 142406 w 1349114"/>
                <a:gd name="connsiteY1" fmla="*/ 105024 h 824552"/>
                <a:gd name="connsiteX2" fmla="*/ 0 w 1349114"/>
                <a:gd name="connsiteY2" fmla="*/ 224946 h 824552"/>
                <a:gd name="connsiteX3" fmla="*/ 74950 w 1349114"/>
                <a:gd name="connsiteY3" fmla="*/ 367352 h 824552"/>
                <a:gd name="connsiteX4" fmla="*/ 217357 w 1349114"/>
                <a:gd name="connsiteY4" fmla="*/ 569719 h 824552"/>
                <a:gd name="connsiteX5" fmla="*/ 427219 w 1349114"/>
                <a:gd name="connsiteY5" fmla="*/ 712126 h 824552"/>
                <a:gd name="connsiteX6" fmla="*/ 509665 w 1349114"/>
                <a:gd name="connsiteY6" fmla="*/ 727116 h 824552"/>
                <a:gd name="connsiteX7" fmla="*/ 689547 w 1349114"/>
                <a:gd name="connsiteY7" fmla="*/ 802067 h 824552"/>
                <a:gd name="connsiteX8" fmla="*/ 757003 w 1349114"/>
                <a:gd name="connsiteY8" fmla="*/ 809562 h 824552"/>
                <a:gd name="connsiteX9" fmla="*/ 794478 w 1349114"/>
                <a:gd name="connsiteY9" fmla="*/ 817057 h 824552"/>
                <a:gd name="connsiteX10" fmla="*/ 1011836 w 1349114"/>
                <a:gd name="connsiteY10" fmla="*/ 824552 h 824552"/>
                <a:gd name="connsiteX11" fmla="*/ 1101777 w 1349114"/>
                <a:gd name="connsiteY11" fmla="*/ 817057 h 824552"/>
                <a:gd name="connsiteX12" fmla="*/ 1334124 w 1349114"/>
                <a:gd name="connsiteY12" fmla="*/ 704631 h 824552"/>
                <a:gd name="connsiteX13" fmla="*/ 1349114 w 1349114"/>
                <a:gd name="connsiteY13" fmla="*/ 479778 h 824552"/>
                <a:gd name="connsiteX14" fmla="*/ 1251678 w 1349114"/>
                <a:gd name="connsiteY14" fmla="*/ 269916 h 824552"/>
                <a:gd name="connsiteX15" fmla="*/ 1049311 w 1349114"/>
                <a:gd name="connsiteY15" fmla="*/ 120014 h 824552"/>
                <a:gd name="connsiteX16" fmla="*/ 816964 w 1349114"/>
                <a:gd name="connsiteY16" fmla="*/ 30073 h 824552"/>
                <a:gd name="connsiteX17" fmla="*/ 734518 w 1349114"/>
                <a:gd name="connsiteY17" fmla="*/ 93 h 824552"/>
                <a:gd name="connsiteX18" fmla="*/ 532150 w 1349114"/>
                <a:gd name="connsiteY18" fmla="*/ 15083 h 824552"/>
                <a:gd name="connsiteX19" fmla="*/ 367259 w 1349114"/>
                <a:gd name="connsiteY19" fmla="*/ 22578 h 8245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1349114" h="824552" extrusionOk="0">
                  <a:moveTo>
                    <a:pt x="367259" y="22578"/>
                  </a:moveTo>
                  <a:cubicBezTo>
                    <a:pt x="299530" y="58541"/>
                    <a:pt x="222171" y="64824"/>
                    <a:pt x="142406" y="105024"/>
                  </a:cubicBezTo>
                  <a:cubicBezTo>
                    <a:pt x="101223" y="158190"/>
                    <a:pt x="50931" y="171937"/>
                    <a:pt x="0" y="224946"/>
                  </a:cubicBezTo>
                  <a:cubicBezTo>
                    <a:pt x="40130" y="267242"/>
                    <a:pt x="41566" y="316869"/>
                    <a:pt x="74950" y="367352"/>
                  </a:cubicBezTo>
                  <a:cubicBezTo>
                    <a:pt x="145148" y="441907"/>
                    <a:pt x="165589" y="510231"/>
                    <a:pt x="217357" y="569719"/>
                  </a:cubicBezTo>
                  <a:cubicBezTo>
                    <a:pt x="297031" y="594553"/>
                    <a:pt x="314561" y="657338"/>
                    <a:pt x="427219" y="712126"/>
                  </a:cubicBezTo>
                  <a:cubicBezTo>
                    <a:pt x="507907" y="721607"/>
                    <a:pt x="474015" y="710206"/>
                    <a:pt x="509665" y="727116"/>
                  </a:cubicBezTo>
                  <a:cubicBezTo>
                    <a:pt x="572375" y="737469"/>
                    <a:pt x="599099" y="771276"/>
                    <a:pt x="689547" y="802067"/>
                  </a:cubicBezTo>
                  <a:cubicBezTo>
                    <a:pt x="712739" y="805143"/>
                    <a:pt x="736349" y="808318"/>
                    <a:pt x="757003" y="809562"/>
                  </a:cubicBezTo>
                  <a:cubicBezTo>
                    <a:pt x="812339" y="827807"/>
                    <a:pt x="759448" y="824882"/>
                    <a:pt x="794478" y="817057"/>
                  </a:cubicBezTo>
                  <a:cubicBezTo>
                    <a:pt x="846097" y="807695"/>
                    <a:pt x="908926" y="832949"/>
                    <a:pt x="1011836" y="824552"/>
                  </a:cubicBezTo>
                  <a:cubicBezTo>
                    <a:pt x="1081228" y="814098"/>
                    <a:pt x="1055853" y="815026"/>
                    <a:pt x="1101777" y="817057"/>
                  </a:cubicBezTo>
                  <a:cubicBezTo>
                    <a:pt x="1201260" y="765750"/>
                    <a:pt x="1233934" y="760893"/>
                    <a:pt x="1334124" y="704631"/>
                  </a:cubicBezTo>
                  <a:cubicBezTo>
                    <a:pt x="1328963" y="599944"/>
                    <a:pt x="1345982" y="588808"/>
                    <a:pt x="1349114" y="479778"/>
                  </a:cubicBezTo>
                  <a:cubicBezTo>
                    <a:pt x="1316585" y="413893"/>
                    <a:pt x="1295891" y="345033"/>
                    <a:pt x="1251678" y="269916"/>
                  </a:cubicBezTo>
                  <a:cubicBezTo>
                    <a:pt x="1142618" y="213022"/>
                    <a:pt x="1132315" y="171009"/>
                    <a:pt x="1049311" y="120014"/>
                  </a:cubicBezTo>
                  <a:cubicBezTo>
                    <a:pt x="944403" y="105675"/>
                    <a:pt x="917077" y="60230"/>
                    <a:pt x="816964" y="30073"/>
                  </a:cubicBezTo>
                  <a:cubicBezTo>
                    <a:pt x="751107" y="-7878"/>
                    <a:pt x="771684" y="-341"/>
                    <a:pt x="734518" y="93"/>
                  </a:cubicBezTo>
                  <a:cubicBezTo>
                    <a:pt x="645980" y="18659"/>
                    <a:pt x="597750" y="4027"/>
                    <a:pt x="532150" y="15083"/>
                  </a:cubicBezTo>
                  <a:cubicBezTo>
                    <a:pt x="454482" y="20463"/>
                    <a:pt x="403753" y="2364"/>
                    <a:pt x="367259" y="22578"/>
                  </a:cubicBezTo>
                  <a:close/>
                </a:path>
              </a:pathLst>
            </a:custGeom>
            <a:noFill/>
            <a:ln w="9525">
              <a:solidFill>
                <a:srgbClr val="FF0000"/>
              </a:solidFill>
              <a:prstDash val="dash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367259 w 1349114"/>
                        <a:gd name="connsiteY0" fmla="*/ 22578 h 824552"/>
                        <a:gd name="connsiteX1" fmla="*/ 142406 w 1349114"/>
                        <a:gd name="connsiteY1" fmla="*/ 105024 h 824552"/>
                        <a:gd name="connsiteX2" fmla="*/ 0 w 1349114"/>
                        <a:gd name="connsiteY2" fmla="*/ 224946 h 824552"/>
                        <a:gd name="connsiteX3" fmla="*/ 74950 w 1349114"/>
                        <a:gd name="connsiteY3" fmla="*/ 367352 h 824552"/>
                        <a:gd name="connsiteX4" fmla="*/ 217357 w 1349114"/>
                        <a:gd name="connsiteY4" fmla="*/ 569719 h 824552"/>
                        <a:gd name="connsiteX5" fmla="*/ 427219 w 1349114"/>
                        <a:gd name="connsiteY5" fmla="*/ 712126 h 824552"/>
                        <a:gd name="connsiteX6" fmla="*/ 509665 w 1349114"/>
                        <a:gd name="connsiteY6" fmla="*/ 727116 h 824552"/>
                        <a:gd name="connsiteX7" fmla="*/ 689547 w 1349114"/>
                        <a:gd name="connsiteY7" fmla="*/ 802067 h 824552"/>
                        <a:gd name="connsiteX8" fmla="*/ 757003 w 1349114"/>
                        <a:gd name="connsiteY8" fmla="*/ 809562 h 824552"/>
                        <a:gd name="connsiteX9" fmla="*/ 794478 w 1349114"/>
                        <a:gd name="connsiteY9" fmla="*/ 817057 h 824552"/>
                        <a:gd name="connsiteX10" fmla="*/ 1011836 w 1349114"/>
                        <a:gd name="connsiteY10" fmla="*/ 824552 h 824552"/>
                        <a:gd name="connsiteX11" fmla="*/ 1101777 w 1349114"/>
                        <a:gd name="connsiteY11" fmla="*/ 817057 h 824552"/>
                        <a:gd name="connsiteX12" fmla="*/ 1334124 w 1349114"/>
                        <a:gd name="connsiteY12" fmla="*/ 704631 h 824552"/>
                        <a:gd name="connsiteX13" fmla="*/ 1349114 w 1349114"/>
                        <a:gd name="connsiteY13" fmla="*/ 479778 h 824552"/>
                        <a:gd name="connsiteX14" fmla="*/ 1251678 w 1349114"/>
                        <a:gd name="connsiteY14" fmla="*/ 269916 h 824552"/>
                        <a:gd name="connsiteX15" fmla="*/ 1049311 w 1349114"/>
                        <a:gd name="connsiteY15" fmla="*/ 120014 h 824552"/>
                        <a:gd name="connsiteX16" fmla="*/ 816964 w 1349114"/>
                        <a:gd name="connsiteY16" fmla="*/ 30073 h 824552"/>
                        <a:gd name="connsiteX17" fmla="*/ 734518 w 1349114"/>
                        <a:gd name="connsiteY17" fmla="*/ 93 h 824552"/>
                        <a:gd name="connsiteX18" fmla="*/ 532150 w 1349114"/>
                        <a:gd name="connsiteY18" fmla="*/ 15083 h 824552"/>
                        <a:gd name="connsiteX19" fmla="*/ 367259 w 1349114"/>
                        <a:gd name="connsiteY19" fmla="*/ 22578 h 824552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</a:cxnLst>
                      <a:rect l="l" t="t" r="r" b="b"/>
                      <a:pathLst>
                        <a:path w="1349114" h="824552">
                          <a:moveTo>
                            <a:pt x="367259" y="22578"/>
                          </a:moveTo>
                          <a:lnTo>
                            <a:pt x="142406" y="105024"/>
                          </a:lnTo>
                          <a:lnTo>
                            <a:pt x="0" y="224946"/>
                          </a:lnTo>
                          <a:lnTo>
                            <a:pt x="74950" y="367352"/>
                          </a:lnTo>
                          <a:lnTo>
                            <a:pt x="217357" y="569719"/>
                          </a:lnTo>
                          <a:lnTo>
                            <a:pt x="427219" y="712126"/>
                          </a:lnTo>
                          <a:cubicBezTo>
                            <a:pt x="500227" y="720238"/>
                            <a:pt x="474440" y="709503"/>
                            <a:pt x="509665" y="727116"/>
                          </a:cubicBezTo>
                          <a:lnTo>
                            <a:pt x="689547" y="802067"/>
                          </a:lnTo>
                          <a:cubicBezTo>
                            <a:pt x="712032" y="804565"/>
                            <a:pt x="734687" y="805843"/>
                            <a:pt x="757003" y="809562"/>
                          </a:cubicBezTo>
                          <a:cubicBezTo>
                            <a:pt x="811454" y="818637"/>
                            <a:pt x="754368" y="817057"/>
                            <a:pt x="794478" y="817057"/>
                          </a:cubicBezTo>
                          <a:lnTo>
                            <a:pt x="1011836" y="824552"/>
                          </a:lnTo>
                          <a:cubicBezTo>
                            <a:pt x="1086740" y="816229"/>
                            <a:pt x="1056668" y="817057"/>
                            <a:pt x="1101777" y="817057"/>
                          </a:cubicBezTo>
                          <a:lnTo>
                            <a:pt x="1334124" y="704631"/>
                          </a:lnTo>
                          <a:lnTo>
                            <a:pt x="1349114" y="479778"/>
                          </a:lnTo>
                          <a:lnTo>
                            <a:pt x="1251678" y="269916"/>
                          </a:lnTo>
                          <a:lnTo>
                            <a:pt x="1049311" y="120014"/>
                          </a:lnTo>
                          <a:lnTo>
                            <a:pt x="816964" y="30073"/>
                          </a:lnTo>
                          <a:cubicBezTo>
                            <a:pt x="750299" y="-3259"/>
                            <a:pt x="779349" y="93"/>
                            <a:pt x="734518" y="93"/>
                          </a:cubicBezTo>
                          <a:lnTo>
                            <a:pt x="532150" y="15083"/>
                          </a:lnTo>
                          <a:lnTo>
                            <a:pt x="367259" y="22578"/>
                          </a:lnTo>
                          <a:close/>
                        </a:path>
                      </a:pathLst>
                    </a:custGeom>
                    <ask:type>
                      <ask:lineSketchScribbl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34" name="TextBox 92">
            <a:extLst>
              <a:ext uri="{FF2B5EF4-FFF2-40B4-BE49-F238E27FC236}">
                <a16:creationId xmlns="" xmlns:a16="http://schemas.microsoft.com/office/drawing/2014/main" id="{67335296-AC46-6E41-8766-8E5A1A2BC0EE}"/>
              </a:ext>
            </a:extLst>
          </p:cNvPr>
          <p:cNvSpPr txBox="1"/>
          <p:nvPr/>
        </p:nvSpPr>
        <p:spPr>
          <a:xfrm>
            <a:off x="148391" y="854277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135" name="Group 134"/>
          <p:cNvGrpSpPr/>
          <p:nvPr/>
        </p:nvGrpSpPr>
        <p:grpSpPr>
          <a:xfrm>
            <a:off x="410021" y="8634724"/>
            <a:ext cx="1927454" cy="874873"/>
            <a:chOff x="447946" y="5032690"/>
            <a:chExt cx="1927454" cy="874873"/>
          </a:xfrm>
        </p:grpSpPr>
        <p:pic>
          <p:nvPicPr>
            <p:cNvPr id="136" name="Picture 135"/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95400" y="5213107"/>
              <a:ext cx="1080000" cy="169991"/>
            </a:xfrm>
            <a:prstGeom prst="rect">
              <a:avLst/>
            </a:prstGeom>
          </p:spPr>
        </p:pic>
        <p:pic>
          <p:nvPicPr>
            <p:cNvPr id="137" name="Picture 136"/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95400" y="5396873"/>
              <a:ext cx="1080000" cy="165727"/>
            </a:xfrm>
            <a:prstGeom prst="rect">
              <a:avLst/>
            </a:prstGeom>
          </p:spPr>
        </p:pic>
        <p:pic>
          <p:nvPicPr>
            <p:cNvPr id="138" name="Picture 137"/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95400" y="5578504"/>
              <a:ext cx="1080000" cy="165727"/>
            </a:xfrm>
            <a:prstGeom prst="rect">
              <a:avLst/>
            </a:prstGeom>
          </p:spPr>
        </p:pic>
        <p:sp>
          <p:nvSpPr>
            <p:cNvPr id="139" name="TextBox 130">
              <a:extLst>
                <a:ext uri="{FF2B5EF4-FFF2-40B4-BE49-F238E27FC236}">
                  <a16:creationId xmlns="" xmlns:a16="http://schemas.microsoft.com/office/drawing/2014/main" id="{1BE44E99-1666-BB4E-9A03-8FCCA9354FE3}"/>
                </a:ext>
              </a:extLst>
            </p:cNvPr>
            <p:cNvSpPr txBox="1"/>
            <p:nvPr/>
          </p:nvSpPr>
          <p:spPr>
            <a:xfrm>
              <a:off x="888699" y="5214315"/>
              <a:ext cx="4379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GRP78</a:t>
              </a:r>
            </a:p>
          </p:txBody>
        </p:sp>
        <p:sp>
          <p:nvSpPr>
            <p:cNvPr id="140" name="TextBox 150">
              <a:extLst>
                <a:ext uri="{FF2B5EF4-FFF2-40B4-BE49-F238E27FC236}">
                  <a16:creationId xmlns="" xmlns:a16="http://schemas.microsoft.com/office/drawing/2014/main" id="{B5AAED81-0352-1444-B2D3-9D686A6AF4C6}"/>
                </a:ext>
              </a:extLst>
            </p:cNvPr>
            <p:cNvSpPr txBox="1"/>
            <p:nvPr/>
          </p:nvSpPr>
          <p:spPr>
            <a:xfrm>
              <a:off x="1560426" y="5722897"/>
              <a:ext cx="54534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4 h A673</a:t>
              </a:r>
            </a:p>
          </p:txBody>
        </p:sp>
        <p:sp>
          <p:nvSpPr>
            <p:cNvPr id="141" name="TextBox 20">
              <a:extLst>
                <a:ext uri="{FF2B5EF4-FFF2-40B4-BE49-F238E27FC236}">
                  <a16:creationId xmlns="" xmlns:a16="http://schemas.microsoft.com/office/drawing/2014/main" id="{DB666D91-713D-924B-8279-2214D6CCCF03}"/>
                </a:ext>
              </a:extLst>
            </p:cNvPr>
            <p:cNvSpPr txBox="1"/>
            <p:nvPr/>
          </p:nvSpPr>
          <p:spPr>
            <a:xfrm>
              <a:off x="1781864" y="504270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42" name="TextBox 21">
              <a:extLst>
                <a:ext uri="{FF2B5EF4-FFF2-40B4-BE49-F238E27FC236}">
                  <a16:creationId xmlns="" xmlns:a16="http://schemas.microsoft.com/office/drawing/2014/main" id="{2D008C48-20D5-C94C-AAEB-2AF84F545FB8}"/>
                </a:ext>
              </a:extLst>
            </p:cNvPr>
            <p:cNvSpPr txBox="1"/>
            <p:nvPr/>
          </p:nvSpPr>
          <p:spPr>
            <a:xfrm>
              <a:off x="1309328" y="5042704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3" name="TextBox 22">
              <a:extLst>
                <a:ext uri="{FF2B5EF4-FFF2-40B4-BE49-F238E27FC236}">
                  <a16:creationId xmlns="" xmlns:a16="http://schemas.microsoft.com/office/drawing/2014/main" id="{5DACBCFC-35B3-2D47-B369-3424B886A2D9}"/>
                </a:ext>
              </a:extLst>
            </p:cNvPr>
            <p:cNvSpPr txBox="1"/>
            <p:nvPr/>
          </p:nvSpPr>
          <p:spPr>
            <a:xfrm>
              <a:off x="1444881" y="5042704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144" name="TextBox 23">
              <a:extLst>
                <a:ext uri="{FF2B5EF4-FFF2-40B4-BE49-F238E27FC236}">
                  <a16:creationId xmlns="" xmlns:a16="http://schemas.microsoft.com/office/drawing/2014/main" id="{A9B2C0B8-69CB-2141-907F-5DD5A540F8CF}"/>
                </a:ext>
              </a:extLst>
            </p:cNvPr>
            <p:cNvSpPr txBox="1"/>
            <p:nvPr/>
          </p:nvSpPr>
          <p:spPr>
            <a:xfrm>
              <a:off x="1612932" y="5036702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145" name="TextBox 38">
              <a:extLst>
                <a:ext uri="{FF2B5EF4-FFF2-40B4-BE49-F238E27FC236}">
                  <a16:creationId xmlns="" xmlns:a16="http://schemas.microsoft.com/office/drawing/2014/main" id="{0D88C6D6-70F9-A74B-9277-13696DD53314}"/>
                </a:ext>
              </a:extLst>
            </p:cNvPr>
            <p:cNvSpPr txBox="1"/>
            <p:nvPr/>
          </p:nvSpPr>
          <p:spPr>
            <a:xfrm>
              <a:off x="447946" y="5034793"/>
              <a:ext cx="8819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unicamycin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(µg/ml)</a:t>
              </a:r>
            </a:p>
          </p:txBody>
        </p:sp>
        <p:sp>
          <p:nvSpPr>
            <p:cNvPr id="146" name="TextBox 20">
              <a:extLst>
                <a:ext uri="{FF2B5EF4-FFF2-40B4-BE49-F238E27FC236}">
                  <a16:creationId xmlns="" xmlns:a16="http://schemas.microsoft.com/office/drawing/2014/main" id="{DB666D91-713D-924B-8279-2214D6CCCF03}"/>
                </a:ext>
              </a:extLst>
            </p:cNvPr>
            <p:cNvSpPr txBox="1"/>
            <p:nvPr/>
          </p:nvSpPr>
          <p:spPr>
            <a:xfrm>
              <a:off x="1936501" y="504406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7" name="TextBox 20">
              <a:extLst>
                <a:ext uri="{FF2B5EF4-FFF2-40B4-BE49-F238E27FC236}">
                  <a16:creationId xmlns="" xmlns:a16="http://schemas.microsoft.com/office/drawing/2014/main" id="{DB666D91-713D-924B-8279-2214D6CCCF03}"/>
                </a:ext>
              </a:extLst>
            </p:cNvPr>
            <p:cNvSpPr txBox="1"/>
            <p:nvPr/>
          </p:nvSpPr>
          <p:spPr>
            <a:xfrm>
              <a:off x="2109860" y="503269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48" name="TextBox 130">
              <a:extLst>
                <a:ext uri="{FF2B5EF4-FFF2-40B4-BE49-F238E27FC236}">
                  <a16:creationId xmlns="" xmlns:a16="http://schemas.microsoft.com/office/drawing/2014/main" id="{1BE44E99-1666-BB4E-9A03-8FCCA9354FE3}"/>
                </a:ext>
              </a:extLst>
            </p:cNvPr>
            <p:cNvSpPr txBox="1"/>
            <p:nvPr/>
          </p:nvSpPr>
          <p:spPr>
            <a:xfrm>
              <a:off x="914959" y="5377934"/>
              <a:ext cx="4074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HOP</a:t>
              </a:r>
            </a:p>
          </p:txBody>
        </p:sp>
        <p:sp>
          <p:nvSpPr>
            <p:cNvPr id="149" name="TextBox 130">
              <a:extLst>
                <a:ext uri="{FF2B5EF4-FFF2-40B4-BE49-F238E27FC236}">
                  <a16:creationId xmlns="" xmlns:a16="http://schemas.microsoft.com/office/drawing/2014/main" id="{1BE44E99-1666-BB4E-9A03-8FCCA9354FE3}"/>
                </a:ext>
              </a:extLst>
            </p:cNvPr>
            <p:cNvSpPr txBox="1"/>
            <p:nvPr/>
          </p:nvSpPr>
          <p:spPr>
            <a:xfrm>
              <a:off x="831603" y="5568766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</p:grpSp>
      <p:sp>
        <p:nvSpPr>
          <p:cNvPr id="150" name="Rectangle 149"/>
          <p:cNvSpPr/>
          <p:nvPr/>
        </p:nvSpPr>
        <p:spPr>
          <a:xfrm>
            <a:off x="5257800" y="9565765"/>
            <a:ext cx="1612942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ex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ag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aption</a:t>
            </a:r>
            <a:endParaRPr lang="en-US" sz="1000" dirty="0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51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7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12703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8">
            <a:extLst>
              <a:ext uri="{FF2B5EF4-FFF2-40B4-BE49-F238E27FC236}">
                <a16:creationId xmlns="" xmlns:a16="http://schemas.microsoft.com/office/drawing/2014/main" id="{55ABAC3B-446B-6940-80D5-AA23D055BBCB}"/>
              </a:ext>
            </a:extLst>
          </p:cNvPr>
          <p:cNvSpPr/>
          <p:nvPr/>
        </p:nvSpPr>
        <p:spPr>
          <a:xfrm>
            <a:off x="323243" y="304800"/>
            <a:ext cx="6229957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7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ccumulation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ntracellular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defects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in A673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67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 (B), 2 µM VE821 (C)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bin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D). DMSO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A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tracellular structures were analyzed by transmission electron microscopy (TEM) and are labeled in red: lysosome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ys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mitochondria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endoplasmic reticulum (ER), nucleus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utophagosom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auto),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glycoge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ranule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lycoge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lipid droplets, vesicles and lipid-filled vesicles. A673 cells were treated with 0.4-5 µg/ml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unicamyci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or 24 h. (E)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TEM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ictur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mmunoblo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t least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414574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7</Words>
  <Application>Microsoft Office PowerPoint</Application>
  <PresentationFormat>A4-Papier (210x297 mm)</PresentationFormat>
  <Paragraphs>100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Office Theme</vt:lpstr>
      <vt:lpstr>PowerPoint-Präsentation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7:16Z</dcterms:modified>
</cp:coreProperties>
</file>